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sldIdLst>
    <p:sldId id="256" r:id="rId2"/>
    <p:sldId id="257" r:id="rId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F7E547B-4D65-D1D3-DF83-A2EFDF5A814A}" v="213" dt="2023-06-12T23:24:44.466"/>
    <p1510:client id="{36C96D04-5FB1-4FF9-97B8-AD8AE1B97913}" v="24" dt="2023-03-03T07:15:55.209"/>
    <p1510:client id="{36E15881-0BA3-4A58-AF06-5CA48921DAEB}" v="52" dt="2023-01-12T01:10:43.077"/>
    <p1510:client id="{43718674-F62E-4C30-BD48-0185FD155AD4}" v="3047" dt="2023-01-12T01:57:05.884"/>
    <p1510:client id="{61854EE4-F1DC-4A8E-847D-7C62DE40BFDC}" v="19" dt="2023-01-11T23:23:35.350"/>
    <p1510:client id="{6BDB5DC7-B327-4349-9663-89FC86BB7159}" v="32" dt="2023-06-12T10:48:07.659"/>
    <p1510:client id="{6C11DB37-55F7-5928-BA9C-EC3C20ACBF17}" v="121" dt="2023-06-12T05:33:24.096"/>
    <p1510:client id="{6FB80908-9FB3-4439-9715-8624B613EDF0}" v="344" dt="2023-06-12T05:51:17.384"/>
    <p1510:client id="{718FBA2C-ED38-385D-C525-33667249682D}" v="362" dt="2023-06-12T05:14:13.920"/>
    <p1510:client id="{8ACED1B7-A0FE-4C46-B20E-82911C931404}" v="511" dt="2023-06-12T06:19:54.035"/>
    <p1510:client id="{9150DE4D-96F0-483B-B20B-3A388AFBCF9F}" v="234" dt="2023-01-11T22:49:33.214"/>
    <p1510:client id="{97AF8D7B-344F-3B49-B154-E1B63D557E80}" v="2" dt="2023-01-11T23:03:05.511"/>
    <p1510:client id="{9C7ACE65-8100-4CA3-A738-9397FE371CFB}" v="17" dt="2023-01-12T01:11:59.585"/>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slideViewPr>
    <p:cSldViewPr snapToGrid="0">
      <p:cViewPr>
        <p:scale>
          <a:sx n="1" d="2"/>
          <a:sy n="1" d="2"/>
        </p:scale>
        <p:origin x="0" y="0"/>
      </p:cViewPr>
      <p:guideLst/>
    </p:cSldViewPr>
  </p:slideViewPr>
  <p:gridSpacing cx="76200" cy="76200"/>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 Id="rId9"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Jake Kendrick" userId="S::21308325@student.uwa.edu.au::ab142299-a4dd-4def-8b03-8ee3e1d9a7dd" providerId="AD" clId="Web-{6EB5C446-C2D2-4F79-881F-212B0D1CE35F}"/>
    <pc:docChg chg="modSld">
      <pc:chgData name="Jake Kendrick" userId="S::21308325@student.uwa.edu.au::ab142299-a4dd-4def-8b03-8ee3e1d9a7dd" providerId="AD" clId="Web-{6EB5C446-C2D2-4F79-881F-212B0D1CE35F}" dt="2022-07-04T08:41:55.910" v="7" actId="20577"/>
      <pc:docMkLst>
        <pc:docMk/>
      </pc:docMkLst>
      <pc:sldChg chg="modSp">
        <pc:chgData name="Jake Kendrick" userId="S::21308325@student.uwa.edu.au::ab142299-a4dd-4def-8b03-8ee3e1d9a7dd" providerId="AD" clId="Web-{6EB5C446-C2D2-4F79-881F-212B0D1CE35F}" dt="2022-07-04T08:41:55.910" v="7" actId="20577"/>
        <pc:sldMkLst>
          <pc:docMk/>
          <pc:sldMk cId="109857222" sldId="256"/>
        </pc:sldMkLst>
        <pc:spChg chg="mod">
          <ac:chgData name="Jake Kendrick" userId="S::21308325@student.uwa.edu.au::ab142299-a4dd-4def-8b03-8ee3e1d9a7dd" providerId="AD" clId="Web-{6EB5C446-C2D2-4F79-881F-212B0D1CE35F}" dt="2022-07-04T08:41:55.910" v="7" actId="20577"/>
          <ac:spMkLst>
            <pc:docMk/>
            <pc:sldMk cId="109857222" sldId="256"/>
            <ac:spMk id="13" creationId="{A9A32FB2-2064-654E-9855-BDC1D5C342CA}"/>
          </ac:spMkLst>
        </pc:spChg>
      </pc:sldChg>
    </pc:docChg>
  </pc:docChgLst>
  <pc:docChgLst>
    <pc:chgData name="Jake Kendrick" userId="S::21308325@student.uwa.edu.au::ab142299-a4dd-4def-8b03-8ee3e1d9a7dd" providerId="AD" clId="Web-{1F7E547B-4D65-D1D3-DF83-A2EFDF5A814A}"/>
    <pc:docChg chg="addSld modSld">
      <pc:chgData name="Jake Kendrick" userId="S::21308325@student.uwa.edu.au::ab142299-a4dd-4def-8b03-8ee3e1d9a7dd" providerId="AD" clId="Web-{1F7E547B-4D65-D1D3-DF83-A2EFDF5A814A}" dt="2023-06-12T23:24:44.466" v="111" actId="20577"/>
      <pc:docMkLst>
        <pc:docMk/>
      </pc:docMkLst>
      <pc:sldChg chg="delSp modSp">
        <pc:chgData name="Jake Kendrick" userId="S::21308325@student.uwa.edu.au::ab142299-a4dd-4def-8b03-8ee3e1d9a7dd" providerId="AD" clId="Web-{1F7E547B-4D65-D1D3-DF83-A2EFDF5A814A}" dt="2023-06-12T23:17:42.019" v="109"/>
        <pc:sldMkLst>
          <pc:docMk/>
          <pc:sldMk cId="109857222" sldId="256"/>
        </pc:sldMkLst>
        <pc:spChg chg="del">
          <ac:chgData name="Jake Kendrick" userId="S::21308325@student.uwa.edu.au::ab142299-a4dd-4def-8b03-8ee3e1d9a7dd" providerId="AD" clId="Web-{1F7E547B-4D65-D1D3-DF83-A2EFDF5A814A}" dt="2023-06-12T23:11:30.042" v="5"/>
          <ac:spMkLst>
            <pc:docMk/>
            <pc:sldMk cId="109857222" sldId="256"/>
            <ac:spMk id="13" creationId="{A9A32FB2-2064-654E-9855-BDC1D5C342CA}"/>
          </ac:spMkLst>
        </pc:spChg>
        <pc:graphicFrameChg chg="mod modGraphic">
          <ac:chgData name="Jake Kendrick" userId="S::21308325@student.uwa.edu.au::ab142299-a4dd-4def-8b03-8ee3e1d9a7dd" providerId="AD" clId="Web-{1F7E547B-4D65-D1D3-DF83-A2EFDF5A814A}" dt="2023-06-12T23:17:42.019" v="109"/>
          <ac:graphicFrameMkLst>
            <pc:docMk/>
            <pc:sldMk cId="109857222" sldId="256"/>
            <ac:graphicFrameMk id="9" creationId="{BFBF22AD-8840-DCC0-C66D-C6455C72D88A}"/>
          </ac:graphicFrameMkLst>
        </pc:graphicFrameChg>
      </pc:sldChg>
      <pc:sldChg chg="addSp delSp modSp new">
        <pc:chgData name="Jake Kendrick" userId="S::21308325@student.uwa.edu.au::ab142299-a4dd-4def-8b03-8ee3e1d9a7dd" providerId="AD" clId="Web-{1F7E547B-4D65-D1D3-DF83-A2EFDF5A814A}" dt="2023-06-12T23:24:44.466" v="111" actId="20577"/>
        <pc:sldMkLst>
          <pc:docMk/>
          <pc:sldMk cId="3511548461" sldId="257"/>
        </pc:sldMkLst>
        <pc:spChg chg="del">
          <ac:chgData name="Jake Kendrick" userId="S::21308325@student.uwa.edu.au::ab142299-a4dd-4def-8b03-8ee3e1d9a7dd" providerId="AD" clId="Web-{1F7E547B-4D65-D1D3-DF83-A2EFDF5A814A}" dt="2023-06-12T23:11:16.635" v="1"/>
          <ac:spMkLst>
            <pc:docMk/>
            <pc:sldMk cId="3511548461" sldId="257"/>
            <ac:spMk id="2" creationId="{FA11A598-976F-BD47-333E-180BB7EC0032}"/>
          </ac:spMkLst>
        </pc:spChg>
        <pc:spChg chg="del">
          <ac:chgData name="Jake Kendrick" userId="S::21308325@student.uwa.edu.au::ab142299-a4dd-4def-8b03-8ee3e1d9a7dd" providerId="AD" clId="Web-{1F7E547B-4D65-D1D3-DF83-A2EFDF5A814A}" dt="2023-06-12T23:11:17.588" v="2"/>
          <ac:spMkLst>
            <pc:docMk/>
            <pc:sldMk cId="3511548461" sldId="257"/>
            <ac:spMk id="3" creationId="{F851ECF0-604B-3F77-C520-B5965350A56C}"/>
          </ac:spMkLst>
        </pc:spChg>
        <pc:spChg chg="add mod">
          <ac:chgData name="Jake Kendrick" userId="S::21308325@student.uwa.edu.au::ab142299-a4dd-4def-8b03-8ee3e1d9a7dd" providerId="AD" clId="Web-{1F7E547B-4D65-D1D3-DF83-A2EFDF5A814A}" dt="2023-06-12T23:24:44.466" v="111" actId="20577"/>
          <ac:spMkLst>
            <pc:docMk/>
            <pc:sldMk cId="3511548461" sldId="257"/>
            <ac:spMk id="5" creationId="{46DDA527-3DF0-6192-7EEB-C48E303BE8D0}"/>
          </ac:spMkLst>
        </pc:spChg>
      </pc:sldChg>
    </pc:docChg>
  </pc:docChgLst>
  <pc:docChgLst>
    <pc:chgData name="Jake Kendrick" userId="S::21308325@student.uwa.edu.au::ab142299-a4dd-4def-8b03-8ee3e1d9a7dd" providerId="AD" clId="Web-{971CA831-DAEA-4931-A841-4AA89F631199}"/>
    <pc:docChg chg="modSld">
      <pc:chgData name="Jake Kendrick" userId="S::21308325@student.uwa.edu.au::ab142299-a4dd-4def-8b03-8ee3e1d9a7dd" providerId="AD" clId="Web-{971CA831-DAEA-4931-A841-4AA89F631199}" dt="2023-01-02T23:46:28.802" v="180" actId="20577"/>
      <pc:docMkLst>
        <pc:docMk/>
      </pc:docMkLst>
      <pc:sldChg chg="modSp">
        <pc:chgData name="Jake Kendrick" userId="S::21308325@student.uwa.edu.au::ab142299-a4dd-4def-8b03-8ee3e1d9a7dd" providerId="AD" clId="Web-{971CA831-DAEA-4931-A841-4AA89F631199}" dt="2023-01-02T23:46:28.802" v="180" actId="20577"/>
        <pc:sldMkLst>
          <pc:docMk/>
          <pc:sldMk cId="109857222" sldId="256"/>
        </pc:sldMkLst>
        <pc:spChg chg="mod">
          <ac:chgData name="Jake Kendrick" userId="S::21308325@student.uwa.edu.au::ab142299-a4dd-4def-8b03-8ee3e1d9a7dd" providerId="AD" clId="Web-{971CA831-DAEA-4931-A841-4AA89F631199}" dt="2023-01-02T23:46:28.802" v="180" actId="20577"/>
          <ac:spMkLst>
            <pc:docMk/>
            <pc:sldMk cId="109857222" sldId="256"/>
            <ac:spMk id="13" creationId="{A9A32FB2-2064-654E-9855-BDC1D5C342CA}"/>
          </ac:spMkLst>
        </pc:spChg>
      </pc:sldChg>
    </pc:docChg>
  </pc:docChgLst>
  <pc:docChgLst>
    <pc:chgData name="Jake Kendrick" userId="c9aa91da-2e15-46cf-a8c4-b4cee9b8e514" providerId="ADAL" clId="{8B45A429-B7B1-FD4F-BC49-09965DEFACEA}"/>
    <pc:docChg chg="modSld">
      <pc:chgData name="Jake Kendrick" userId="c9aa91da-2e15-46cf-a8c4-b4cee9b8e514" providerId="ADAL" clId="{8B45A429-B7B1-FD4F-BC49-09965DEFACEA}" dt="2023-01-09T23:40:28.912" v="0" actId="767"/>
      <pc:docMkLst>
        <pc:docMk/>
      </pc:docMkLst>
      <pc:sldChg chg="addSp modSp">
        <pc:chgData name="Jake Kendrick" userId="c9aa91da-2e15-46cf-a8c4-b4cee9b8e514" providerId="ADAL" clId="{8B45A429-B7B1-FD4F-BC49-09965DEFACEA}" dt="2023-01-09T23:40:28.912" v="0" actId="767"/>
        <pc:sldMkLst>
          <pc:docMk/>
          <pc:sldMk cId="109857222" sldId="256"/>
        </pc:sldMkLst>
        <pc:spChg chg="add mod">
          <ac:chgData name="Jake Kendrick" userId="c9aa91da-2e15-46cf-a8c4-b4cee9b8e514" providerId="ADAL" clId="{8B45A429-B7B1-FD4F-BC49-09965DEFACEA}" dt="2023-01-09T23:40:28.912" v="0" actId="767"/>
          <ac:spMkLst>
            <pc:docMk/>
            <pc:sldMk cId="109857222" sldId="256"/>
            <ac:spMk id="2" creationId="{2EF2A381-DB62-ADB9-8061-FEE116D46C4B}"/>
          </ac:spMkLst>
        </pc:spChg>
      </pc:sldChg>
    </pc:docChg>
  </pc:docChgLst>
  <pc:docChgLst>
    <pc:chgData name="Jake Kendrick" userId="S::21308325@student.uwa.edu.au::ab142299-a4dd-4def-8b03-8ee3e1d9a7dd" providerId="AD" clId="Web-{4E3A628E-BFF1-479D-AE1E-F018F1267E13}"/>
    <pc:docChg chg="modSld">
      <pc:chgData name="Jake Kendrick" userId="S::21308325@student.uwa.edu.au::ab142299-a4dd-4def-8b03-8ee3e1d9a7dd" providerId="AD" clId="Web-{4E3A628E-BFF1-479D-AE1E-F018F1267E13}" dt="2023-01-05T05:42:05.204" v="7" actId="20577"/>
      <pc:docMkLst>
        <pc:docMk/>
      </pc:docMkLst>
      <pc:sldChg chg="modSp">
        <pc:chgData name="Jake Kendrick" userId="S::21308325@student.uwa.edu.au::ab142299-a4dd-4def-8b03-8ee3e1d9a7dd" providerId="AD" clId="Web-{4E3A628E-BFF1-479D-AE1E-F018F1267E13}" dt="2023-01-05T05:42:05.204" v="7" actId="20577"/>
        <pc:sldMkLst>
          <pc:docMk/>
          <pc:sldMk cId="109857222" sldId="256"/>
        </pc:sldMkLst>
        <pc:spChg chg="mod">
          <ac:chgData name="Jake Kendrick" userId="S::21308325@student.uwa.edu.au::ab142299-a4dd-4def-8b03-8ee3e1d9a7dd" providerId="AD" clId="Web-{4E3A628E-BFF1-479D-AE1E-F018F1267E13}" dt="2023-01-05T05:42:05.204" v="7" actId="20577"/>
          <ac:spMkLst>
            <pc:docMk/>
            <pc:sldMk cId="109857222" sldId="256"/>
            <ac:spMk id="13" creationId="{A9A32FB2-2064-654E-9855-BDC1D5C342CA}"/>
          </ac:spMkLst>
        </pc:spChg>
      </pc:sldChg>
    </pc:docChg>
  </pc:docChgLst>
  <pc:docChgLst>
    <pc:chgData name="Jake Kendrick" userId="S::21308325@student.uwa.edu.au::ab142299-a4dd-4def-8b03-8ee3e1d9a7dd" providerId="AD" clId="Web-{9C7ACE65-8100-4CA3-A738-9397FE371CFB}"/>
    <pc:docChg chg="modSld">
      <pc:chgData name="Jake Kendrick" userId="S::21308325@student.uwa.edu.au::ab142299-a4dd-4def-8b03-8ee3e1d9a7dd" providerId="AD" clId="Web-{9C7ACE65-8100-4CA3-A738-9397FE371CFB}" dt="2023-01-12T01:11:46.756" v="7" actId="20577"/>
      <pc:docMkLst>
        <pc:docMk/>
      </pc:docMkLst>
      <pc:sldChg chg="modSp">
        <pc:chgData name="Jake Kendrick" userId="S::21308325@student.uwa.edu.au::ab142299-a4dd-4def-8b03-8ee3e1d9a7dd" providerId="AD" clId="Web-{9C7ACE65-8100-4CA3-A738-9397FE371CFB}" dt="2023-01-12T01:11:46.756" v="7" actId="20577"/>
        <pc:sldMkLst>
          <pc:docMk/>
          <pc:sldMk cId="109857222" sldId="256"/>
        </pc:sldMkLst>
        <pc:spChg chg="mod">
          <ac:chgData name="Jake Kendrick" userId="S::21308325@student.uwa.edu.au::ab142299-a4dd-4def-8b03-8ee3e1d9a7dd" providerId="AD" clId="Web-{9C7ACE65-8100-4CA3-A738-9397FE371CFB}" dt="2023-01-12T01:11:46.756" v="7" actId="20577"/>
          <ac:spMkLst>
            <pc:docMk/>
            <pc:sldMk cId="109857222" sldId="256"/>
            <ac:spMk id="13" creationId="{A9A32FB2-2064-654E-9855-BDC1D5C342CA}"/>
          </ac:spMkLst>
        </pc:spChg>
      </pc:sldChg>
    </pc:docChg>
  </pc:docChgLst>
  <pc:docChgLst>
    <pc:chgData name="Jake Kendrick" userId="S::21308325@student.uwa.edu.au::ab142299-a4dd-4def-8b03-8ee3e1d9a7dd" providerId="AD" clId="Web-{8ACED1B7-A0FE-4C46-B20E-82911C931404}"/>
    <pc:docChg chg="modSld">
      <pc:chgData name="Jake Kendrick" userId="S::21308325@student.uwa.edu.au::ab142299-a4dd-4def-8b03-8ee3e1d9a7dd" providerId="AD" clId="Web-{8ACED1B7-A0FE-4C46-B20E-82911C931404}" dt="2023-06-12T06:19:54.035" v="267"/>
      <pc:docMkLst>
        <pc:docMk/>
      </pc:docMkLst>
      <pc:sldChg chg="addSp modSp">
        <pc:chgData name="Jake Kendrick" userId="S::21308325@student.uwa.edu.au::ab142299-a4dd-4def-8b03-8ee3e1d9a7dd" providerId="AD" clId="Web-{8ACED1B7-A0FE-4C46-B20E-82911C931404}" dt="2023-06-12T06:19:54.035" v="267"/>
        <pc:sldMkLst>
          <pc:docMk/>
          <pc:sldMk cId="109857222" sldId="256"/>
        </pc:sldMkLst>
        <pc:spChg chg="add mod">
          <ac:chgData name="Jake Kendrick" userId="S::21308325@student.uwa.edu.au::ab142299-a4dd-4def-8b03-8ee3e1d9a7dd" providerId="AD" clId="Web-{8ACED1B7-A0FE-4C46-B20E-82911C931404}" dt="2023-06-12T06:09:21.953" v="56" actId="1076"/>
          <ac:spMkLst>
            <pc:docMk/>
            <pc:sldMk cId="109857222" sldId="256"/>
            <ac:spMk id="2" creationId="{DB307362-7B48-0310-0A58-C2C0E905F869}"/>
          </ac:spMkLst>
        </pc:spChg>
        <pc:spChg chg="add mod">
          <ac:chgData name="Jake Kendrick" userId="S::21308325@student.uwa.edu.au::ab142299-a4dd-4def-8b03-8ee3e1d9a7dd" providerId="AD" clId="Web-{8ACED1B7-A0FE-4C46-B20E-82911C931404}" dt="2023-06-12T06:09:25.422" v="57" actId="1076"/>
          <ac:spMkLst>
            <pc:docMk/>
            <pc:sldMk cId="109857222" sldId="256"/>
            <ac:spMk id="4" creationId="{064E793E-D3F0-3B4D-8C7D-0A9BE94CBC10}"/>
          </ac:spMkLst>
        </pc:spChg>
        <pc:spChg chg="add mod">
          <ac:chgData name="Jake Kendrick" userId="S::21308325@student.uwa.edu.au::ab142299-a4dd-4def-8b03-8ee3e1d9a7dd" providerId="AD" clId="Web-{8ACED1B7-A0FE-4C46-B20E-82911C931404}" dt="2023-06-12T06:19:54.035" v="267"/>
          <ac:spMkLst>
            <pc:docMk/>
            <pc:sldMk cId="109857222" sldId="256"/>
            <ac:spMk id="6" creationId="{038E16DD-DDEB-B29B-5575-2AB0C79BD8B4}"/>
          </ac:spMkLst>
        </pc:spChg>
        <pc:spChg chg="mod">
          <ac:chgData name="Jake Kendrick" userId="S::21308325@student.uwa.edu.au::ab142299-a4dd-4def-8b03-8ee3e1d9a7dd" providerId="AD" clId="Web-{8ACED1B7-A0FE-4C46-B20E-82911C931404}" dt="2023-06-12T06:15:03.480" v="265" actId="20577"/>
          <ac:spMkLst>
            <pc:docMk/>
            <pc:sldMk cId="109857222" sldId="256"/>
            <ac:spMk id="13" creationId="{A9A32FB2-2064-654E-9855-BDC1D5C342CA}"/>
          </ac:spMkLst>
        </pc:spChg>
        <pc:graphicFrameChg chg="mod modGraphic">
          <ac:chgData name="Jake Kendrick" userId="S::21308325@student.uwa.edu.au::ab142299-a4dd-4def-8b03-8ee3e1d9a7dd" providerId="AD" clId="Web-{8ACED1B7-A0FE-4C46-B20E-82911C931404}" dt="2023-06-12T06:09:15.109" v="55"/>
          <ac:graphicFrameMkLst>
            <pc:docMk/>
            <pc:sldMk cId="109857222" sldId="256"/>
            <ac:graphicFrameMk id="9" creationId="{BFBF22AD-8840-DCC0-C66D-C6455C72D88A}"/>
          </ac:graphicFrameMkLst>
        </pc:graphicFrameChg>
      </pc:sldChg>
    </pc:docChg>
  </pc:docChgLst>
  <pc:docChgLst>
    <pc:chgData name="Jake Kendrick" userId="S::21308325@student.uwa.edu.au::ab142299-a4dd-4def-8b03-8ee3e1d9a7dd" providerId="AD" clId="Web-{11E9321A-6FD3-4CBD-9F17-7B40575D75C8}"/>
    <pc:docChg chg="modSld">
      <pc:chgData name="Jake Kendrick" userId="S::21308325@student.uwa.edu.au::ab142299-a4dd-4def-8b03-8ee3e1d9a7dd" providerId="AD" clId="Web-{11E9321A-6FD3-4CBD-9F17-7B40575D75C8}" dt="2023-01-09T03:31:22.234" v="321" actId="20577"/>
      <pc:docMkLst>
        <pc:docMk/>
      </pc:docMkLst>
      <pc:sldChg chg="modSp">
        <pc:chgData name="Jake Kendrick" userId="S::21308325@student.uwa.edu.au::ab142299-a4dd-4def-8b03-8ee3e1d9a7dd" providerId="AD" clId="Web-{11E9321A-6FD3-4CBD-9F17-7B40575D75C8}" dt="2023-01-09T03:31:22.234" v="321" actId="20577"/>
        <pc:sldMkLst>
          <pc:docMk/>
          <pc:sldMk cId="109857222" sldId="256"/>
        </pc:sldMkLst>
        <pc:spChg chg="mod">
          <ac:chgData name="Jake Kendrick" userId="S::21308325@student.uwa.edu.au::ab142299-a4dd-4def-8b03-8ee3e1d9a7dd" providerId="AD" clId="Web-{11E9321A-6FD3-4CBD-9F17-7B40575D75C8}" dt="2023-01-09T03:31:22.234" v="321" actId="20577"/>
          <ac:spMkLst>
            <pc:docMk/>
            <pc:sldMk cId="109857222" sldId="256"/>
            <ac:spMk id="13" creationId="{A9A32FB2-2064-654E-9855-BDC1D5C342CA}"/>
          </ac:spMkLst>
        </pc:spChg>
      </pc:sldChg>
    </pc:docChg>
  </pc:docChgLst>
  <pc:docChgLst>
    <pc:chgData name="Jake Kendrick" userId="S::21308325@student.uwa.edu.au::ab142299-a4dd-4def-8b03-8ee3e1d9a7dd" providerId="AD" clId="Web-{61854EE4-F1DC-4A8E-847D-7C62DE40BFDC}"/>
    <pc:docChg chg="modSld">
      <pc:chgData name="Jake Kendrick" userId="S::21308325@student.uwa.edu.au::ab142299-a4dd-4def-8b03-8ee3e1d9a7dd" providerId="AD" clId="Web-{61854EE4-F1DC-4A8E-847D-7C62DE40BFDC}" dt="2023-01-11T23:23:35.350" v="17" actId="688"/>
      <pc:docMkLst>
        <pc:docMk/>
      </pc:docMkLst>
      <pc:sldChg chg="addSp modSp">
        <pc:chgData name="Jake Kendrick" userId="S::21308325@student.uwa.edu.au::ab142299-a4dd-4def-8b03-8ee3e1d9a7dd" providerId="AD" clId="Web-{61854EE4-F1DC-4A8E-847D-7C62DE40BFDC}" dt="2023-01-11T23:23:35.350" v="17" actId="688"/>
        <pc:sldMkLst>
          <pc:docMk/>
          <pc:sldMk cId="109857222" sldId="256"/>
        </pc:sldMkLst>
        <pc:spChg chg="mod">
          <ac:chgData name="Jake Kendrick" userId="S::21308325@student.uwa.edu.au::ab142299-a4dd-4def-8b03-8ee3e1d9a7dd" providerId="AD" clId="Web-{61854EE4-F1DC-4A8E-847D-7C62DE40BFDC}" dt="2023-01-11T23:21:59.469" v="4" actId="1076"/>
          <ac:spMkLst>
            <pc:docMk/>
            <pc:sldMk cId="109857222" sldId="256"/>
            <ac:spMk id="5" creationId="{0578B295-60DA-1ACA-FA20-EABE43ECBD76}"/>
          </ac:spMkLst>
        </pc:spChg>
        <pc:spChg chg="mod">
          <ac:chgData name="Jake Kendrick" userId="S::21308325@student.uwa.edu.au::ab142299-a4dd-4def-8b03-8ee3e1d9a7dd" providerId="AD" clId="Web-{61854EE4-F1DC-4A8E-847D-7C62DE40BFDC}" dt="2023-01-11T23:21:59.485" v="5" actId="1076"/>
          <ac:spMkLst>
            <pc:docMk/>
            <pc:sldMk cId="109857222" sldId="256"/>
            <ac:spMk id="7" creationId="{D5C3C840-2AF0-DF80-DC4C-81D5DA112E6E}"/>
          </ac:spMkLst>
        </pc:spChg>
        <pc:spChg chg="mod">
          <ac:chgData name="Jake Kendrick" userId="S::21308325@student.uwa.edu.au::ab142299-a4dd-4def-8b03-8ee3e1d9a7dd" providerId="AD" clId="Web-{61854EE4-F1DC-4A8E-847D-7C62DE40BFDC}" dt="2023-01-11T23:21:59.438" v="2" actId="1076"/>
          <ac:spMkLst>
            <pc:docMk/>
            <pc:sldMk cId="109857222" sldId="256"/>
            <ac:spMk id="10" creationId="{77A02ED0-8423-0C42-930A-6F5D1DA6A053}"/>
          </ac:spMkLst>
        </pc:spChg>
        <pc:spChg chg="add mod">
          <ac:chgData name="Jake Kendrick" userId="S::21308325@student.uwa.edu.au::ab142299-a4dd-4def-8b03-8ee3e1d9a7dd" providerId="AD" clId="Web-{61854EE4-F1DC-4A8E-847D-7C62DE40BFDC}" dt="2023-01-11T23:23:35.350" v="17" actId="688"/>
          <ac:spMkLst>
            <pc:docMk/>
            <pc:sldMk cId="109857222" sldId="256"/>
            <ac:spMk id="14" creationId="{4C7BB03D-0E3B-0F75-1FEB-27E8E5B49C86}"/>
          </ac:spMkLst>
        </pc:spChg>
        <pc:spChg chg="mod">
          <ac:chgData name="Jake Kendrick" userId="S::21308325@student.uwa.edu.au::ab142299-a4dd-4def-8b03-8ee3e1d9a7dd" providerId="AD" clId="Web-{61854EE4-F1DC-4A8E-847D-7C62DE40BFDC}" dt="2023-01-11T23:21:38.156" v="1" actId="1076"/>
          <ac:spMkLst>
            <pc:docMk/>
            <pc:sldMk cId="109857222" sldId="256"/>
            <ac:spMk id="19" creationId="{3812D9A9-07A0-88FE-16FA-489DD0F05B96}"/>
          </ac:spMkLst>
        </pc:spChg>
        <pc:picChg chg="mod modCrop">
          <ac:chgData name="Jake Kendrick" userId="S::21308325@student.uwa.edu.au::ab142299-a4dd-4def-8b03-8ee3e1d9a7dd" providerId="AD" clId="Web-{61854EE4-F1DC-4A8E-847D-7C62DE40BFDC}" dt="2023-01-11T23:23:01.223" v="14"/>
          <ac:picMkLst>
            <pc:docMk/>
            <pc:sldMk cId="109857222" sldId="256"/>
            <ac:picMk id="11" creationId="{0283F916-FE9D-384F-57ED-B414501219F8}"/>
          </ac:picMkLst>
        </pc:picChg>
        <pc:picChg chg="mod">
          <ac:chgData name="Jake Kendrick" userId="S::21308325@student.uwa.edu.au::ab142299-a4dd-4def-8b03-8ee3e1d9a7dd" providerId="AD" clId="Web-{61854EE4-F1DC-4A8E-847D-7C62DE40BFDC}" dt="2023-01-11T23:21:59.454" v="3" actId="1076"/>
          <ac:picMkLst>
            <pc:docMk/>
            <pc:sldMk cId="109857222" sldId="256"/>
            <ac:picMk id="26" creationId="{625661E8-F1CD-2AC2-EA69-8FECF524C8E3}"/>
          </ac:picMkLst>
        </pc:picChg>
      </pc:sldChg>
    </pc:docChg>
  </pc:docChgLst>
  <pc:docChgLst>
    <pc:chgData name="Jake Kendrick" userId="S::21308325@student.uwa.edu.au::ab142299-a4dd-4def-8b03-8ee3e1d9a7dd" providerId="AD" clId="Web-{71067842-DC60-4BA4-A80B-E2F3844D8B62}"/>
    <pc:docChg chg="modSld">
      <pc:chgData name="Jake Kendrick" userId="S::21308325@student.uwa.edu.au::ab142299-a4dd-4def-8b03-8ee3e1d9a7dd" providerId="AD" clId="Web-{71067842-DC60-4BA4-A80B-E2F3844D8B62}" dt="2023-01-09T03:41:48.887" v="282" actId="20577"/>
      <pc:docMkLst>
        <pc:docMk/>
      </pc:docMkLst>
      <pc:sldChg chg="modSp">
        <pc:chgData name="Jake Kendrick" userId="S::21308325@student.uwa.edu.au::ab142299-a4dd-4def-8b03-8ee3e1d9a7dd" providerId="AD" clId="Web-{71067842-DC60-4BA4-A80B-E2F3844D8B62}" dt="2023-01-09T03:41:48.887" v="282" actId="20577"/>
        <pc:sldMkLst>
          <pc:docMk/>
          <pc:sldMk cId="109857222" sldId="256"/>
        </pc:sldMkLst>
        <pc:spChg chg="mod">
          <ac:chgData name="Jake Kendrick" userId="S::21308325@student.uwa.edu.au::ab142299-a4dd-4def-8b03-8ee3e1d9a7dd" providerId="AD" clId="Web-{71067842-DC60-4BA4-A80B-E2F3844D8B62}" dt="2023-01-09T03:41:48.887" v="282" actId="20577"/>
          <ac:spMkLst>
            <pc:docMk/>
            <pc:sldMk cId="109857222" sldId="256"/>
            <ac:spMk id="13" creationId="{A9A32FB2-2064-654E-9855-BDC1D5C342CA}"/>
          </ac:spMkLst>
        </pc:spChg>
      </pc:sldChg>
    </pc:docChg>
  </pc:docChgLst>
  <pc:docChgLst>
    <pc:chgData name="Jake Kendrick" userId="S::21308325@student.uwa.edu.au::ab142299-a4dd-4def-8b03-8ee3e1d9a7dd" providerId="AD" clId="Web-{6C11DB37-55F7-5928-BA9C-EC3C20ACBF17}"/>
    <pc:docChg chg="modSld">
      <pc:chgData name="Jake Kendrick" userId="S::21308325@student.uwa.edu.au::ab142299-a4dd-4def-8b03-8ee3e1d9a7dd" providerId="AD" clId="Web-{6C11DB37-55F7-5928-BA9C-EC3C20ACBF17}" dt="2023-06-12T05:33:24.096" v="78" actId="20577"/>
      <pc:docMkLst>
        <pc:docMk/>
      </pc:docMkLst>
      <pc:sldChg chg="addSp modSp">
        <pc:chgData name="Jake Kendrick" userId="S::21308325@student.uwa.edu.au::ab142299-a4dd-4def-8b03-8ee3e1d9a7dd" providerId="AD" clId="Web-{6C11DB37-55F7-5928-BA9C-EC3C20ACBF17}" dt="2023-06-12T05:33:24.096" v="78" actId="20577"/>
        <pc:sldMkLst>
          <pc:docMk/>
          <pc:sldMk cId="109857222" sldId="256"/>
        </pc:sldMkLst>
        <pc:spChg chg="add mod">
          <ac:chgData name="Jake Kendrick" userId="S::21308325@student.uwa.edu.au::ab142299-a4dd-4def-8b03-8ee3e1d9a7dd" providerId="AD" clId="Web-{6C11DB37-55F7-5928-BA9C-EC3C20ACBF17}" dt="2023-06-12T05:32:37.766" v="69" actId="1076"/>
          <ac:spMkLst>
            <pc:docMk/>
            <pc:sldMk cId="109857222" sldId="256"/>
            <ac:spMk id="2" creationId="{8C6A3FBF-8002-0C94-BA16-0667E70894DB}"/>
          </ac:spMkLst>
        </pc:spChg>
        <pc:spChg chg="add mod">
          <ac:chgData name="Jake Kendrick" userId="S::21308325@student.uwa.edu.au::ab142299-a4dd-4def-8b03-8ee3e1d9a7dd" providerId="AD" clId="Web-{6C11DB37-55F7-5928-BA9C-EC3C20ACBF17}" dt="2023-06-12T05:32:19.828" v="62" actId="14100"/>
          <ac:spMkLst>
            <pc:docMk/>
            <pc:sldMk cId="109857222" sldId="256"/>
            <ac:spMk id="4" creationId="{27A96775-B130-55FA-4134-988D64090C2E}"/>
          </ac:spMkLst>
        </pc:spChg>
        <pc:spChg chg="add mod">
          <ac:chgData name="Jake Kendrick" userId="S::21308325@student.uwa.edu.au::ab142299-a4dd-4def-8b03-8ee3e1d9a7dd" providerId="AD" clId="Web-{6C11DB37-55F7-5928-BA9C-EC3C20ACBF17}" dt="2023-06-12T05:33:24.096" v="78" actId="20577"/>
          <ac:spMkLst>
            <pc:docMk/>
            <pc:sldMk cId="109857222" sldId="256"/>
            <ac:spMk id="6" creationId="{7859DAD8-D439-0B7B-7D68-499D6709EE7B}"/>
          </ac:spMkLst>
        </pc:spChg>
        <pc:spChg chg="add mod">
          <ac:chgData name="Jake Kendrick" userId="S::21308325@student.uwa.edu.au::ab142299-a4dd-4def-8b03-8ee3e1d9a7dd" providerId="AD" clId="Web-{6C11DB37-55F7-5928-BA9C-EC3C20ACBF17}" dt="2023-06-12T05:32:43.923" v="71" actId="1076"/>
          <ac:spMkLst>
            <pc:docMk/>
            <pc:sldMk cId="109857222" sldId="256"/>
            <ac:spMk id="8" creationId="{E73775FE-E078-56E9-9AC2-BD17EDC99EA9}"/>
          </ac:spMkLst>
        </pc:spChg>
        <pc:spChg chg="mod">
          <ac:chgData name="Jake Kendrick" userId="S::21308325@student.uwa.edu.au::ab142299-a4dd-4def-8b03-8ee3e1d9a7dd" providerId="AD" clId="Web-{6C11DB37-55F7-5928-BA9C-EC3C20ACBF17}" dt="2023-06-12T05:31:21.951" v="42" actId="14100"/>
          <ac:spMkLst>
            <pc:docMk/>
            <pc:sldMk cId="109857222" sldId="256"/>
            <ac:spMk id="36" creationId="{9038A5FC-BAEB-6F6F-E152-D90D91AFE4C4}"/>
          </ac:spMkLst>
        </pc:spChg>
        <pc:spChg chg="mod">
          <ac:chgData name="Jake Kendrick" userId="S::21308325@student.uwa.edu.au::ab142299-a4dd-4def-8b03-8ee3e1d9a7dd" providerId="AD" clId="Web-{6C11DB37-55F7-5928-BA9C-EC3C20ACBF17}" dt="2023-06-12T05:31:12.919" v="41" actId="20577"/>
          <ac:spMkLst>
            <pc:docMk/>
            <pc:sldMk cId="109857222" sldId="256"/>
            <ac:spMk id="37" creationId="{31574BA6-DC1B-27E8-6D53-C5259F6FCE78}"/>
          </ac:spMkLst>
        </pc:spChg>
        <pc:spChg chg="mod">
          <ac:chgData name="Jake Kendrick" userId="S::21308325@student.uwa.edu.au::ab142299-a4dd-4def-8b03-8ee3e1d9a7dd" providerId="AD" clId="Web-{6C11DB37-55F7-5928-BA9C-EC3C20ACBF17}" dt="2023-06-12T05:23:56.573" v="11" actId="14100"/>
          <ac:spMkLst>
            <pc:docMk/>
            <pc:sldMk cId="109857222" sldId="256"/>
            <ac:spMk id="58" creationId="{12807188-A8EC-55CC-19F3-5C8F9FEE666B}"/>
          </ac:spMkLst>
        </pc:spChg>
        <pc:spChg chg="mod">
          <ac:chgData name="Jake Kendrick" userId="S::21308325@student.uwa.edu.au::ab142299-a4dd-4def-8b03-8ee3e1d9a7dd" providerId="AD" clId="Web-{6C11DB37-55F7-5928-BA9C-EC3C20ACBF17}" dt="2023-06-12T05:24:59.935" v="18" actId="14100"/>
          <ac:spMkLst>
            <pc:docMk/>
            <pc:sldMk cId="109857222" sldId="256"/>
            <ac:spMk id="60" creationId="{571D5DE6-7BAC-F156-A40F-35164140D145}"/>
          </ac:spMkLst>
        </pc:spChg>
        <pc:picChg chg="mod modCrop">
          <ac:chgData name="Jake Kendrick" userId="S::21308325@student.uwa.edu.au::ab142299-a4dd-4def-8b03-8ee3e1d9a7dd" providerId="AD" clId="Web-{6C11DB37-55F7-5928-BA9C-EC3C20ACBF17}" dt="2023-06-12T05:23:21.306" v="3" actId="14100"/>
          <ac:picMkLst>
            <pc:docMk/>
            <pc:sldMk cId="109857222" sldId="256"/>
            <ac:picMk id="55" creationId="{FD19E755-28F7-14C7-2B2F-9691220023CD}"/>
          </ac:picMkLst>
        </pc:picChg>
        <pc:picChg chg="mod modCrop">
          <ac:chgData name="Jake Kendrick" userId="S::21308325@student.uwa.edu.au::ab142299-a4dd-4def-8b03-8ee3e1d9a7dd" providerId="AD" clId="Web-{6C11DB37-55F7-5928-BA9C-EC3C20ACBF17}" dt="2023-06-12T05:23:46.979" v="8" actId="14100"/>
          <ac:picMkLst>
            <pc:docMk/>
            <pc:sldMk cId="109857222" sldId="256"/>
            <ac:picMk id="61" creationId="{64F72DF3-F2F2-95C7-31EE-BC1637A78667}"/>
          </ac:picMkLst>
        </pc:picChg>
      </pc:sldChg>
    </pc:docChg>
  </pc:docChgLst>
  <pc:docChgLst>
    <pc:chgData name="Jake Kendrick" userId="c9aa91da-2e15-46cf-a8c4-b4cee9b8e514" providerId="ADAL" clId="{4D39B9F2-2A26-5844-9159-FAC44B83CB06}"/>
    <pc:docChg chg="undo custSel modSld modMainMaster">
      <pc:chgData name="Jake Kendrick" userId="c9aa91da-2e15-46cf-a8c4-b4cee9b8e514" providerId="ADAL" clId="{4D39B9F2-2A26-5844-9159-FAC44B83CB06}" dt="2022-05-16T06:21:44.646" v="1059" actId="255"/>
      <pc:docMkLst>
        <pc:docMk/>
      </pc:docMkLst>
      <pc:sldChg chg="addSp delSp modSp mod">
        <pc:chgData name="Jake Kendrick" userId="c9aa91da-2e15-46cf-a8c4-b4cee9b8e514" providerId="ADAL" clId="{4D39B9F2-2A26-5844-9159-FAC44B83CB06}" dt="2022-05-16T06:21:44.646" v="1059" actId="255"/>
        <pc:sldMkLst>
          <pc:docMk/>
          <pc:sldMk cId="109857222" sldId="256"/>
        </pc:sldMkLst>
        <pc:spChg chg="del">
          <ac:chgData name="Jake Kendrick" userId="c9aa91da-2e15-46cf-a8c4-b4cee9b8e514" providerId="ADAL" clId="{4D39B9F2-2A26-5844-9159-FAC44B83CB06}" dt="2022-05-16T02:36:42.839" v="0" actId="478"/>
          <ac:spMkLst>
            <pc:docMk/>
            <pc:sldMk cId="109857222" sldId="256"/>
            <ac:spMk id="2" creationId="{00000000-0000-0000-0000-000000000000}"/>
          </ac:spMkLst>
        </pc:spChg>
        <pc:spChg chg="del">
          <ac:chgData name="Jake Kendrick" userId="c9aa91da-2e15-46cf-a8c4-b4cee9b8e514" providerId="ADAL" clId="{4D39B9F2-2A26-5844-9159-FAC44B83CB06}" dt="2022-05-16T02:36:44.015" v="1" actId="478"/>
          <ac:spMkLst>
            <pc:docMk/>
            <pc:sldMk cId="109857222" sldId="256"/>
            <ac:spMk id="3" creationId="{00000000-0000-0000-0000-000000000000}"/>
          </ac:spMkLst>
        </pc:spChg>
        <pc:spChg chg="add mod">
          <ac:chgData name="Jake Kendrick" userId="c9aa91da-2e15-46cf-a8c4-b4cee9b8e514" providerId="ADAL" clId="{4D39B9F2-2A26-5844-9159-FAC44B83CB06}" dt="2022-05-16T02:49:24.057" v="139" actId="1076"/>
          <ac:spMkLst>
            <pc:docMk/>
            <pc:sldMk cId="109857222" sldId="256"/>
            <ac:spMk id="10" creationId="{77A02ED0-8423-0C42-930A-6F5D1DA6A053}"/>
          </ac:spMkLst>
        </pc:spChg>
        <pc:spChg chg="add mod">
          <ac:chgData name="Jake Kendrick" userId="c9aa91da-2e15-46cf-a8c4-b4cee9b8e514" providerId="ADAL" clId="{4D39B9F2-2A26-5844-9159-FAC44B83CB06}" dt="2022-05-16T02:49:24.057" v="139" actId="1076"/>
          <ac:spMkLst>
            <pc:docMk/>
            <pc:sldMk cId="109857222" sldId="256"/>
            <ac:spMk id="11" creationId="{51C3C997-41C1-7247-BB0B-5044F4E47364}"/>
          </ac:spMkLst>
        </pc:spChg>
        <pc:spChg chg="add mod">
          <ac:chgData name="Jake Kendrick" userId="c9aa91da-2e15-46cf-a8c4-b4cee9b8e514" providerId="ADAL" clId="{4D39B9F2-2A26-5844-9159-FAC44B83CB06}" dt="2022-05-16T02:49:24.057" v="139" actId="1076"/>
          <ac:spMkLst>
            <pc:docMk/>
            <pc:sldMk cId="109857222" sldId="256"/>
            <ac:spMk id="12" creationId="{CBAAA63C-1BA9-DA4A-A878-9EC83D20AC07}"/>
          </ac:spMkLst>
        </pc:spChg>
        <pc:spChg chg="add mod">
          <ac:chgData name="Jake Kendrick" userId="c9aa91da-2e15-46cf-a8c4-b4cee9b8e514" providerId="ADAL" clId="{4D39B9F2-2A26-5844-9159-FAC44B83CB06}" dt="2022-05-16T06:21:44.646" v="1059" actId="255"/>
          <ac:spMkLst>
            <pc:docMk/>
            <pc:sldMk cId="109857222" sldId="256"/>
            <ac:spMk id="13" creationId="{A9A32FB2-2064-654E-9855-BDC1D5C342CA}"/>
          </ac:spMkLst>
        </pc:spChg>
        <pc:picChg chg="add mod modCrop">
          <ac:chgData name="Jake Kendrick" userId="c9aa91da-2e15-46cf-a8c4-b4cee9b8e514" providerId="ADAL" clId="{4D39B9F2-2A26-5844-9159-FAC44B83CB06}" dt="2022-05-16T02:48:12.368" v="79" actId="1076"/>
          <ac:picMkLst>
            <pc:docMk/>
            <pc:sldMk cId="109857222" sldId="256"/>
            <ac:picMk id="5" creationId="{D0D72CDC-DB73-4A46-BC72-65F82BD2E953}"/>
          </ac:picMkLst>
        </pc:picChg>
        <pc:picChg chg="add mod modCrop">
          <ac:chgData name="Jake Kendrick" userId="c9aa91da-2e15-46cf-a8c4-b4cee9b8e514" providerId="ADAL" clId="{4D39B9F2-2A26-5844-9159-FAC44B83CB06}" dt="2022-05-16T02:49:24.057" v="139" actId="1076"/>
          <ac:picMkLst>
            <pc:docMk/>
            <pc:sldMk cId="109857222" sldId="256"/>
            <ac:picMk id="7" creationId="{39AFEE4A-488A-8545-A74A-679028501F65}"/>
          </ac:picMkLst>
        </pc:picChg>
        <pc:picChg chg="add mod">
          <ac:chgData name="Jake Kendrick" userId="c9aa91da-2e15-46cf-a8c4-b4cee9b8e514" providerId="ADAL" clId="{4D39B9F2-2A26-5844-9159-FAC44B83CB06}" dt="2022-05-16T02:49:24.057" v="139" actId="1076"/>
          <ac:picMkLst>
            <pc:docMk/>
            <pc:sldMk cId="109857222" sldId="256"/>
            <ac:picMk id="9" creationId="{7534F080-3019-5945-A870-517575C07067}"/>
          </ac:picMkLst>
        </pc:picChg>
        <pc:cxnChg chg="add mod">
          <ac:chgData name="Jake Kendrick" userId="c9aa91da-2e15-46cf-a8c4-b4cee9b8e514" providerId="ADAL" clId="{4D39B9F2-2A26-5844-9159-FAC44B83CB06}" dt="2022-05-16T02:50:12.996" v="143" actId="1076"/>
          <ac:cxnSpMkLst>
            <pc:docMk/>
            <pc:sldMk cId="109857222" sldId="256"/>
            <ac:cxnSpMk id="15" creationId="{31A8256A-2223-0045-8866-AF2EE0DBAA26}"/>
          </ac:cxnSpMkLst>
        </pc:cxnChg>
      </pc:sldChg>
      <pc:sldMasterChg chg="modSp modSldLayout">
        <pc:chgData name="Jake Kendrick" userId="c9aa91da-2e15-46cf-a8c4-b4cee9b8e514" providerId="ADAL" clId="{4D39B9F2-2A26-5844-9159-FAC44B83CB06}" dt="2022-05-16T02:37:19.615" v="2"/>
        <pc:sldMasterMkLst>
          <pc:docMk/>
          <pc:sldMasterMk cId="2460954070" sldId="2147483660"/>
        </pc:sldMasterMkLst>
        <pc:spChg chg="mod">
          <ac:chgData name="Jake Kendrick" userId="c9aa91da-2e15-46cf-a8c4-b4cee9b8e514" providerId="ADAL" clId="{4D39B9F2-2A26-5844-9159-FAC44B83CB06}" dt="2022-05-16T02:37:19.615" v="2"/>
          <ac:spMkLst>
            <pc:docMk/>
            <pc:sldMasterMk cId="2460954070" sldId="2147483660"/>
            <ac:spMk id="2" creationId="{00000000-0000-0000-0000-000000000000}"/>
          </ac:spMkLst>
        </pc:spChg>
        <pc:spChg chg="mod">
          <ac:chgData name="Jake Kendrick" userId="c9aa91da-2e15-46cf-a8c4-b4cee9b8e514" providerId="ADAL" clId="{4D39B9F2-2A26-5844-9159-FAC44B83CB06}" dt="2022-05-16T02:37:19.615" v="2"/>
          <ac:spMkLst>
            <pc:docMk/>
            <pc:sldMasterMk cId="2460954070" sldId="2147483660"/>
            <ac:spMk id="3" creationId="{00000000-0000-0000-0000-000000000000}"/>
          </ac:spMkLst>
        </pc:spChg>
        <pc:spChg chg="mod">
          <ac:chgData name="Jake Kendrick" userId="c9aa91da-2e15-46cf-a8c4-b4cee9b8e514" providerId="ADAL" clId="{4D39B9F2-2A26-5844-9159-FAC44B83CB06}" dt="2022-05-16T02:37:19.615" v="2"/>
          <ac:spMkLst>
            <pc:docMk/>
            <pc:sldMasterMk cId="2460954070" sldId="2147483660"/>
            <ac:spMk id="4" creationId="{00000000-0000-0000-0000-000000000000}"/>
          </ac:spMkLst>
        </pc:spChg>
        <pc:spChg chg="mod">
          <ac:chgData name="Jake Kendrick" userId="c9aa91da-2e15-46cf-a8c4-b4cee9b8e514" providerId="ADAL" clId="{4D39B9F2-2A26-5844-9159-FAC44B83CB06}" dt="2022-05-16T02:37:19.615" v="2"/>
          <ac:spMkLst>
            <pc:docMk/>
            <pc:sldMasterMk cId="2460954070" sldId="2147483660"/>
            <ac:spMk id="5" creationId="{00000000-0000-0000-0000-000000000000}"/>
          </ac:spMkLst>
        </pc:spChg>
        <pc:spChg chg="mod">
          <ac:chgData name="Jake Kendrick" userId="c9aa91da-2e15-46cf-a8c4-b4cee9b8e514" providerId="ADAL" clId="{4D39B9F2-2A26-5844-9159-FAC44B83CB06}" dt="2022-05-16T02:37:19.615" v="2"/>
          <ac:spMkLst>
            <pc:docMk/>
            <pc:sldMasterMk cId="2460954070" sldId="2147483660"/>
            <ac:spMk id="6" creationId="{00000000-0000-0000-0000-000000000000}"/>
          </ac:spMkLst>
        </pc:spChg>
        <pc:sldLayoutChg chg="modSp">
          <pc:chgData name="Jake Kendrick" userId="c9aa91da-2e15-46cf-a8c4-b4cee9b8e514" providerId="ADAL" clId="{4D39B9F2-2A26-5844-9159-FAC44B83CB06}" dt="2022-05-16T02:37:19.615" v="2"/>
          <pc:sldLayoutMkLst>
            <pc:docMk/>
            <pc:sldMasterMk cId="2460954070" sldId="2147483660"/>
            <pc:sldLayoutMk cId="2385387890" sldId="2147483661"/>
          </pc:sldLayoutMkLst>
          <pc:spChg chg="mod">
            <ac:chgData name="Jake Kendrick" userId="c9aa91da-2e15-46cf-a8c4-b4cee9b8e514" providerId="ADAL" clId="{4D39B9F2-2A26-5844-9159-FAC44B83CB06}" dt="2022-05-16T02:37:19.615" v="2"/>
            <ac:spMkLst>
              <pc:docMk/>
              <pc:sldMasterMk cId="2460954070" sldId="2147483660"/>
              <pc:sldLayoutMk cId="2385387890" sldId="2147483661"/>
              <ac:spMk id="2" creationId="{00000000-0000-0000-0000-000000000000}"/>
            </ac:spMkLst>
          </pc:spChg>
          <pc:spChg chg="mod">
            <ac:chgData name="Jake Kendrick" userId="c9aa91da-2e15-46cf-a8c4-b4cee9b8e514" providerId="ADAL" clId="{4D39B9F2-2A26-5844-9159-FAC44B83CB06}" dt="2022-05-16T02:37:19.615" v="2"/>
            <ac:spMkLst>
              <pc:docMk/>
              <pc:sldMasterMk cId="2460954070" sldId="2147483660"/>
              <pc:sldLayoutMk cId="2385387890" sldId="2147483661"/>
              <ac:spMk id="3" creationId="{00000000-0000-0000-0000-000000000000}"/>
            </ac:spMkLst>
          </pc:spChg>
        </pc:sldLayoutChg>
        <pc:sldLayoutChg chg="modSp">
          <pc:chgData name="Jake Kendrick" userId="c9aa91da-2e15-46cf-a8c4-b4cee9b8e514" providerId="ADAL" clId="{4D39B9F2-2A26-5844-9159-FAC44B83CB06}" dt="2022-05-16T02:37:19.615" v="2"/>
          <pc:sldLayoutMkLst>
            <pc:docMk/>
            <pc:sldMasterMk cId="2460954070" sldId="2147483660"/>
            <pc:sldLayoutMk cId="2591524520" sldId="2147483663"/>
          </pc:sldLayoutMkLst>
          <pc:spChg chg="mod">
            <ac:chgData name="Jake Kendrick" userId="c9aa91da-2e15-46cf-a8c4-b4cee9b8e514" providerId="ADAL" clId="{4D39B9F2-2A26-5844-9159-FAC44B83CB06}" dt="2022-05-16T02:37:19.615" v="2"/>
            <ac:spMkLst>
              <pc:docMk/>
              <pc:sldMasterMk cId="2460954070" sldId="2147483660"/>
              <pc:sldLayoutMk cId="2591524520" sldId="2147483663"/>
              <ac:spMk id="2" creationId="{00000000-0000-0000-0000-000000000000}"/>
            </ac:spMkLst>
          </pc:spChg>
          <pc:spChg chg="mod">
            <ac:chgData name="Jake Kendrick" userId="c9aa91da-2e15-46cf-a8c4-b4cee9b8e514" providerId="ADAL" clId="{4D39B9F2-2A26-5844-9159-FAC44B83CB06}" dt="2022-05-16T02:37:19.615" v="2"/>
            <ac:spMkLst>
              <pc:docMk/>
              <pc:sldMasterMk cId="2460954070" sldId="2147483660"/>
              <pc:sldLayoutMk cId="2591524520" sldId="2147483663"/>
              <ac:spMk id="3" creationId="{00000000-0000-0000-0000-000000000000}"/>
            </ac:spMkLst>
          </pc:spChg>
        </pc:sldLayoutChg>
        <pc:sldLayoutChg chg="modSp">
          <pc:chgData name="Jake Kendrick" userId="c9aa91da-2e15-46cf-a8c4-b4cee9b8e514" providerId="ADAL" clId="{4D39B9F2-2A26-5844-9159-FAC44B83CB06}" dt="2022-05-16T02:37:19.615" v="2"/>
          <pc:sldLayoutMkLst>
            <pc:docMk/>
            <pc:sldMasterMk cId="2460954070" sldId="2147483660"/>
            <pc:sldLayoutMk cId="1203092039" sldId="2147483664"/>
          </pc:sldLayoutMkLst>
          <pc:spChg chg="mod">
            <ac:chgData name="Jake Kendrick" userId="c9aa91da-2e15-46cf-a8c4-b4cee9b8e514" providerId="ADAL" clId="{4D39B9F2-2A26-5844-9159-FAC44B83CB06}" dt="2022-05-16T02:37:19.615" v="2"/>
            <ac:spMkLst>
              <pc:docMk/>
              <pc:sldMasterMk cId="2460954070" sldId="2147483660"/>
              <pc:sldLayoutMk cId="1203092039" sldId="2147483664"/>
              <ac:spMk id="3" creationId="{00000000-0000-0000-0000-000000000000}"/>
            </ac:spMkLst>
          </pc:spChg>
          <pc:spChg chg="mod">
            <ac:chgData name="Jake Kendrick" userId="c9aa91da-2e15-46cf-a8c4-b4cee9b8e514" providerId="ADAL" clId="{4D39B9F2-2A26-5844-9159-FAC44B83CB06}" dt="2022-05-16T02:37:19.615" v="2"/>
            <ac:spMkLst>
              <pc:docMk/>
              <pc:sldMasterMk cId="2460954070" sldId="2147483660"/>
              <pc:sldLayoutMk cId="1203092039" sldId="2147483664"/>
              <ac:spMk id="4" creationId="{00000000-0000-0000-0000-000000000000}"/>
            </ac:spMkLst>
          </pc:spChg>
        </pc:sldLayoutChg>
        <pc:sldLayoutChg chg="modSp">
          <pc:chgData name="Jake Kendrick" userId="c9aa91da-2e15-46cf-a8c4-b4cee9b8e514" providerId="ADAL" clId="{4D39B9F2-2A26-5844-9159-FAC44B83CB06}" dt="2022-05-16T02:37:19.615" v="2"/>
          <pc:sldLayoutMkLst>
            <pc:docMk/>
            <pc:sldMasterMk cId="2460954070" sldId="2147483660"/>
            <pc:sldLayoutMk cId="3733172339" sldId="2147483665"/>
          </pc:sldLayoutMkLst>
          <pc:spChg chg="mod">
            <ac:chgData name="Jake Kendrick" userId="c9aa91da-2e15-46cf-a8c4-b4cee9b8e514" providerId="ADAL" clId="{4D39B9F2-2A26-5844-9159-FAC44B83CB06}" dt="2022-05-16T02:37:19.615" v="2"/>
            <ac:spMkLst>
              <pc:docMk/>
              <pc:sldMasterMk cId="2460954070" sldId="2147483660"/>
              <pc:sldLayoutMk cId="3733172339" sldId="2147483665"/>
              <ac:spMk id="2" creationId="{00000000-0000-0000-0000-000000000000}"/>
            </ac:spMkLst>
          </pc:spChg>
          <pc:spChg chg="mod">
            <ac:chgData name="Jake Kendrick" userId="c9aa91da-2e15-46cf-a8c4-b4cee9b8e514" providerId="ADAL" clId="{4D39B9F2-2A26-5844-9159-FAC44B83CB06}" dt="2022-05-16T02:37:19.615" v="2"/>
            <ac:spMkLst>
              <pc:docMk/>
              <pc:sldMasterMk cId="2460954070" sldId="2147483660"/>
              <pc:sldLayoutMk cId="3733172339" sldId="2147483665"/>
              <ac:spMk id="3" creationId="{00000000-0000-0000-0000-000000000000}"/>
            </ac:spMkLst>
          </pc:spChg>
          <pc:spChg chg="mod">
            <ac:chgData name="Jake Kendrick" userId="c9aa91da-2e15-46cf-a8c4-b4cee9b8e514" providerId="ADAL" clId="{4D39B9F2-2A26-5844-9159-FAC44B83CB06}" dt="2022-05-16T02:37:19.615" v="2"/>
            <ac:spMkLst>
              <pc:docMk/>
              <pc:sldMasterMk cId="2460954070" sldId="2147483660"/>
              <pc:sldLayoutMk cId="3733172339" sldId="2147483665"/>
              <ac:spMk id="4" creationId="{00000000-0000-0000-0000-000000000000}"/>
            </ac:spMkLst>
          </pc:spChg>
          <pc:spChg chg="mod">
            <ac:chgData name="Jake Kendrick" userId="c9aa91da-2e15-46cf-a8c4-b4cee9b8e514" providerId="ADAL" clId="{4D39B9F2-2A26-5844-9159-FAC44B83CB06}" dt="2022-05-16T02:37:19.615" v="2"/>
            <ac:spMkLst>
              <pc:docMk/>
              <pc:sldMasterMk cId="2460954070" sldId="2147483660"/>
              <pc:sldLayoutMk cId="3733172339" sldId="2147483665"/>
              <ac:spMk id="5" creationId="{00000000-0000-0000-0000-000000000000}"/>
            </ac:spMkLst>
          </pc:spChg>
          <pc:spChg chg="mod">
            <ac:chgData name="Jake Kendrick" userId="c9aa91da-2e15-46cf-a8c4-b4cee9b8e514" providerId="ADAL" clId="{4D39B9F2-2A26-5844-9159-FAC44B83CB06}" dt="2022-05-16T02:37:19.615" v="2"/>
            <ac:spMkLst>
              <pc:docMk/>
              <pc:sldMasterMk cId="2460954070" sldId="2147483660"/>
              <pc:sldLayoutMk cId="3733172339" sldId="2147483665"/>
              <ac:spMk id="6" creationId="{00000000-0000-0000-0000-000000000000}"/>
            </ac:spMkLst>
          </pc:spChg>
        </pc:sldLayoutChg>
        <pc:sldLayoutChg chg="modSp">
          <pc:chgData name="Jake Kendrick" userId="c9aa91da-2e15-46cf-a8c4-b4cee9b8e514" providerId="ADAL" clId="{4D39B9F2-2A26-5844-9159-FAC44B83CB06}" dt="2022-05-16T02:37:19.615" v="2"/>
          <pc:sldLayoutMkLst>
            <pc:docMk/>
            <pc:sldMasterMk cId="2460954070" sldId="2147483660"/>
            <pc:sldLayoutMk cId="3171841454" sldId="2147483668"/>
          </pc:sldLayoutMkLst>
          <pc:spChg chg="mod">
            <ac:chgData name="Jake Kendrick" userId="c9aa91da-2e15-46cf-a8c4-b4cee9b8e514" providerId="ADAL" clId="{4D39B9F2-2A26-5844-9159-FAC44B83CB06}" dt="2022-05-16T02:37:19.615" v="2"/>
            <ac:spMkLst>
              <pc:docMk/>
              <pc:sldMasterMk cId="2460954070" sldId="2147483660"/>
              <pc:sldLayoutMk cId="3171841454" sldId="2147483668"/>
              <ac:spMk id="2" creationId="{00000000-0000-0000-0000-000000000000}"/>
            </ac:spMkLst>
          </pc:spChg>
          <pc:spChg chg="mod">
            <ac:chgData name="Jake Kendrick" userId="c9aa91da-2e15-46cf-a8c4-b4cee9b8e514" providerId="ADAL" clId="{4D39B9F2-2A26-5844-9159-FAC44B83CB06}" dt="2022-05-16T02:37:19.615" v="2"/>
            <ac:spMkLst>
              <pc:docMk/>
              <pc:sldMasterMk cId="2460954070" sldId="2147483660"/>
              <pc:sldLayoutMk cId="3171841454" sldId="2147483668"/>
              <ac:spMk id="3" creationId="{00000000-0000-0000-0000-000000000000}"/>
            </ac:spMkLst>
          </pc:spChg>
          <pc:spChg chg="mod">
            <ac:chgData name="Jake Kendrick" userId="c9aa91da-2e15-46cf-a8c4-b4cee9b8e514" providerId="ADAL" clId="{4D39B9F2-2A26-5844-9159-FAC44B83CB06}" dt="2022-05-16T02:37:19.615" v="2"/>
            <ac:spMkLst>
              <pc:docMk/>
              <pc:sldMasterMk cId="2460954070" sldId="2147483660"/>
              <pc:sldLayoutMk cId="3171841454" sldId="2147483668"/>
              <ac:spMk id="4" creationId="{00000000-0000-0000-0000-000000000000}"/>
            </ac:spMkLst>
          </pc:spChg>
        </pc:sldLayoutChg>
        <pc:sldLayoutChg chg="modSp">
          <pc:chgData name="Jake Kendrick" userId="c9aa91da-2e15-46cf-a8c4-b4cee9b8e514" providerId="ADAL" clId="{4D39B9F2-2A26-5844-9159-FAC44B83CB06}" dt="2022-05-16T02:37:19.615" v="2"/>
          <pc:sldLayoutMkLst>
            <pc:docMk/>
            <pc:sldMasterMk cId="2460954070" sldId="2147483660"/>
            <pc:sldLayoutMk cId="1718958274" sldId="2147483669"/>
          </pc:sldLayoutMkLst>
          <pc:spChg chg="mod">
            <ac:chgData name="Jake Kendrick" userId="c9aa91da-2e15-46cf-a8c4-b4cee9b8e514" providerId="ADAL" clId="{4D39B9F2-2A26-5844-9159-FAC44B83CB06}" dt="2022-05-16T02:37:19.615" v="2"/>
            <ac:spMkLst>
              <pc:docMk/>
              <pc:sldMasterMk cId="2460954070" sldId="2147483660"/>
              <pc:sldLayoutMk cId="1718958274" sldId="2147483669"/>
              <ac:spMk id="2" creationId="{00000000-0000-0000-0000-000000000000}"/>
            </ac:spMkLst>
          </pc:spChg>
          <pc:spChg chg="mod">
            <ac:chgData name="Jake Kendrick" userId="c9aa91da-2e15-46cf-a8c4-b4cee9b8e514" providerId="ADAL" clId="{4D39B9F2-2A26-5844-9159-FAC44B83CB06}" dt="2022-05-16T02:37:19.615" v="2"/>
            <ac:spMkLst>
              <pc:docMk/>
              <pc:sldMasterMk cId="2460954070" sldId="2147483660"/>
              <pc:sldLayoutMk cId="1718958274" sldId="2147483669"/>
              <ac:spMk id="3" creationId="{00000000-0000-0000-0000-000000000000}"/>
            </ac:spMkLst>
          </pc:spChg>
          <pc:spChg chg="mod">
            <ac:chgData name="Jake Kendrick" userId="c9aa91da-2e15-46cf-a8c4-b4cee9b8e514" providerId="ADAL" clId="{4D39B9F2-2A26-5844-9159-FAC44B83CB06}" dt="2022-05-16T02:37:19.615" v="2"/>
            <ac:spMkLst>
              <pc:docMk/>
              <pc:sldMasterMk cId="2460954070" sldId="2147483660"/>
              <pc:sldLayoutMk cId="1718958274" sldId="2147483669"/>
              <ac:spMk id="4" creationId="{00000000-0000-0000-0000-000000000000}"/>
            </ac:spMkLst>
          </pc:spChg>
        </pc:sldLayoutChg>
        <pc:sldLayoutChg chg="modSp">
          <pc:chgData name="Jake Kendrick" userId="c9aa91da-2e15-46cf-a8c4-b4cee9b8e514" providerId="ADAL" clId="{4D39B9F2-2A26-5844-9159-FAC44B83CB06}" dt="2022-05-16T02:37:19.615" v="2"/>
          <pc:sldLayoutMkLst>
            <pc:docMk/>
            <pc:sldMasterMk cId="2460954070" sldId="2147483660"/>
            <pc:sldLayoutMk cId="3479445657" sldId="2147483671"/>
          </pc:sldLayoutMkLst>
          <pc:spChg chg="mod">
            <ac:chgData name="Jake Kendrick" userId="c9aa91da-2e15-46cf-a8c4-b4cee9b8e514" providerId="ADAL" clId="{4D39B9F2-2A26-5844-9159-FAC44B83CB06}" dt="2022-05-16T02:37:19.615" v="2"/>
            <ac:spMkLst>
              <pc:docMk/>
              <pc:sldMasterMk cId="2460954070" sldId="2147483660"/>
              <pc:sldLayoutMk cId="3479445657" sldId="2147483671"/>
              <ac:spMk id="2" creationId="{00000000-0000-0000-0000-000000000000}"/>
            </ac:spMkLst>
          </pc:spChg>
          <pc:spChg chg="mod">
            <ac:chgData name="Jake Kendrick" userId="c9aa91da-2e15-46cf-a8c4-b4cee9b8e514" providerId="ADAL" clId="{4D39B9F2-2A26-5844-9159-FAC44B83CB06}" dt="2022-05-16T02:37:19.615" v="2"/>
            <ac:spMkLst>
              <pc:docMk/>
              <pc:sldMasterMk cId="2460954070" sldId="2147483660"/>
              <pc:sldLayoutMk cId="3479445657" sldId="2147483671"/>
              <ac:spMk id="3" creationId="{00000000-0000-0000-0000-000000000000}"/>
            </ac:spMkLst>
          </pc:spChg>
        </pc:sldLayoutChg>
      </pc:sldMasterChg>
      <pc:sldMasterChg chg="modSp modSldLayout">
        <pc:chgData name="Jake Kendrick" userId="c9aa91da-2e15-46cf-a8c4-b4cee9b8e514" providerId="ADAL" clId="{4D39B9F2-2A26-5844-9159-FAC44B83CB06}" dt="2022-05-16T02:37:31.962" v="3"/>
        <pc:sldMasterMkLst>
          <pc:docMk/>
          <pc:sldMasterMk cId="1448422383" sldId="2147483672"/>
        </pc:sldMasterMkLst>
        <pc:spChg chg="mod">
          <ac:chgData name="Jake Kendrick" userId="c9aa91da-2e15-46cf-a8c4-b4cee9b8e514" providerId="ADAL" clId="{4D39B9F2-2A26-5844-9159-FAC44B83CB06}" dt="2022-05-16T02:37:31.962" v="3"/>
          <ac:spMkLst>
            <pc:docMk/>
            <pc:sldMasterMk cId="1448422383" sldId="2147483672"/>
            <ac:spMk id="2" creationId="{00000000-0000-0000-0000-000000000000}"/>
          </ac:spMkLst>
        </pc:spChg>
        <pc:spChg chg="mod">
          <ac:chgData name="Jake Kendrick" userId="c9aa91da-2e15-46cf-a8c4-b4cee9b8e514" providerId="ADAL" clId="{4D39B9F2-2A26-5844-9159-FAC44B83CB06}" dt="2022-05-16T02:37:31.962" v="3"/>
          <ac:spMkLst>
            <pc:docMk/>
            <pc:sldMasterMk cId="1448422383" sldId="2147483672"/>
            <ac:spMk id="3" creationId="{00000000-0000-0000-0000-000000000000}"/>
          </ac:spMkLst>
        </pc:spChg>
        <pc:spChg chg="mod">
          <ac:chgData name="Jake Kendrick" userId="c9aa91da-2e15-46cf-a8c4-b4cee9b8e514" providerId="ADAL" clId="{4D39B9F2-2A26-5844-9159-FAC44B83CB06}" dt="2022-05-16T02:37:31.962" v="3"/>
          <ac:spMkLst>
            <pc:docMk/>
            <pc:sldMasterMk cId="1448422383" sldId="2147483672"/>
            <ac:spMk id="4" creationId="{00000000-0000-0000-0000-000000000000}"/>
          </ac:spMkLst>
        </pc:spChg>
        <pc:spChg chg="mod">
          <ac:chgData name="Jake Kendrick" userId="c9aa91da-2e15-46cf-a8c4-b4cee9b8e514" providerId="ADAL" clId="{4D39B9F2-2A26-5844-9159-FAC44B83CB06}" dt="2022-05-16T02:37:31.962" v="3"/>
          <ac:spMkLst>
            <pc:docMk/>
            <pc:sldMasterMk cId="1448422383" sldId="2147483672"/>
            <ac:spMk id="5" creationId="{00000000-0000-0000-0000-000000000000}"/>
          </ac:spMkLst>
        </pc:spChg>
        <pc:spChg chg="mod">
          <ac:chgData name="Jake Kendrick" userId="c9aa91da-2e15-46cf-a8c4-b4cee9b8e514" providerId="ADAL" clId="{4D39B9F2-2A26-5844-9159-FAC44B83CB06}" dt="2022-05-16T02:37:31.962" v="3"/>
          <ac:spMkLst>
            <pc:docMk/>
            <pc:sldMasterMk cId="1448422383" sldId="2147483672"/>
            <ac:spMk id="6" creationId="{00000000-0000-0000-0000-000000000000}"/>
          </ac:spMkLst>
        </pc:spChg>
        <pc:sldLayoutChg chg="modSp">
          <pc:chgData name="Jake Kendrick" userId="c9aa91da-2e15-46cf-a8c4-b4cee9b8e514" providerId="ADAL" clId="{4D39B9F2-2A26-5844-9159-FAC44B83CB06}" dt="2022-05-16T02:37:31.962" v="3"/>
          <pc:sldLayoutMkLst>
            <pc:docMk/>
            <pc:sldMasterMk cId="1448422383" sldId="2147483672"/>
            <pc:sldLayoutMk cId="2719679625" sldId="2147483673"/>
          </pc:sldLayoutMkLst>
          <pc:spChg chg="mod">
            <ac:chgData name="Jake Kendrick" userId="c9aa91da-2e15-46cf-a8c4-b4cee9b8e514" providerId="ADAL" clId="{4D39B9F2-2A26-5844-9159-FAC44B83CB06}" dt="2022-05-16T02:37:31.962" v="3"/>
            <ac:spMkLst>
              <pc:docMk/>
              <pc:sldMasterMk cId="1448422383" sldId="2147483672"/>
              <pc:sldLayoutMk cId="2719679625" sldId="2147483673"/>
              <ac:spMk id="2" creationId="{00000000-0000-0000-0000-000000000000}"/>
            </ac:spMkLst>
          </pc:spChg>
          <pc:spChg chg="mod">
            <ac:chgData name="Jake Kendrick" userId="c9aa91da-2e15-46cf-a8c4-b4cee9b8e514" providerId="ADAL" clId="{4D39B9F2-2A26-5844-9159-FAC44B83CB06}" dt="2022-05-16T02:37:31.962" v="3"/>
            <ac:spMkLst>
              <pc:docMk/>
              <pc:sldMasterMk cId="1448422383" sldId="2147483672"/>
              <pc:sldLayoutMk cId="2719679625" sldId="2147483673"/>
              <ac:spMk id="3" creationId="{00000000-0000-0000-0000-000000000000}"/>
            </ac:spMkLst>
          </pc:spChg>
        </pc:sldLayoutChg>
        <pc:sldLayoutChg chg="modSp">
          <pc:chgData name="Jake Kendrick" userId="c9aa91da-2e15-46cf-a8c4-b4cee9b8e514" providerId="ADAL" clId="{4D39B9F2-2A26-5844-9159-FAC44B83CB06}" dt="2022-05-16T02:37:31.962" v="3"/>
          <pc:sldLayoutMkLst>
            <pc:docMk/>
            <pc:sldMasterMk cId="1448422383" sldId="2147483672"/>
            <pc:sldLayoutMk cId="2619595333" sldId="2147483675"/>
          </pc:sldLayoutMkLst>
          <pc:spChg chg="mod">
            <ac:chgData name="Jake Kendrick" userId="c9aa91da-2e15-46cf-a8c4-b4cee9b8e514" providerId="ADAL" clId="{4D39B9F2-2A26-5844-9159-FAC44B83CB06}" dt="2022-05-16T02:37:31.962" v="3"/>
            <ac:spMkLst>
              <pc:docMk/>
              <pc:sldMasterMk cId="1448422383" sldId="2147483672"/>
              <pc:sldLayoutMk cId="2619595333" sldId="2147483675"/>
              <ac:spMk id="2" creationId="{00000000-0000-0000-0000-000000000000}"/>
            </ac:spMkLst>
          </pc:spChg>
          <pc:spChg chg="mod">
            <ac:chgData name="Jake Kendrick" userId="c9aa91da-2e15-46cf-a8c4-b4cee9b8e514" providerId="ADAL" clId="{4D39B9F2-2A26-5844-9159-FAC44B83CB06}" dt="2022-05-16T02:37:31.962" v="3"/>
            <ac:spMkLst>
              <pc:docMk/>
              <pc:sldMasterMk cId="1448422383" sldId="2147483672"/>
              <pc:sldLayoutMk cId="2619595333" sldId="2147483675"/>
              <ac:spMk id="3" creationId="{00000000-0000-0000-0000-000000000000}"/>
            </ac:spMkLst>
          </pc:spChg>
        </pc:sldLayoutChg>
        <pc:sldLayoutChg chg="modSp">
          <pc:chgData name="Jake Kendrick" userId="c9aa91da-2e15-46cf-a8c4-b4cee9b8e514" providerId="ADAL" clId="{4D39B9F2-2A26-5844-9159-FAC44B83CB06}" dt="2022-05-16T02:37:31.962" v="3"/>
          <pc:sldLayoutMkLst>
            <pc:docMk/>
            <pc:sldMasterMk cId="1448422383" sldId="2147483672"/>
            <pc:sldLayoutMk cId="7411637" sldId="2147483676"/>
          </pc:sldLayoutMkLst>
          <pc:spChg chg="mod">
            <ac:chgData name="Jake Kendrick" userId="c9aa91da-2e15-46cf-a8c4-b4cee9b8e514" providerId="ADAL" clId="{4D39B9F2-2A26-5844-9159-FAC44B83CB06}" dt="2022-05-16T02:37:31.962" v="3"/>
            <ac:spMkLst>
              <pc:docMk/>
              <pc:sldMasterMk cId="1448422383" sldId="2147483672"/>
              <pc:sldLayoutMk cId="7411637" sldId="2147483676"/>
              <ac:spMk id="3" creationId="{00000000-0000-0000-0000-000000000000}"/>
            </ac:spMkLst>
          </pc:spChg>
          <pc:spChg chg="mod">
            <ac:chgData name="Jake Kendrick" userId="c9aa91da-2e15-46cf-a8c4-b4cee9b8e514" providerId="ADAL" clId="{4D39B9F2-2A26-5844-9159-FAC44B83CB06}" dt="2022-05-16T02:37:31.962" v="3"/>
            <ac:spMkLst>
              <pc:docMk/>
              <pc:sldMasterMk cId="1448422383" sldId="2147483672"/>
              <pc:sldLayoutMk cId="7411637" sldId="2147483676"/>
              <ac:spMk id="4" creationId="{00000000-0000-0000-0000-000000000000}"/>
            </ac:spMkLst>
          </pc:spChg>
        </pc:sldLayoutChg>
        <pc:sldLayoutChg chg="modSp">
          <pc:chgData name="Jake Kendrick" userId="c9aa91da-2e15-46cf-a8c4-b4cee9b8e514" providerId="ADAL" clId="{4D39B9F2-2A26-5844-9159-FAC44B83CB06}" dt="2022-05-16T02:37:31.962" v="3"/>
          <pc:sldLayoutMkLst>
            <pc:docMk/>
            <pc:sldMasterMk cId="1448422383" sldId="2147483672"/>
            <pc:sldLayoutMk cId="236591791" sldId="2147483677"/>
          </pc:sldLayoutMkLst>
          <pc:spChg chg="mod">
            <ac:chgData name="Jake Kendrick" userId="c9aa91da-2e15-46cf-a8c4-b4cee9b8e514" providerId="ADAL" clId="{4D39B9F2-2A26-5844-9159-FAC44B83CB06}" dt="2022-05-16T02:37:31.962" v="3"/>
            <ac:spMkLst>
              <pc:docMk/>
              <pc:sldMasterMk cId="1448422383" sldId="2147483672"/>
              <pc:sldLayoutMk cId="236591791" sldId="2147483677"/>
              <ac:spMk id="2" creationId="{00000000-0000-0000-0000-000000000000}"/>
            </ac:spMkLst>
          </pc:spChg>
          <pc:spChg chg="mod">
            <ac:chgData name="Jake Kendrick" userId="c9aa91da-2e15-46cf-a8c4-b4cee9b8e514" providerId="ADAL" clId="{4D39B9F2-2A26-5844-9159-FAC44B83CB06}" dt="2022-05-16T02:37:31.962" v="3"/>
            <ac:spMkLst>
              <pc:docMk/>
              <pc:sldMasterMk cId="1448422383" sldId="2147483672"/>
              <pc:sldLayoutMk cId="236591791" sldId="2147483677"/>
              <ac:spMk id="3" creationId="{00000000-0000-0000-0000-000000000000}"/>
            </ac:spMkLst>
          </pc:spChg>
          <pc:spChg chg="mod">
            <ac:chgData name="Jake Kendrick" userId="c9aa91da-2e15-46cf-a8c4-b4cee9b8e514" providerId="ADAL" clId="{4D39B9F2-2A26-5844-9159-FAC44B83CB06}" dt="2022-05-16T02:37:31.962" v="3"/>
            <ac:spMkLst>
              <pc:docMk/>
              <pc:sldMasterMk cId="1448422383" sldId="2147483672"/>
              <pc:sldLayoutMk cId="236591791" sldId="2147483677"/>
              <ac:spMk id="4" creationId="{00000000-0000-0000-0000-000000000000}"/>
            </ac:spMkLst>
          </pc:spChg>
          <pc:spChg chg="mod">
            <ac:chgData name="Jake Kendrick" userId="c9aa91da-2e15-46cf-a8c4-b4cee9b8e514" providerId="ADAL" clId="{4D39B9F2-2A26-5844-9159-FAC44B83CB06}" dt="2022-05-16T02:37:31.962" v="3"/>
            <ac:spMkLst>
              <pc:docMk/>
              <pc:sldMasterMk cId="1448422383" sldId="2147483672"/>
              <pc:sldLayoutMk cId="236591791" sldId="2147483677"/>
              <ac:spMk id="5" creationId="{00000000-0000-0000-0000-000000000000}"/>
            </ac:spMkLst>
          </pc:spChg>
          <pc:spChg chg="mod">
            <ac:chgData name="Jake Kendrick" userId="c9aa91da-2e15-46cf-a8c4-b4cee9b8e514" providerId="ADAL" clId="{4D39B9F2-2A26-5844-9159-FAC44B83CB06}" dt="2022-05-16T02:37:31.962" v="3"/>
            <ac:spMkLst>
              <pc:docMk/>
              <pc:sldMasterMk cId="1448422383" sldId="2147483672"/>
              <pc:sldLayoutMk cId="236591791" sldId="2147483677"/>
              <ac:spMk id="6" creationId="{00000000-0000-0000-0000-000000000000}"/>
            </ac:spMkLst>
          </pc:spChg>
        </pc:sldLayoutChg>
        <pc:sldLayoutChg chg="modSp">
          <pc:chgData name="Jake Kendrick" userId="c9aa91da-2e15-46cf-a8c4-b4cee9b8e514" providerId="ADAL" clId="{4D39B9F2-2A26-5844-9159-FAC44B83CB06}" dt="2022-05-16T02:37:31.962" v="3"/>
          <pc:sldLayoutMkLst>
            <pc:docMk/>
            <pc:sldMasterMk cId="1448422383" sldId="2147483672"/>
            <pc:sldLayoutMk cId="936506105" sldId="2147483680"/>
          </pc:sldLayoutMkLst>
          <pc:spChg chg="mod">
            <ac:chgData name="Jake Kendrick" userId="c9aa91da-2e15-46cf-a8c4-b4cee9b8e514" providerId="ADAL" clId="{4D39B9F2-2A26-5844-9159-FAC44B83CB06}" dt="2022-05-16T02:37:31.962" v="3"/>
            <ac:spMkLst>
              <pc:docMk/>
              <pc:sldMasterMk cId="1448422383" sldId="2147483672"/>
              <pc:sldLayoutMk cId="936506105" sldId="2147483680"/>
              <ac:spMk id="2" creationId="{00000000-0000-0000-0000-000000000000}"/>
            </ac:spMkLst>
          </pc:spChg>
          <pc:spChg chg="mod">
            <ac:chgData name="Jake Kendrick" userId="c9aa91da-2e15-46cf-a8c4-b4cee9b8e514" providerId="ADAL" clId="{4D39B9F2-2A26-5844-9159-FAC44B83CB06}" dt="2022-05-16T02:37:31.962" v="3"/>
            <ac:spMkLst>
              <pc:docMk/>
              <pc:sldMasterMk cId="1448422383" sldId="2147483672"/>
              <pc:sldLayoutMk cId="936506105" sldId="2147483680"/>
              <ac:spMk id="3" creationId="{00000000-0000-0000-0000-000000000000}"/>
            </ac:spMkLst>
          </pc:spChg>
          <pc:spChg chg="mod">
            <ac:chgData name="Jake Kendrick" userId="c9aa91da-2e15-46cf-a8c4-b4cee9b8e514" providerId="ADAL" clId="{4D39B9F2-2A26-5844-9159-FAC44B83CB06}" dt="2022-05-16T02:37:31.962" v="3"/>
            <ac:spMkLst>
              <pc:docMk/>
              <pc:sldMasterMk cId="1448422383" sldId="2147483672"/>
              <pc:sldLayoutMk cId="936506105" sldId="2147483680"/>
              <ac:spMk id="4" creationId="{00000000-0000-0000-0000-000000000000}"/>
            </ac:spMkLst>
          </pc:spChg>
        </pc:sldLayoutChg>
        <pc:sldLayoutChg chg="modSp">
          <pc:chgData name="Jake Kendrick" userId="c9aa91da-2e15-46cf-a8c4-b4cee9b8e514" providerId="ADAL" clId="{4D39B9F2-2A26-5844-9159-FAC44B83CB06}" dt="2022-05-16T02:37:31.962" v="3"/>
          <pc:sldLayoutMkLst>
            <pc:docMk/>
            <pc:sldMasterMk cId="1448422383" sldId="2147483672"/>
            <pc:sldLayoutMk cId="3131925715" sldId="2147483681"/>
          </pc:sldLayoutMkLst>
          <pc:spChg chg="mod">
            <ac:chgData name="Jake Kendrick" userId="c9aa91da-2e15-46cf-a8c4-b4cee9b8e514" providerId="ADAL" clId="{4D39B9F2-2A26-5844-9159-FAC44B83CB06}" dt="2022-05-16T02:37:31.962" v="3"/>
            <ac:spMkLst>
              <pc:docMk/>
              <pc:sldMasterMk cId="1448422383" sldId="2147483672"/>
              <pc:sldLayoutMk cId="3131925715" sldId="2147483681"/>
              <ac:spMk id="2" creationId="{00000000-0000-0000-0000-000000000000}"/>
            </ac:spMkLst>
          </pc:spChg>
          <pc:spChg chg="mod">
            <ac:chgData name="Jake Kendrick" userId="c9aa91da-2e15-46cf-a8c4-b4cee9b8e514" providerId="ADAL" clId="{4D39B9F2-2A26-5844-9159-FAC44B83CB06}" dt="2022-05-16T02:37:31.962" v="3"/>
            <ac:spMkLst>
              <pc:docMk/>
              <pc:sldMasterMk cId="1448422383" sldId="2147483672"/>
              <pc:sldLayoutMk cId="3131925715" sldId="2147483681"/>
              <ac:spMk id="3" creationId="{00000000-0000-0000-0000-000000000000}"/>
            </ac:spMkLst>
          </pc:spChg>
          <pc:spChg chg="mod">
            <ac:chgData name="Jake Kendrick" userId="c9aa91da-2e15-46cf-a8c4-b4cee9b8e514" providerId="ADAL" clId="{4D39B9F2-2A26-5844-9159-FAC44B83CB06}" dt="2022-05-16T02:37:31.962" v="3"/>
            <ac:spMkLst>
              <pc:docMk/>
              <pc:sldMasterMk cId="1448422383" sldId="2147483672"/>
              <pc:sldLayoutMk cId="3131925715" sldId="2147483681"/>
              <ac:spMk id="4" creationId="{00000000-0000-0000-0000-000000000000}"/>
            </ac:spMkLst>
          </pc:spChg>
        </pc:sldLayoutChg>
        <pc:sldLayoutChg chg="modSp">
          <pc:chgData name="Jake Kendrick" userId="c9aa91da-2e15-46cf-a8c4-b4cee9b8e514" providerId="ADAL" clId="{4D39B9F2-2A26-5844-9159-FAC44B83CB06}" dt="2022-05-16T02:37:31.962" v="3"/>
          <pc:sldLayoutMkLst>
            <pc:docMk/>
            <pc:sldMasterMk cId="1448422383" sldId="2147483672"/>
            <pc:sldLayoutMk cId="867567097" sldId="2147483683"/>
          </pc:sldLayoutMkLst>
          <pc:spChg chg="mod">
            <ac:chgData name="Jake Kendrick" userId="c9aa91da-2e15-46cf-a8c4-b4cee9b8e514" providerId="ADAL" clId="{4D39B9F2-2A26-5844-9159-FAC44B83CB06}" dt="2022-05-16T02:37:31.962" v="3"/>
            <ac:spMkLst>
              <pc:docMk/>
              <pc:sldMasterMk cId="1448422383" sldId="2147483672"/>
              <pc:sldLayoutMk cId="867567097" sldId="2147483683"/>
              <ac:spMk id="2" creationId="{00000000-0000-0000-0000-000000000000}"/>
            </ac:spMkLst>
          </pc:spChg>
          <pc:spChg chg="mod">
            <ac:chgData name="Jake Kendrick" userId="c9aa91da-2e15-46cf-a8c4-b4cee9b8e514" providerId="ADAL" clId="{4D39B9F2-2A26-5844-9159-FAC44B83CB06}" dt="2022-05-16T02:37:31.962" v="3"/>
            <ac:spMkLst>
              <pc:docMk/>
              <pc:sldMasterMk cId="1448422383" sldId="2147483672"/>
              <pc:sldLayoutMk cId="867567097" sldId="2147483683"/>
              <ac:spMk id="3" creationId="{00000000-0000-0000-0000-000000000000}"/>
            </ac:spMkLst>
          </pc:spChg>
        </pc:sldLayoutChg>
      </pc:sldMasterChg>
      <pc:sldMasterChg chg="modSp modSldLayout">
        <pc:chgData name="Jake Kendrick" userId="c9aa91da-2e15-46cf-a8c4-b4cee9b8e514" providerId="ADAL" clId="{4D39B9F2-2A26-5844-9159-FAC44B83CB06}" dt="2022-05-16T02:38:17.140" v="4"/>
        <pc:sldMasterMkLst>
          <pc:docMk/>
          <pc:sldMasterMk cId="2382013965" sldId="2147483684"/>
        </pc:sldMasterMkLst>
        <pc:spChg chg="mod">
          <ac:chgData name="Jake Kendrick" userId="c9aa91da-2e15-46cf-a8c4-b4cee9b8e514" providerId="ADAL" clId="{4D39B9F2-2A26-5844-9159-FAC44B83CB06}" dt="2022-05-16T02:38:17.140" v="4"/>
          <ac:spMkLst>
            <pc:docMk/>
            <pc:sldMasterMk cId="2382013965" sldId="2147483684"/>
            <ac:spMk id="2" creationId="{00000000-0000-0000-0000-000000000000}"/>
          </ac:spMkLst>
        </pc:spChg>
        <pc:spChg chg="mod">
          <ac:chgData name="Jake Kendrick" userId="c9aa91da-2e15-46cf-a8c4-b4cee9b8e514" providerId="ADAL" clId="{4D39B9F2-2A26-5844-9159-FAC44B83CB06}" dt="2022-05-16T02:38:17.140" v="4"/>
          <ac:spMkLst>
            <pc:docMk/>
            <pc:sldMasterMk cId="2382013965" sldId="2147483684"/>
            <ac:spMk id="3" creationId="{00000000-0000-0000-0000-000000000000}"/>
          </ac:spMkLst>
        </pc:spChg>
        <pc:spChg chg="mod">
          <ac:chgData name="Jake Kendrick" userId="c9aa91da-2e15-46cf-a8c4-b4cee9b8e514" providerId="ADAL" clId="{4D39B9F2-2A26-5844-9159-FAC44B83CB06}" dt="2022-05-16T02:38:17.140" v="4"/>
          <ac:spMkLst>
            <pc:docMk/>
            <pc:sldMasterMk cId="2382013965" sldId="2147483684"/>
            <ac:spMk id="4" creationId="{00000000-0000-0000-0000-000000000000}"/>
          </ac:spMkLst>
        </pc:spChg>
        <pc:spChg chg="mod">
          <ac:chgData name="Jake Kendrick" userId="c9aa91da-2e15-46cf-a8c4-b4cee9b8e514" providerId="ADAL" clId="{4D39B9F2-2A26-5844-9159-FAC44B83CB06}" dt="2022-05-16T02:38:17.140" v="4"/>
          <ac:spMkLst>
            <pc:docMk/>
            <pc:sldMasterMk cId="2382013965" sldId="2147483684"/>
            <ac:spMk id="5" creationId="{00000000-0000-0000-0000-000000000000}"/>
          </ac:spMkLst>
        </pc:spChg>
        <pc:spChg chg="mod">
          <ac:chgData name="Jake Kendrick" userId="c9aa91da-2e15-46cf-a8c4-b4cee9b8e514" providerId="ADAL" clId="{4D39B9F2-2A26-5844-9159-FAC44B83CB06}" dt="2022-05-16T02:38:17.140" v="4"/>
          <ac:spMkLst>
            <pc:docMk/>
            <pc:sldMasterMk cId="2382013965" sldId="2147483684"/>
            <ac:spMk id="6" creationId="{00000000-0000-0000-0000-000000000000}"/>
          </ac:spMkLst>
        </pc:spChg>
        <pc:sldLayoutChg chg="modSp">
          <pc:chgData name="Jake Kendrick" userId="c9aa91da-2e15-46cf-a8c4-b4cee9b8e514" providerId="ADAL" clId="{4D39B9F2-2A26-5844-9159-FAC44B83CB06}" dt="2022-05-16T02:38:17.140" v="4"/>
          <pc:sldLayoutMkLst>
            <pc:docMk/>
            <pc:sldMasterMk cId="2382013965" sldId="2147483684"/>
            <pc:sldLayoutMk cId="996975112" sldId="2147483685"/>
          </pc:sldLayoutMkLst>
          <pc:spChg chg="mod">
            <ac:chgData name="Jake Kendrick" userId="c9aa91da-2e15-46cf-a8c4-b4cee9b8e514" providerId="ADAL" clId="{4D39B9F2-2A26-5844-9159-FAC44B83CB06}" dt="2022-05-16T02:38:17.140" v="4"/>
            <ac:spMkLst>
              <pc:docMk/>
              <pc:sldMasterMk cId="2382013965" sldId="2147483684"/>
              <pc:sldLayoutMk cId="996975112" sldId="2147483685"/>
              <ac:spMk id="2" creationId="{00000000-0000-0000-0000-000000000000}"/>
            </ac:spMkLst>
          </pc:spChg>
          <pc:spChg chg="mod">
            <ac:chgData name="Jake Kendrick" userId="c9aa91da-2e15-46cf-a8c4-b4cee9b8e514" providerId="ADAL" clId="{4D39B9F2-2A26-5844-9159-FAC44B83CB06}" dt="2022-05-16T02:38:17.140" v="4"/>
            <ac:spMkLst>
              <pc:docMk/>
              <pc:sldMasterMk cId="2382013965" sldId="2147483684"/>
              <pc:sldLayoutMk cId="996975112" sldId="2147483685"/>
              <ac:spMk id="3" creationId="{00000000-0000-0000-0000-000000000000}"/>
            </ac:spMkLst>
          </pc:spChg>
        </pc:sldLayoutChg>
        <pc:sldLayoutChg chg="modSp">
          <pc:chgData name="Jake Kendrick" userId="c9aa91da-2e15-46cf-a8c4-b4cee9b8e514" providerId="ADAL" clId="{4D39B9F2-2A26-5844-9159-FAC44B83CB06}" dt="2022-05-16T02:38:17.140" v="4"/>
          <pc:sldLayoutMkLst>
            <pc:docMk/>
            <pc:sldMasterMk cId="2382013965" sldId="2147483684"/>
            <pc:sldLayoutMk cId="2857899147" sldId="2147483687"/>
          </pc:sldLayoutMkLst>
          <pc:spChg chg="mod">
            <ac:chgData name="Jake Kendrick" userId="c9aa91da-2e15-46cf-a8c4-b4cee9b8e514" providerId="ADAL" clId="{4D39B9F2-2A26-5844-9159-FAC44B83CB06}" dt="2022-05-16T02:38:17.140" v="4"/>
            <ac:spMkLst>
              <pc:docMk/>
              <pc:sldMasterMk cId="2382013965" sldId="2147483684"/>
              <pc:sldLayoutMk cId="2857899147" sldId="2147483687"/>
              <ac:spMk id="2" creationId="{00000000-0000-0000-0000-000000000000}"/>
            </ac:spMkLst>
          </pc:spChg>
          <pc:spChg chg="mod">
            <ac:chgData name="Jake Kendrick" userId="c9aa91da-2e15-46cf-a8c4-b4cee9b8e514" providerId="ADAL" clId="{4D39B9F2-2A26-5844-9159-FAC44B83CB06}" dt="2022-05-16T02:38:17.140" v="4"/>
            <ac:spMkLst>
              <pc:docMk/>
              <pc:sldMasterMk cId="2382013965" sldId="2147483684"/>
              <pc:sldLayoutMk cId="2857899147" sldId="2147483687"/>
              <ac:spMk id="3" creationId="{00000000-0000-0000-0000-000000000000}"/>
            </ac:spMkLst>
          </pc:spChg>
        </pc:sldLayoutChg>
        <pc:sldLayoutChg chg="modSp">
          <pc:chgData name="Jake Kendrick" userId="c9aa91da-2e15-46cf-a8c4-b4cee9b8e514" providerId="ADAL" clId="{4D39B9F2-2A26-5844-9159-FAC44B83CB06}" dt="2022-05-16T02:38:17.140" v="4"/>
          <pc:sldLayoutMkLst>
            <pc:docMk/>
            <pc:sldMasterMk cId="2382013965" sldId="2147483684"/>
            <pc:sldLayoutMk cId="79401963" sldId="2147483688"/>
          </pc:sldLayoutMkLst>
          <pc:spChg chg="mod">
            <ac:chgData name="Jake Kendrick" userId="c9aa91da-2e15-46cf-a8c4-b4cee9b8e514" providerId="ADAL" clId="{4D39B9F2-2A26-5844-9159-FAC44B83CB06}" dt="2022-05-16T02:38:17.140" v="4"/>
            <ac:spMkLst>
              <pc:docMk/>
              <pc:sldMasterMk cId="2382013965" sldId="2147483684"/>
              <pc:sldLayoutMk cId="79401963" sldId="2147483688"/>
              <ac:spMk id="3" creationId="{00000000-0000-0000-0000-000000000000}"/>
            </ac:spMkLst>
          </pc:spChg>
          <pc:spChg chg="mod">
            <ac:chgData name="Jake Kendrick" userId="c9aa91da-2e15-46cf-a8c4-b4cee9b8e514" providerId="ADAL" clId="{4D39B9F2-2A26-5844-9159-FAC44B83CB06}" dt="2022-05-16T02:38:17.140" v="4"/>
            <ac:spMkLst>
              <pc:docMk/>
              <pc:sldMasterMk cId="2382013965" sldId="2147483684"/>
              <pc:sldLayoutMk cId="79401963" sldId="2147483688"/>
              <ac:spMk id="4" creationId="{00000000-0000-0000-0000-000000000000}"/>
            </ac:spMkLst>
          </pc:spChg>
        </pc:sldLayoutChg>
        <pc:sldLayoutChg chg="modSp">
          <pc:chgData name="Jake Kendrick" userId="c9aa91da-2e15-46cf-a8c4-b4cee9b8e514" providerId="ADAL" clId="{4D39B9F2-2A26-5844-9159-FAC44B83CB06}" dt="2022-05-16T02:38:17.140" v="4"/>
          <pc:sldLayoutMkLst>
            <pc:docMk/>
            <pc:sldMasterMk cId="2382013965" sldId="2147483684"/>
            <pc:sldLayoutMk cId="4289396409" sldId="2147483689"/>
          </pc:sldLayoutMkLst>
          <pc:spChg chg="mod">
            <ac:chgData name="Jake Kendrick" userId="c9aa91da-2e15-46cf-a8c4-b4cee9b8e514" providerId="ADAL" clId="{4D39B9F2-2A26-5844-9159-FAC44B83CB06}" dt="2022-05-16T02:38:17.140" v="4"/>
            <ac:spMkLst>
              <pc:docMk/>
              <pc:sldMasterMk cId="2382013965" sldId="2147483684"/>
              <pc:sldLayoutMk cId="4289396409" sldId="2147483689"/>
              <ac:spMk id="2" creationId="{00000000-0000-0000-0000-000000000000}"/>
            </ac:spMkLst>
          </pc:spChg>
          <pc:spChg chg="mod">
            <ac:chgData name="Jake Kendrick" userId="c9aa91da-2e15-46cf-a8c4-b4cee9b8e514" providerId="ADAL" clId="{4D39B9F2-2A26-5844-9159-FAC44B83CB06}" dt="2022-05-16T02:38:17.140" v="4"/>
            <ac:spMkLst>
              <pc:docMk/>
              <pc:sldMasterMk cId="2382013965" sldId="2147483684"/>
              <pc:sldLayoutMk cId="4289396409" sldId="2147483689"/>
              <ac:spMk id="3" creationId="{00000000-0000-0000-0000-000000000000}"/>
            </ac:spMkLst>
          </pc:spChg>
          <pc:spChg chg="mod">
            <ac:chgData name="Jake Kendrick" userId="c9aa91da-2e15-46cf-a8c4-b4cee9b8e514" providerId="ADAL" clId="{4D39B9F2-2A26-5844-9159-FAC44B83CB06}" dt="2022-05-16T02:38:17.140" v="4"/>
            <ac:spMkLst>
              <pc:docMk/>
              <pc:sldMasterMk cId="2382013965" sldId="2147483684"/>
              <pc:sldLayoutMk cId="4289396409" sldId="2147483689"/>
              <ac:spMk id="4" creationId="{00000000-0000-0000-0000-000000000000}"/>
            </ac:spMkLst>
          </pc:spChg>
          <pc:spChg chg="mod">
            <ac:chgData name="Jake Kendrick" userId="c9aa91da-2e15-46cf-a8c4-b4cee9b8e514" providerId="ADAL" clId="{4D39B9F2-2A26-5844-9159-FAC44B83CB06}" dt="2022-05-16T02:38:17.140" v="4"/>
            <ac:spMkLst>
              <pc:docMk/>
              <pc:sldMasterMk cId="2382013965" sldId="2147483684"/>
              <pc:sldLayoutMk cId="4289396409" sldId="2147483689"/>
              <ac:spMk id="5" creationId="{00000000-0000-0000-0000-000000000000}"/>
            </ac:spMkLst>
          </pc:spChg>
          <pc:spChg chg="mod">
            <ac:chgData name="Jake Kendrick" userId="c9aa91da-2e15-46cf-a8c4-b4cee9b8e514" providerId="ADAL" clId="{4D39B9F2-2A26-5844-9159-FAC44B83CB06}" dt="2022-05-16T02:38:17.140" v="4"/>
            <ac:spMkLst>
              <pc:docMk/>
              <pc:sldMasterMk cId="2382013965" sldId="2147483684"/>
              <pc:sldLayoutMk cId="4289396409" sldId="2147483689"/>
              <ac:spMk id="6" creationId="{00000000-0000-0000-0000-000000000000}"/>
            </ac:spMkLst>
          </pc:spChg>
        </pc:sldLayoutChg>
        <pc:sldLayoutChg chg="modSp">
          <pc:chgData name="Jake Kendrick" userId="c9aa91da-2e15-46cf-a8c4-b4cee9b8e514" providerId="ADAL" clId="{4D39B9F2-2A26-5844-9159-FAC44B83CB06}" dt="2022-05-16T02:38:17.140" v="4"/>
          <pc:sldLayoutMkLst>
            <pc:docMk/>
            <pc:sldMasterMk cId="2382013965" sldId="2147483684"/>
            <pc:sldLayoutMk cId="57237556" sldId="2147483692"/>
          </pc:sldLayoutMkLst>
          <pc:spChg chg="mod">
            <ac:chgData name="Jake Kendrick" userId="c9aa91da-2e15-46cf-a8c4-b4cee9b8e514" providerId="ADAL" clId="{4D39B9F2-2A26-5844-9159-FAC44B83CB06}" dt="2022-05-16T02:38:17.140" v="4"/>
            <ac:spMkLst>
              <pc:docMk/>
              <pc:sldMasterMk cId="2382013965" sldId="2147483684"/>
              <pc:sldLayoutMk cId="57237556" sldId="2147483692"/>
              <ac:spMk id="2" creationId="{00000000-0000-0000-0000-000000000000}"/>
            </ac:spMkLst>
          </pc:spChg>
          <pc:spChg chg="mod">
            <ac:chgData name="Jake Kendrick" userId="c9aa91da-2e15-46cf-a8c4-b4cee9b8e514" providerId="ADAL" clId="{4D39B9F2-2A26-5844-9159-FAC44B83CB06}" dt="2022-05-16T02:38:17.140" v="4"/>
            <ac:spMkLst>
              <pc:docMk/>
              <pc:sldMasterMk cId="2382013965" sldId="2147483684"/>
              <pc:sldLayoutMk cId="57237556" sldId="2147483692"/>
              <ac:spMk id="3" creationId="{00000000-0000-0000-0000-000000000000}"/>
            </ac:spMkLst>
          </pc:spChg>
          <pc:spChg chg="mod">
            <ac:chgData name="Jake Kendrick" userId="c9aa91da-2e15-46cf-a8c4-b4cee9b8e514" providerId="ADAL" clId="{4D39B9F2-2A26-5844-9159-FAC44B83CB06}" dt="2022-05-16T02:38:17.140" v="4"/>
            <ac:spMkLst>
              <pc:docMk/>
              <pc:sldMasterMk cId="2382013965" sldId="2147483684"/>
              <pc:sldLayoutMk cId="57237556" sldId="2147483692"/>
              <ac:spMk id="4" creationId="{00000000-0000-0000-0000-000000000000}"/>
            </ac:spMkLst>
          </pc:spChg>
        </pc:sldLayoutChg>
        <pc:sldLayoutChg chg="modSp">
          <pc:chgData name="Jake Kendrick" userId="c9aa91da-2e15-46cf-a8c4-b4cee9b8e514" providerId="ADAL" clId="{4D39B9F2-2A26-5844-9159-FAC44B83CB06}" dt="2022-05-16T02:38:17.140" v="4"/>
          <pc:sldLayoutMkLst>
            <pc:docMk/>
            <pc:sldMasterMk cId="2382013965" sldId="2147483684"/>
            <pc:sldLayoutMk cId="4223698147" sldId="2147483693"/>
          </pc:sldLayoutMkLst>
          <pc:spChg chg="mod">
            <ac:chgData name="Jake Kendrick" userId="c9aa91da-2e15-46cf-a8c4-b4cee9b8e514" providerId="ADAL" clId="{4D39B9F2-2A26-5844-9159-FAC44B83CB06}" dt="2022-05-16T02:38:17.140" v="4"/>
            <ac:spMkLst>
              <pc:docMk/>
              <pc:sldMasterMk cId="2382013965" sldId="2147483684"/>
              <pc:sldLayoutMk cId="4223698147" sldId="2147483693"/>
              <ac:spMk id="2" creationId="{00000000-0000-0000-0000-000000000000}"/>
            </ac:spMkLst>
          </pc:spChg>
          <pc:spChg chg="mod">
            <ac:chgData name="Jake Kendrick" userId="c9aa91da-2e15-46cf-a8c4-b4cee9b8e514" providerId="ADAL" clId="{4D39B9F2-2A26-5844-9159-FAC44B83CB06}" dt="2022-05-16T02:38:17.140" v="4"/>
            <ac:spMkLst>
              <pc:docMk/>
              <pc:sldMasterMk cId="2382013965" sldId="2147483684"/>
              <pc:sldLayoutMk cId="4223698147" sldId="2147483693"/>
              <ac:spMk id="3" creationId="{00000000-0000-0000-0000-000000000000}"/>
            </ac:spMkLst>
          </pc:spChg>
          <pc:spChg chg="mod">
            <ac:chgData name="Jake Kendrick" userId="c9aa91da-2e15-46cf-a8c4-b4cee9b8e514" providerId="ADAL" clId="{4D39B9F2-2A26-5844-9159-FAC44B83CB06}" dt="2022-05-16T02:38:17.140" v="4"/>
            <ac:spMkLst>
              <pc:docMk/>
              <pc:sldMasterMk cId="2382013965" sldId="2147483684"/>
              <pc:sldLayoutMk cId="4223698147" sldId="2147483693"/>
              <ac:spMk id="4" creationId="{00000000-0000-0000-0000-000000000000}"/>
            </ac:spMkLst>
          </pc:spChg>
        </pc:sldLayoutChg>
        <pc:sldLayoutChg chg="modSp">
          <pc:chgData name="Jake Kendrick" userId="c9aa91da-2e15-46cf-a8c4-b4cee9b8e514" providerId="ADAL" clId="{4D39B9F2-2A26-5844-9159-FAC44B83CB06}" dt="2022-05-16T02:38:17.140" v="4"/>
          <pc:sldLayoutMkLst>
            <pc:docMk/>
            <pc:sldMasterMk cId="2382013965" sldId="2147483684"/>
            <pc:sldLayoutMk cId="2881034104" sldId="2147483695"/>
          </pc:sldLayoutMkLst>
          <pc:spChg chg="mod">
            <ac:chgData name="Jake Kendrick" userId="c9aa91da-2e15-46cf-a8c4-b4cee9b8e514" providerId="ADAL" clId="{4D39B9F2-2A26-5844-9159-FAC44B83CB06}" dt="2022-05-16T02:38:17.140" v="4"/>
            <ac:spMkLst>
              <pc:docMk/>
              <pc:sldMasterMk cId="2382013965" sldId="2147483684"/>
              <pc:sldLayoutMk cId="2881034104" sldId="2147483695"/>
              <ac:spMk id="2" creationId="{00000000-0000-0000-0000-000000000000}"/>
            </ac:spMkLst>
          </pc:spChg>
          <pc:spChg chg="mod">
            <ac:chgData name="Jake Kendrick" userId="c9aa91da-2e15-46cf-a8c4-b4cee9b8e514" providerId="ADAL" clId="{4D39B9F2-2A26-5844-9159-FAC44B83CB06}" dt="2022-05-16T02:38:17.140" v="4"/>
            <ac:spMkLst>
              <pc:docMk/>
              <pc:sldMasterMk cId="2382013965" sldId="2147483684"/>
              <pc:sldLayoutMk cId="2881034104" sldId="2147483695"/>
              <ac:spMk id="3" creationId="{00000000-0000-0000-0000-000000000000}"/>
            </ac:spMkLst>
          </pc:spChg>
        </pc:sldLayoutChg>
      </pc:sldMasterChg>
    </pc:docChg>
  </pc:docChgLst>
  <pc:docChgLst>
    <pc:chgData name="Jake Kendrick" userId="S::21308325@student.uwa.edu.au::ab142299-a4dd-4def-8b03-8ee3e1d9a7dd" providerId="AD" clId="Web-{6FB80908-9FB3-4439-9715-8624B613EDF0}"/>
    <pc:docChg chg="modSld">
      <pc:chgData name="Jake Kendrick" userId="S::21308325@student.uwa.edu.au::ab142299-a4dd-4def-8b03-8ee3e1d9a7dd" providerId="AD" clId="Web-{6FB80908-9FB3-4439-9715-8624B613EDF0}" dt="2023-06-12T05:51:17.384" v="327" actId="1076"/>
      <pc:docMkLst>
        <pc:docMk/>
      </pc:docMkLst>
      <pc:sldChg chg="addSp delSp modSp">
        <pc:chgData name="Jake Kendrick" userId="S::21308325@student.uwa.edu.au::ab142299-a4dd-4def-8b03-8ee3e1d9a7dd" providerId="AD" clId="Web-{6FB80908-9FB3-4439-9715-8624B613EDF0}" dt="2023-06-12T05:51:17.384" v="327" actId="1076"/>
        <pc:sldMkLst>
          <pc:docMk/>
          <pc:sldMk cId="109857222" sldId="256"/>
        </pc:sldMkLst>
        <pc:spChg chg="del">
          <ac:chgData name="Jake Kendrick" userId="S::21308325@student.uwa.edu.au::ab142299-a4dd-4def-8b03-8ee3e1d9a7dd" providerId="AD" clId="Web-{6FB80908-9FB3-4439-9715-8624B613EDF0}" dt="2023-06-12T05:50:55.477" v="323"/>
          <ac:spMkLst>
            <pc:docMk/>
            <pc:sldMk cId="109857222" sldId="256"/>
            <ac:spMk id="2" creationId="{8C6A3FBF-8002-0C94-BA16-0667E70894DB}"/>
          </ac:spMkLst>
        </pc:spChg>
        <pc:spChg chg="del">
          <ac:chgData name="Jake Kendrick" userId="S::21308325@student.uwa.edu.au::ab142299-a4dd-4def-8b03-8ee3e1d9a7dd" providerId="AD" clId="Web-{6FB80908-9FB3-4439-9715-8624B613EDF0}" dt="2023-06-12T05:37:01.302" v="3"/>
          <ac:spMkLst>
            <pc:docMk/>
            <pc:sldMk cId="109857222" sldId="256"/>
            <ac:spMk id="4" creationId="{27A96775-B130-55FA-4134-988D64090C2E}"/>
          </ac:spMkLst>
        </pc:spChg>
        <pc:spChg chg="del mod">
          <ac:chgData name="Jake Kendrick" userId="S::21308325@student.uwa.edu.au::ab142299-a4dd-4def-8b03-8ee3e1d9a7dd" providerId="AD" clId="Web-{6FB80908-9FB3-4439-9715-8624B613EDF0}" dt="2023-06-12T05:50:51.852" v="322"/>
          <ac:spMkLst>
            <pc:docMk/>
            <pc:sldMk cId="109857222" sldId="256"/>
            <ac:spMk id="6" creationId="{7859DAD8-D439-0B7B-7D68-499D6709EE7B}"/>
          </ac:spMkLst>
        </pc:spChg>
        <pc:spChg chg="del">
          <ac:chgData name="Jake Kendrick" userId="S::21308325@student.uwa.edu.au::ab142299-a4dd-4def-8b03-8ee3e1d9a7dd" providerId="AD" clId="Web-{6FB80908-9FB3-4439-9715-8624B613EDF0}" dt="2023-06-12T05:50:49.274" v="321"/>
          <ac:spMkLst>
            <pc:docMk/>
            <pc:sldMk cId="109857222" sldId="256"/>
            <ac:spMk id="8" creationId="{E73775FE-E078-56E9-9AC2-BD17EDC99EA9}"/>
          </ac:spMkLst>
        </pc:spChg>
        <pc:spChg chg="add mod">
          <ac:chgData name="Jake Kendrick" userId="S::21308325@student.uwa.edu.au::ab142299-a4dd-4def-8b03-8ee3e1d9a7dd" providerId="AD" clId="Web-{6FB80908-9FB3-4439-9715-8624B613EDF0}" dt="2023-06-12T05:51:17.384" v="327" actId="1076"/>
          <ac:spMkLst>
            <pc:docMk/>
            <pc:sldMk cId="109857222" sldId="256"/>
            <ac:spMk id="11" creationId="{BE6C1E72-9673-0254-0240-0D5606E34EAF}"/>
          </ac:spMkLst>
        </pc:spChg>
        <pc:graphicFrameChg chg="add mod modGraphic">
          <ac:chgData name="Jake Kendrick" userId="S::21308325@student.uwa.edu.au::ab142299-a4dd-4def-8b03-8ee3e1d9a7dd" providerId="AD" clId="Web-{6FB80908-9FB3-4439-9715-8624B613EDF0}" dt="2023-06-12T05:51:04.384" v="324" actId="1076"/>
          <ac:graphicFrameMkLst>
            <pc:docMk/>
            <pc:sldMk cId="109857222" sldId="256"/>
            <ac:graphicFrameMk id="9" creationId="{BFBF22AD-8840-DCC0-C66D-C6455C72D88A}"/>
          </ac:graphicFrameMkLst>
        </pc:graphicFrameChg>
      </pc:sldChg>
    </pc:docChg>
  </pc:docChgLst>
  <pc:docChgLst>
    <pc:chgData name="Jake Kendrick" userId="S::21308325@student.uwa.edu.au::ab142299-a4dd-4def-8b03-8ee3e1d9a7dd" providerId="AD" clId="Web-{129B7036-A487-4283-AEBC-0E151928EE2F}"/>
    <pc:docChg chg="modSld">
      <pc:chgData name="Jake Kendrick" userId="S::21308325@student.uwa.edu.au::ab142299-a4dd-4def-8b03-8ee3e1d9a7dd" providerId="AD" clId="Web-{129B7036-A487-4283-AEBC-0E151928EE2F}" dt="2022-12-30T01:00:12.775" v="63" actId="1076"/>
      <pc:docMkLst>
        <pc:docMk/>
      </pc:docMkLst>
      <pc:sldChg chg="addSp delSp modSp">
        <pc:chgData name="Jake Kendrick" userId="S::21308325@student.uwa.edu.au::ab142299-a4dd-4def-8b03-8ee3e1d9a7dd" providerId="AD" clId="Web-{129B7036-A487-4283-AEBC-0E151928EE2F}" dt="2022-12-30T01:00:12.775" v="63" actId="1076"/>
        <pc:sldMkLst>
          <pc:docMk/>
          <pc:sldMk cId="109857222" sldId="256"/>
        </pc:sldMkLst>
        <pc:spChg chg="del mod">
          <ac:chgData name="Jake Kendrick" userId="S::21308325@student.uwa.edu.au::ab142299-a4dd-4def-8b03-8ee3e1d9a7dd" providerId="AD" clId="Web-{129B7036-A487-4283-AEBC-0E151928EE2F}" dt="2022-12-30T01:00:06.556" v="62"/>
          <ac:spMkLst>
            <pc:docMk/>
            <pc:sldMk cId="109857222" sldId="256"/>
            <ac:spMk id="4" creationId="{10C2DED3-698D-7ED0-B399-35C69A59F96F}"/>
          </ac:spMkLst>
        </pc:spChg>
        <pc:spChg chg="mod ord">
          <ac:chgData name="Jake Kendrick" userId="S::21308325@student.uwa.edu.au::ab142299-a4dd-4def-8b03-8ee3e1d9a7dd" providerId="AD" clId="Web-{129B7036-A487-4283-AEBC-0E151928EE2F}" dt="2022-12-30T00:43:40.603" v="46" actId="1076"/>
          <ac:spMkLst>
            <pc:docMk/>
            <pc:sldMk cId="109857222" sldId="256"/>
            <ac:spMk id="8" creationId="{49AF7FBA-0E18-CB4F-B3BE-BE18C90D7AC9}"/>
          </ac:spMkLst>
        </pc:spChg>
        <pc:spChg chg="mod">
          <ac:chgData name="Jake Kendrick" userId="S::21308325@student.uwa.edu.au::ab142299-a4dd-4def-8b03-8ee3e1d9a7dd" providerId="AD" clId="Web-{129B7036-A487-4283-AEBC-0E151928EE2F}" dt="2022-12-30T00:41:38.505" v="36" actId="1076"/>
          <ac:spMkLst>
            <pc:docMk/>
            <pc:sldMk cId="109857222" sldId="256"/>
            <ac:spMk id="12" creationId="{CBAAA63C-1BA9-DA4A-A878-9EC83D20AC07}"/>
          </ac:spMkLst>
        </pc:spChg>
        <pc:spChg chg="mod">
          <ac:chgData name="Jake Kendrick" userId="S::21308325@student.uwa.edu.au::ab142299-a4dd-4def-8b03-8ee3e1d9a7dd" providerId="AD" clId="Web-{129B7036-A487-4283-AEBC-0E151928EE2F}" dt="2022-12-30T01:00:12.775" v="63" actId="1076"/>
          <ac:spMkLst>
            <pc:docMk/>
            <pc:sldMk cId="109857222" sldId="256"/>
            <ac:spMk id="13" creationId="{A9A32FB2-2064-654E-9855-BDC1D5C342CA}"/>
          </ac:spMkLst>
        </pc:spChg>
        <pc:spChg chg="add mod">
          <ac:chgData name="Jake Kendrick" userId="S::21308325@student.uwa.edu.au::ab142299-a4dd-4def-8b03-8ee3e1d9a7dd" providerId="AD" clId="Web-{129B7036-A487-4283-AEBC-0E151928EE2F}" dt="2022-12-30T00:45:33.091" v="58" actId="1076"/>
          <ac:spMkLst>
            <pc:docMk/>
            <pc:sldMk cId="109857222" sldId="256"/>
            <ac:spMk id="16" creationId="{80964941-725D-582D-85CF-54E8FAAD5688}"/>
          </ac:spMkLst>
        </pc:spChg>
        <pc:picChg chg="del mod">
          <ac:chgData name="Jake Kendrick" userId="S::21308325@student.uwa.edu.au::ab142299-a4dd-4def-8b03-8ee3e1d9a7dd" providerId="AD" clId="Web-{129B7036-A487-4283-AEBC-0E151928EE2F}" dt="2022-12-30T00:46:50.781" v="61"/>
          <ac:picMkLst>
            <pc:docMk/>
            <pc:sldMk cId="109857222" sldId="256"/>
            <ac:picMk id="2" creationId="{A01C2D52-27EF-673E-93AD-928A3BE60015}"/>
          </ac:picMkLst>
        </pc:picChg>
        <pc:picChg chg="del mod">
          <ac:chgData name="Jake Kendrick" userId="S::21308325@student.uwa.edu.au::ab142299-a4dd-4def-8b03-8ee3e1d9a7dd" providerId="AD" clId="Web-{129B7036-A487-4283-AEBC-0E151928EE2F}" dt="2022-12-30T00:46:49.531" v="60"/>
          <ac:picMkLst>
            <pc:docMk/>
            <pc:sldMk cId="109857222" sldId="256"/>
            <ac:picMk id="3" creationId="{661A1E88-944A-AB5F-978C-33994634841E}"/>
          </ac:picMkLst>
        </pc:picChg>
        <pc:picChg chg="add del mod">
          <ac:chgData name="Jake Kendrick" userId="S::21308325@student.uwa.edu.au::ab142299-a4dd-4def-8b03-8ee3e1d9a7dd" providerId="AD" clId="Web-{129B7036-A487-4283-AEBC-0E151928EE2F}" dt="2022-12-30T00:34:57.875" v="7"/>
          <ac:picMkLst>
            <pc:docMk/>
            <pc:sldMk cId="109857222" sldId="256"/>
            <ac:picMk id="5" creationId="{A83FB03C-DDC2-EED4-37A9-6E3D6C87CB30}"/>
          </ac:picMkLst>
        </pc:picChg>
        <pc:picChg chg="del mod">
          <ac:chgData name="Jake Kendrick" userId="S::21308325@student.uwa.edu.au::ab142299-a4dd-4def-8b03-8ee3e1d9a7dd" providerId="AD" clId="Web-{129B7036-A487-4283-AEBC-0E151928EE2F}" dt="2022-12-30T00:46:48.156" v="59"/>
          <ac:picMkLst>
            <pc:docMk/>
            <pc:sldMk cId="109857222" sldId="256"/>
            <ac:picMk id="6" creationId="{C8430E77-9396-9DD5-0C58-64C6EC5B5743}"/>
          </ac:picMkLst>
        </pc:picChg>
        <pc:picChg chg="add mod">
          <ac:chgData name="Jake Kendrick" userId="S::21308325@student.uwa.edu.au::ab142299-a4dd-4def-8b03-8ee3e1d9a7dd" providerId="AD" clId="Web-{129B7036-A487-4283-AEBC-0E151928EE2F}" dt="2022-12-30T00:37:01.847" v="10" actId="1076"/>
          <ac:picMkLst>
            <pc:docMk/>
            <pc:sldMk cId="109857222" sldId="256"/>
            <ac:picMk id="7" creationId="{B88E6ABA-78B8-3F49-417A-A1784A1552E1}"/>
          </ac:picMkLst>
        </pc:picChg>
        <pc:picChg chg="add mod">
          <ac:chgData name="Jake Kendrick" userId="S::21308325@student.uwa.edu.au::ab142299-a4dd-4def-8b03-8ee3e1d9a7dd" providerId="AD" clId="Web-{129B7036-A487-4283-AEBC-0E151928EE2F}" dt="2022-12-30T00:45:19.450" v="57" actId="1076"/>
          <ac:picMkLst>
            <pc:docMk/>
            <pc:sldMk cId="109857222" sldId="256"/>
            <ac:picMk id="9" creationId="{B78580BA-CA6C-E0AA-1F4E-8B6EE9A4EC2E}"/>
          </ac:picMkLst>
        </pc:picChg>
        <pc:picChg chg="add mod modCrop">
          <ac:chgData name="Jake Kendrick" userId="S::21308325@student.uwa.edu.au::ab142299-a4dd-4def-8b03-8ee3e1d9a7dd" providerId="AD" clId="Web-{129B7036-A487-4283-AEBC-0E151928EE2F}" dt="2022-12-30T00:45:09.371" v="54" actId="1076"/>
          <ac:picMkLst>
            <pc:docMk/>
            <pc:sldMk cId="109857222" sldId="256"/>
            <ac:picMk id="11" creationId="{6BE05963-DA49-5BEA-3DD4-BA88C3DA3C8D}"/>
          </ac:picMkLst>
        </pc:picChg>
        <pc:picChg chg="add mod modCrop">
          <ac:chgData name="Jake Kendrick" userId="S::21308325@student.uwa.edu.au::ab142299-a4dd-4def-8b03-8ee3e1d9a7dd" providerId="AD" clId="Web-{129B7036-A487-4283-AEBC-0E151928EE2F}" dt="2022-12-30T00:44:42.277" v="51" actId="1076"/>
          <ac:picMkLst>
            <pc:docMk/>
            <pc:sldMk cId="109857222" sldId="256"/>
            <ac:picMk id="14" creationId="{C1B7684E-4813-5A71-C5D5-92C5E7636AEF}"/>
          </ac:picMkLst>
        </pc:picChg>
      </pc:sldChg>
    </pc:docChg>
  </pc:docChgLst>
  <pc:docChgLst>
    <pc:chgData clId="Web-{61854EE4-F1DC-4A8E-847D-7C62DE40BFDC}"/>
    <pc:docChg chg="modSld">
      <pc:chgData name="" userId="" providerId="" clId="Web-{61854EE4-F1DC-4A8E-847D-7C62DE40BFDC}" dt="2023-01-11T23:21:18.654" v="0" actId="1076"/>
      <pc:docMkLst>
        <pc:docMk/>
      </pc:docMkLst>
      <pc:sldChg chg="modSp">
        <pc:chgData name="" userId="" providerId="" clId="Web-{61854EE4-F1DC-4A8E-847D-7C62DE40BFDC}" dt="2023-01-11T23:21:18.654" v="0" actId="1076"/>
        <pc:sldMkLst>
          <pc:docMk/>
          <pc:sldMk cId="109857222" sldId="256"/>
        </pc:sldMkLst>
        <pc:picChg chg="mod">
          <ac:chgData name="" userId="" providerId="" clId="Web-{61854EE4-F1DC-4A8E-847D-7C62DE40BFDC}" dt="2023-01-11T23:21:18.654" v="0" actId="1076"/>
          <ac:picMkLst>
            <pc:docMk/>
            <pc:sldMk cId="109857222" sldId="256"/>
            <ac:picMk id="11" creationId="{0283F916-FE9D-384F-57ED-B414501219F8}"/>
          </ac:picMkLst>
        </pc:picChg>
      </pc:sldChg>
    </pc:docChg>
  </pc:docChgLst>
  <pc:docChgLst>
    <pc:chgData name="Jake Kendrick" userId="S::21308325@student.uwa.edu.au::ab142299-a4dd-4def-8b03-8ee3e1d9a7dd" providerId="AD" clId="Web-{43718674-F62E-4C30-BD48-0185FD155AD4}"/>
    <pc:docChg chg="modSld">
      <pc:chgData name="Jake Kendrick" userId="S::21308325@student.uwa.edu.au::ab142299-a4dd-4def-8b03-8ee3e1d9a7dd" providerId="AD" clId="Web-{43718674-F62E-4C30-BD48-0185FD155AD4}" dt="2023-01-12T01:57:05.868" v="1633" actId="20577"/>
      <pc:docMkLst>
        <pc:docMk/>
      </pc:docMkLst>
      <pc:sldChg chg="addSp delSp modSp">
        <pc:chgData name="Jake Kendrick" userId="S::21308325@student.uwa.edu.au::ab142299-a4dd-4def-8b03-8ee3e1d9a7dd" providerId="AD" clId="Web-{43718674-F62E-4C30-BD48-0185FD155AD4}" dt="2023-01-12T01:57:05.868" v="1633" actId="20577"/>
        <pc:sldMkLst>
          <pc:docMk/>
          <pc:sldMk cId="109857222" sldId="256"/>
        </pc:sldMkLst>
        <pc:spChg chg="mod">
          <ac:chgData name="Jake Kendrick" userId="S::21308325@student.uwa.edu.au::ab142299-a4dd-4def-8b03-8ee3e1d9a7dd" providerId="AD" clId="Web-{43718674-F62E-4C30-BD48-0185FD155AD4}" dt="2023-01-12T00:03:56.916" v="161" actId="1076"/>
          <ac:spMkLst>
            <pc:docMk/>
            <pc:sldMk cId="109857222" sldId="256"/>
            <ac:spMk id="2" creationId="{2EF2A381-DB62-ADB9-8061-FEE116D46C4B}"/>
          </ac:spMkLst>
        </pc:spChg>
        <pc:spChg chg="add mod">
          <ac:chgData name="Jake Kendrick" userId="S::21308325@student.uwa.edu.au::ab142299-a4dd-4def-8b03-8ee3e1d9a7dd" providerId="AD" clId="Web-{43718674-F62E-4C30-BD48-0185FD155AD4}" dt="2023-01-12T01:41:26.338" v="1132" actId="14100"/>
          <ac:spMkLst>
            <pc:docMk/>
            <pc:sldMk cId="109857222" sldId="256"/>
            <ac:spMk id="3" creationId="{ECC7EB11-F726-4C25-B968-5F3F1B5D581C}"/>
          </ac:spMkLst>
        </pc:spChg>
        <pc:spChg chg="del">
          <ac:chgData name="Jake Kendrick" userId="S::21308325@student.uwa.edu.au::ab142299-a4dd-4def-8b03-8ee3e1d9a7dd" providerId="AD" clId="Web-{43718674-F62E-4C30-BD48-0185FD155AD4}" dt="2023-01-11T23:32:30.892" v="16"/>
          <ac:spMkLst>
            <pc:docMk/>
            <pc:sldMk cId="109857222" sldId="256"/>
            <ac:spMk id="8" creationId="{49AF7FBA-0E18-CB4F-B3BE-BE18C90D7AC9}"/>
          </ac:spMkLst>
        </pc:spChg>
        <pc:spChg chg="del mod">
          <ac:chgData name="Jake Kendrick" userId="S::21308325@student.uwa.edu.au::ab142299-a4dd-4def-8b03-8ee3e1d9a7dd" providerId="AD" clId="Web-{43718674-F62E-4C30-BD48-0185FD155AD4}" dt="2023-01-12T00:17:12.152" v="224"/>
          <ac:spMkLst>
            <pc:docMk/>
            <pc:sldMk cId="109857222" sldId="256"/>
            <ac:spMk id="9" creationId="{F84F21F5-DB0A-CEEB-B8EA-E1623E38B685}"/>
          </ac:spMkLst>
        </pc:spChg>
        <pc:spChg chg="mod">
          <ac:chgData name="Jake Kendrick" userId="S::21308325@student.uwa.edu.au::ab142299-a4dd-4def-8b03-8ee3e1d9a7dd" providerId="AD" clId="Web-{43718674-F62E-4C30-BD48-0185FD155AD4}" dt="2023-01-12T01:57:05.868" v="1633" actId="20577"/>
          <ac:spMkLst>
            <pc:docMk/>
            <pc:sldMk cId="109857222" sldId="256"/>
            <ac:spMk id="13" creationId="{A9A32FB2-2064-654E-9855-BDC1D5C342CA}"/>
          </ac:spMkLst>
        </pc:spChg>
        <pc:spChg chg="del">
          <ac:chgData name="Jake Kendrick" userId="S::21308325@student.uwa.edu.au::ab142299-a4dd-4def-8b03-8ee3e1d9a7dd" providerId="AD" clId="Web-{43718674-F62E-4C30-BD48-0185FD155AD4}" dt="2023-01-11T23:32:32.345" v="17"/>
          <ac:spMkLst>
            <pc:docMk/>
            <pc:sldMk cId="109857222" sldId="256"/>
            <ac:spMk id="14" creationId="{4C7BB03D-0E3B-0F75-1FEB-27E8E5B49C86}"/>
          </ac:spMkLst>
        </pc:spChg>
        <pc:spChg chg="del">
          <ac:chgData name="Jake Kendrick" userId="S::21308325@student.uwa.edu.au::ab142299-a4dd-4def-8b03-8ee3e1d9a7dd" providerId="AD" clId="Web-{43718674-F62E-4C30-BD48-0185FD155AD4}" dt="2023-01-12T00:36:40.473" v="286"/>
          <ac:spMkLst>
            <pc:docMk/>
            <pc:sldMk cId="109857222" sldId="256"/>
            <ac:spMk id="16" creationId="{80964941-725D-582D-85CF-54E8FAAD5688}"/>
          </ac:spMkLst>
        </pc:spChg>
        <pc:spChg chg="del">
          <ac:chgData name="Jake Kendrick" userId="S::21308325@student.uwa.edu.au::ab142299-a4dd-4def-8b03-8ee3e1d9a7dd" providerId="AD" clId="Web-{43718674-F62E-4C30-BD48-0185FD155AD4}" dt="2023-01-12T00:36:59.927" v="289"/>
          <ac:spMkLst>
            <pc:docMk/>
            <pc:sldMk cId="109857222" sldId="256"/>
            <ac:spMk id="18" creationId="{4D65B9FF-6820-FDA8-0CD9-7668B2480389}"/>
          </ac:spMkLst>
        </pc:spChg>
        <pc:spChg chg="del mod">
          <ac:chgData name="Jake Kendrick" userId="S::21308325@student.uwa.edu.au::ab142299-a4dd-4def-8b03-8ee3e1d9a7dd" providerId="AD" clId="Web-{43718674-F62E-4C30-BD48-0185FD155AD4}" dt="2023-01-11T23:59:28.785" v="116"/>
          <ac:spMkLst>
            <pc:docMk/>
            <pc:sldMk cId="109857222" sldId="256"/>
            <ac:spMk id="19" creationId="{3812D9A9-07A0-88FE-16FA-489DD0F05B96}"/>
          </ac:spMkLst>
        </pc:spChg>
        <pc:spChg chg="del">
          <ac:chgData name="Jake Kendrick" userId="S::21308325@student.uwa.edu.au::ab142299-a4dd-4def-8b03-8ee3e1d9a7dd" providerId="AD" clId="Web-{43718674-F62E-4C30-BD48-0185FD155AD4}" dt="2023-01-11T23:57:36.189" v="110"/>
          <ac:spMkLst>
            <pc:docMk/>
            <pc:sldMk cId="109857222" sldId="256"/>
            <ac:spMk id="20" creationId="{A9BF038A-4132-71D8-636F-2AB899ABEE36}"/>
          </ac:spMkLst>
        </pc:spChg>
        <pc:spChg chg="del mod">
          <ac:chgData name="Jake Kendrick" userId="S::21308325@student.uwa.edu.au::ab142299-a4dd-4def-8b03-8ee3e1d9a7dd" providerId="AD" clId="Web-{43718674-F62E-4C30-BD48-0185FD155AD4}" dt="2023-01-11T23:59:04.832" v="113"/>
          <ac:spMkLst>
            <pc:docMk/>
            <pc:sldMk cId="109857222" sldId="256"/>
            <ac:spMk id="21" creationId="{C6CE92FD-6A3E-6E0F-574C-CD26CA5D3A57}"/>
          </ac:spMkLst>
        </pc:spChg>
        <pc:spChg chg="mod">
          <ac:chgData name="Jake Kendrick" userId="S::21308325@student.uwa.edu.au::ab142299-a4dd-4def-8b03-8ee3e1d9a7dd" providerId="AD" clId="Web-{43718674-F62E-4C30-BD48-0185FD155AD4}" dt="2023-01-12T00:38:39.117" v="302" actId="1076"/>
          <ac:spMkLst>
            <pc:docMk/>
            <pc:sldMk cId="109857222" sldId="256"/>
            <ac:spMk id="23" creationId="{95508AB1-968D-80D6-992F-FB9BCCC8E50C}"/>
          </ac:spMkLst>
        </pc:spChg>
        <pc:spChg chg="add mod">
          <ac:chgData name="Jake Kendrick" userId="S::21308325@student.uwa.edu.au::ab142299-a4dd-4def-8b03-8ee3e1d9a7dd" providerId="AD" clId="Web-{43718674-F62E-4C30-BD48-0185FD155AD4}" dt="2023-01-11T23:33:03.314" v="19"/>
          <ac:spMkLst>
            <pc:docMk/>
            <pc:sldMk cId="109857222" sldId="256"/>
            <ac:spMk id="24" creationId="{D03B52AC-0E6F-DF1C-D0F5-FA74898FA11D}"/>
          </ac:spMkLst>
        </pc:spChg>
        <pc:spChg chg="add mod">
          <ac:chgData name="Jake Kendrick" userId="S::21308325@student.uwa.edu.au::ab142299-a4dd-4def-8b03-8ee3e1d9a7dd" providerId="AD" clId="Web-{43718674-F62E-4C30-BD48-0185FD155AD4}" dt="2023-01-11T23:33:41.940" v="28"/>
          <ac:spMkLst>
            <pc:docMk/>
            <pc:sldMk cId="109857222" sldId="256"/>
            <ac:spMk id="25" creationId="{046B7A09-1A51-7855-228B-8E006AA12518}"/>
          </ac:spMkLst>
        </pc:spChg>
        <pc:spChg chg="add mod">
          <ac:chgData name="Jake Kendrick" userId="S::21308325@student.uwa.edu.au::ab142299-a4dd-4def-8b03-8ee3e1d9a7dd" providerId="AD" clId="Web-{43718674-F62E-4C30-BD48-0185FD155AD4}" dt="2023-01-11T23:45:56.753" v="42" actId="1076"/>
          <ac:spMkLst>
            <pc:docMk/>
            <pc:sldMk cId="109857222" sldId="256"/>
            <ac:spMk id="28" creationId="{3AC7618D-CAC4-1099-5DDE-36854DE868CD}"/>
          </ac:spMkLst>
        </pc:spChg>
        <pc:spChg chg="add del">
          <ac:chgData name="Jake Kendrick" userId="S::21308325@student.uwa.edu.au::ab142299-a4dd-4def-8b03-8ee3e1d9a7dd" providerId="AD" clId="Web-{43718674-F62E-4C30-BD48-0185FD155AD4}" dt="2023-01-11T23:46:01.753" v="44"/>
          <ac:spMkLst>
            <pc:docMk/>
            <pc:sldMk cId="109857222" sldId="256"/>
            <ac:spMk id="29" creationId="{30A9D7FD-552A-D002-9ECA-2D3F077F82B5}"/>
          </ac:spMkLst>
        </pc:spChg>
        <pc:spChg chg="add del">
          <ac:chgData name="Jake Kendrick" userId="S::21308325@student.uwa.edu.au::ab142299-a4dd-4def-8b03-8ee3e1d9a7dd" providerId="AD" clId="Web-{43718674-F62E-4C30-BD48-0185FD155AD4}" dt="2023-01-11T23:46:08.612" v="46"/>
          <ac:spMkLst>
            <pc:docMk/>
            <pc:sldMk cId="109857222" sldId="256"/>
            <ac:spMk id="30" creationId="{83F48EE8-ED65-A786-AAA1-ED6F037A24CA}"/>
          </ac:spMkLst>
        </pc:spChg>
        <pc:spChg chg="add del">
          <ac:chgData name="Jake Kendrick" userId="S::21308325@student.uwa.edu.au::ab142299-a4dd-4def-8b03-8ee3e1d9a7dd" providerId="AD" clId="Web-{43718674-F62E-4C30-BD48-0185FD155AD4}" dt="2023-01-11T23:46:21.769" v="48"/>
          <ac:spMkLst>
            <pc:docMk/>
            <pc:sldMk cId="109857222" sldId="256"/>
            <ac:spMk id="31" creationId="{D8EB70A2-F599-7BE8-404D-5F1E9AD474C0}"/>
          </ac:spMkLst>
        </pc:spChg>
        <pc:spChg chg="add mod">
          <ac:chgData name="Jake Kendrick" userId="S::21308325@student.uwa.edu.au::ab142299-a4dd-4def-8b03-8ee3e1d9a7dd" providerId="AD" clId="Web-{43718674-F62E-4C30-BD48-0185FD155AD4}" dt="2023-01-11T23:46:44.644" v="50" actId="1076"/>
          <ac:spMkLst>
            <pc:docMk/>
            <pc:sldMk cId="109857222" sldId="256"/>
            <ac:spMk id="32" creationId="{6EB4D891-2210-2913-0945-E42ACE242EA1}"/>
          </ac:spMkLst>
        </pc:spChg>
        <pc:spChg chg="add del">
          <ac:chgData name="Jake Kendrick" userId="S::21308325@student.uwa.edu.au::ab142299-a4dd-4def-8b03-8ee3e1d9a7dd" providerId="AD" clId="Web-{43718674-F62E-4C30-BD48-0185FD155AD4}" dt="2023-01-11T23:54:22.232" v="69"/>
          <ac:spMkLst>
            <pc:docMk/>
            <pc:sldMk cId="109857222" sldId="256"/>
            <ac:spMk id="35" creationId="{3D7ACC04-1CCA-79D6-AB53-030390511448}"/>
          </ac:spMkLst>
        </pc:spChg>
        <pc:spChg chg="add mod">
          <ac:chgData name="Jake Kendrick" userId="S::21308325@student.uwa.edu.au::ab142299-a4dd-4def-8b03-8ee3e1d9a7dd" providerId="AD" clId="Web-{43718674-F62E-4C30-BD48-0185FD155AD4}" dt="2023-01-12T00:37:29.724" v="292" actId="14100"/>
          <ac:spMkLst>
            <pc:docMk/>
            <pc:sldMk cId="109857222" sldId="256"/>
            <ac:spMk id="36" creationId="{9038A5FC-BAEB-6F6F-E152-D90D91AFE4C4}"/>
          </ac:spMkLst>
        </pc:spChg>
        <pc:spChg chg="add mod">
          <ac:chgData name="Jake Kendrick" userId="S::21308325@student.uwa.edu.au::ab142299-a4dd-4def-8b03-8ee3e1d9a7dd" providerId="AD" clId="Web-{43718674-F62E-4C30-BD48-0185FD155AD4}" dt="2023-01-12T00:37:23.459" v="291" actId="1076"/>
          <ac:spMkLst>
            <pc:docMk/>
            <pc:sldMk cId="109857222" sldId="256"/>
            <ac:spMk id="37" creationId="{31574BA6-DC1B-27E8-6D53-C5259F6FCE78}"/>
          </ac:spMkLst>
        </pc:spChg>
        <pc:spChg chg="add del mod">
          <ac:chgData name="Jake Kendrick" userId="S::21308325@student.uwa.edu.au::ab142299-a4dd-4def-8b03-8ee3e1d9a7dd" providerId="AD" clId="Web-{43718674-F62E-4C30-BD48-0185FD155AD4}" dt="2023-01-12T00:38:17.335" v="298"/>
          <ac:spMkLst>
            <pc:docMk/>
            <pc:sldMk cId="109857222" sldId="256"/>
            <ac:spMk id="38" creationId="{96801251-5BA3-2994-165F-EC866A7E4563}"/>
          </ac:spMkLst>
        </pc:spChg>
        <pc:spChg chg="add mod">
          <ac:chgData name="Jake Kendrick" userId="S::21308325@student.uwa.edu.au::ab142299-a4dd-4def-8b03-8ee3e1d9a7dd" providerId="AD" clId="Web-{43718674-F62E-4C30-BD48-0185FD155AD4}" dt="2023-01-12T00:11:56.426" v="185" actId="14100"/>
          <ac:spMkLst>
            <pc:docMk/>
            <pc:sldMk cId="109857222" sldId="256"/>
            <ac:spMk id="39" creationId="{55A072C5-91CD-B984-C138-99285623E89B}"/>
          </ac:spMkLst>
        </pc:spChg>
        <pc:spChg chg="add mod">
          <ac:chgData name="Jake Kendrick" userId="S::21308325@student.uwa.edu.au::ab142299-a4dd-4def-8b03-8ee3e1d9a7dd" providerId="AD" clId="Web-{43718674-F62E-4C30-BD48-0185FD155AD4}" dt="2023-01-12T00:04:10.198" v="174" actId="1076"/>
          <ac:spMkLst>
            <pc:docMk/>
            <pc:sldMk cId="109857222" sldId="256"/>
            <ac:spMk id="40" creationId="{33444CC2-0B7A-4C62-68A0-445C4CA3BE0B}"/>
          </ac:spMkLst>
        </pc:spChg>
        <pc:spChg chg="add mod">
          <ac:chgData name="Jake Kendrick" userId="S::21308325@student.uwa.edu.au::ab142299-a4dd-4def-8b03-8ee3e1d9a7dd" providerId="AD" clId="Web-{43718674-F62E-4C30-BD48-0185FD155AD4}" dt="2023-01-12T00:14:57.665" v="223" actId="20577"/>
          <ac:spMkLst>
            <pc:docMk/>
            <pc:sldMk cId="109857222" sldId="256"/>
            <ac:spMk id="41" creationId="{0C5F94FA-5BDB-3A9B-D2F7-088A5358A9A4}"/>
          </ac:spMkLst>
        </pc:spChg>
        <pc:spChg chg="add mod">
          <ac:chgData name="Jake Kendrick" userId="S::21308325@student.uwa.edu.au::ab142299-a4dd-4def-8b03-8ee3e1d9a7dd" providerId="AD" clId="Web-{43718674-F62E-4C30-BD48-0185FD155AD4}" dt="2023-01-12T00:14:29.867" v="201" actId="1076"/>
          <ac:spMkLst>
            <pc:docMk/>
            <pc:sldMk cId="109857222" sldId="256"/>
            <ac:spMk id="42" creationId="{3B80A3C7-7EB6-0B4C-23BA-E8FB9CFA8FBB}"/>
          </ac:spMkLst>
        </pc:spChg>
        <pc:spChg chg="add mod">
          <ac:chgData name="Jake Kendrick" userId="S::21308325@student.uwa.edu.au::ab142299-a4dd-4def-8b03-8ee3e1d9a7dd" providerId="AD" clId="Web-{43718674-F62E-4C30-BD48-0185FD155AD4}" dt="2023-01-12T00:38:33.726" v="301" actId="1076"/>
          <ac:spMkLst>
            <pc:docMk/>
            <pc:sldMk cId="109857222" sldId="256"/>
            <ac:spMk id="48" creationId="{46C92995-C1F9-3A19-A0B2-3E947A6561DA}"/>
          </ac:spMkLst>
        </pc:spChg>
        <pc:picChg chg="del">
          <ac:chgData name="Jake Kendrick" userId="S::21308325@student.uwa.edu.au::ab142299-a4dd-4def-8b03-8ee3e1d9a7dd" providerId="AD" clId="Web-{43718674-F62E-4C30-BD48-0185FD155AD4}" dt="2023-01-12T00:36:41.177" v="287"/>
          <ac:picMkLst>
            <pc:docMk/>
            <pc:sldMk cId="109857222" sldId="256"/>
            <ac:picMk id="3" creationId="{DC3B467F-2961-5A82-95F3-327D33E11716}"/>
          </ac:picMkLst>
        </pc:picChg>
        <pc:picChg chg="del">
          <ac:chgData name="Jake Kendrick" userId="S::21308325@student.uwa.edu.au::ab142299-a4dd-4def-8b03-8ee3e1d9a7dd" providerId="AD" clId="Web-{43718674-F62E-4C30-BD48-0185FD155AD4}" dt="2023-01-12T00:36:37.817" v="285"/>
          <ac:picMkLst>
            <pc:docMk/>
            <pc:sldMk cId="109857222" sldId="256"/>
            <ac:picMk id="4" creationId="{A972ECAA-0A6A-0A57-6A95-F0FDAA2BD6B8}"/>
          </ac:picMkLst>
        </pc:picChg>
        <pc:picChg chg="add del mod">
          <ac:chgData name="Jake Kendrick" userId="S::21308325@student.uwa.edu.au::ab142299-a4dd-4def-8b03-8ee3e1d9a7dd" providerId="AD" clId="Web-{43718674-F62E-4C30-BD48-0185FD155AD4}" dt="2023-01-12T00:28:42.026" v="250"/>
          <ac:picMkLst>
            <pc:docMk/>
            <pc:sldMk cId="109857222" sldId="256"/>
            <ac:picMk id="6" creationId="{B4966B41-A841-E371-89F5-D9DB325AAB62}"/>
          </ac:picMkLst>
        </pc:picChg>
        <pc:picChg chg="add del mod">
          <ac:chgData name="Jake Kendrick" userId="S::21308325@student.uwa.edu.au::ab142299-a4dd-4def-8b03-8ee3e1d9a7dd" providerId="AD" clId="Web-{43718674-F62E-4C30-BD48-0185FD155AD4}" dt="2023-01-12T00:32:41.031" v="268"/>
          <ac:picMkLst>
            <pc:docMk/>
            <pc:sldMk cId="109857222" sldId="256"/>
            <ac:picMk id="11" creationId="{0283F916-FE9D-384F-57ED-B414501219F8}"/>
          </ac:picMkLst>
        </pc:picChg>
        <pc:picChg chg="del mod">
          <ac:chgData name="Jake Kendrick" userId="S::21308325@student.uwa.edu.au::ab142299-a4dd-4def-8b03-8ee3e1d9a7dd" providerId="AD" clId="Web-{43718674-F62E-4C30-BD48-0185FD155AD4}" dt="2023-01-12T00:30:06.418" v="261"/>
          <ac:picMkLst>
            <pc:docMk/>
            <pc:sldMk cId="109857222" sldId="256"/>
            <ac:picMk id="17" creationId="{B34E3F46-1685-3C3E-1C5C-6733834D3548}"/>
          </ac:picMkLst>
        </pc:picChg>
        <pc:picChg chg="add mod modCrop">
          <ac:chgData name="Jake Kendrick" userId="S::21308325@student.uwa.edu.au::ab142299-a4dd-4def-8b03-8ee3e1d9a7dd" providerId="AD" clId="Web-{43718674-F62E-4C30-BD48-0185FD155AD4}" dt="2023-01-11T23:29:34.404" v="13" actId="1076"/>
          <ac:picMkLst>
            <pc:docMk/>
            <pc:sldMk cId="109857222" sldId="256"/>
            <ac:picMk id="22" creationId="{9C3257FB-98C5-58ED-6EC1-6CBD33D00AA0}"/>
          </ac:picMkLst>
        </pc:picChg>
        <pc:picChg chg="add mod modCrop">
          <ac:chgData name="Jake Kendrick" userId="S::21308325@student.uwa.edu.au::ab142299-a4dd-4def-8b03-8ee3e1d9a7dd" providerId="AD" clId="Web-{43718674-F62E-4C30-BD48-0185FD155AD4}" dt="2023-01-11T23:45:48.471" v="40" actId="1076"/>
          <ac:picMkLst>
            <pc:docMk/>
            <pc:sldMk cId="109857222" sldId="256"/>
            <ac:picMk id="27" creationId="{9D03736E-DD8F-95BD-25BB-D4085B3A0A0E}"/>
          </ac:picMkLst>
        </pc:picChg>
        <pc:picChg chg="add mod">
          <ac:chgData name="Jake Kendrick" userId="S::21308325@student.uwa.edu.au::ab142299-a4dd-4def-8b03-8ee3e1d9a7dd" providerId="AD" clId="Web-{43718674-F62E-4C30-BD48-0185FD155AD4}" dt="2023-01-12T00:03:56.994" v="167" actId="1076"/>
          <ac:picMkLst>
            <pc:docMk/>
            <pc:sldMk cId="109857222" sldId="256"/>
            <ac:picMk id="33" creationId="{C5C09760-FA55-B5E0-5665-829C0A0E4041}"/>
          </ac:picMkLst>
        </pc:picChg>
        <pc:picChg chg="add del mod">
          <ac:chgData name="Jake Kendrick" userId="S::21308325@student.uwa.edu.au::ab142299-a4dd-4def-8b03-8ee3e1d9a7dd" providerId="AD" clId="Web-{43718674-F62E-4C30-BD48-0185FD155AD4}" dt="2023-01-12T00:03:57.010" v="168" actId="1076"/>
          <ac:picMkLst>
            <pc:docMk/>
            <pc:sldMk cId="109857222" sldId="256"/>
            <ac:picMk id="34" creationId="{27F33C34-E134-436F-980B-BE88724A9A53}"/>
          </ac:picMkLst>
        </pc:picChg>
        <pc:picChg chg="add del mod modCrop">
          <ac:chgData name="Jake Kendrick" userId="S::21308325@student.uwa.edu.au::ab142299-a4dd-4def-8b03-8ee3e1d9a7dd" providerId="AD" clId="Web-{43718674-F62E-4C30-BD48-0185FD155AD4}" dt="2023-01-12T00:33:37.298" v="277"/>
          <ac:picMkLst>
            <pc:docMk/>
            <pc:sldMk cId="109857222" sldId="256"/>
            <ac:picMk id="43" creationId="{DFA428E2-977F-95B0-5E04-ED94490EF235}"/>
          </ac:picMkLst>
        </pc:picChg>
        <pc:picChg chg="add mod modCrop">
          <ac:chgData name="Jake Kendrick" userId="S::21308325@student.uwa.edu.au::ab142299-a4dd-4def-8b03-8ee3e1d9a7dd" providerId="AD" clId="Web-{43718674-F62E-4C30-BD48-0185FD155AD4}" dt="2023-01-12T00:29:18.120" v="260"/>
          <ac:picMkLst>
            <pc:docMk/>
            <pc:sldMk cId="109857222" sldId="256"/>
            <ac:picMk id="44" creationId="{E6FDD401-8D4D-70E2-E966-5C4A21D73D7C}"/>
          </ac:picMkLst>
        </pc:picChg>
        <pc:picChg chg="add mod modCrop">
          <ac:chgData name="Jake Kendrick" userId="S::21308325@student.uwa.edu.au::ab142299-a4dd-4def-8b03-8ee3e1d9a7dd" providerId="AD" clId="Web-{43718674-F62E-4C30-BD48-0185FD155AD4}" dt="2023-01-12T00:30:41.575" v="267"/>
          <ac:picMkLst>
            <pc:docMk/>
            <pc:sldMk cId="109857222" sldId="256"/>
            <ac:picMk id="45" creationId="{20B50D02-9F4E-BBFD-0898-6B0E82922521}"/>
          </ac:picMkLst>
        </pc:picChg>
        <pc:picChg chg="add mod modCrop">
          <ac:chgData name="Jake Kendrick" userId="S::21308325@student.uwa.edu.au::ab142299-a4dd-4def-8b03-8ee3e1d9a7dd" providerId="AD" clId="Web-{43718674-F62E-4C30-BD48-0185FD155AD4}" dt="2023-01-12T00:33:22.438" v="276"/>
          <ac:picMkLst>
            <pc:docMk/>
            <pc:sldMk cId="109857222" sldId="256"/>
            <ac:picMk id="46" creationId="{A2C6F53B-A4B4-D819-4FB7-69E36E8FA5DC}"/>
          </ac:picMkLst>
        </pc:picChg>
        <pc:picChg chg="add mod modCrop">
          <ac:chgData name="Jake Kendrick" userId="S::21308325@student.uwa.edu.au::ab142299-a4dd-4def-8b03-8ee3e1d9a7dd" providerId="AD" clId="Web-{43718674-F62E-4C30-BD48-0185FD155AD4}" dt="2023-01-12T00:34:07.892" v="283"/>
          <ac:picMkLst>
            <pc:docMk/>
            <pc:sldMk cId="109857222" sldId="256"/>
            <ac:picMk id="47" creationId="{BB0866FE-E4BC-414C-5235-C69F629B2D52}"/>
          </ac:picMkLst>
        </pc:picChg>
      </pc:sldChg>
    </pc:docChg>
  </pc:docChgLst>
  <pc:docChgLst>
    <pc:chgData name="Jake Kendrick" userId="S::21308325@student.uwa.edu.au::ab142299-a4dd-4def-8b03-8ee3e1d9a7dd" providerId="AD" clId="Web-{6BDB5DC7-B327-4349-9663-89FC86BB7159}"/>
    <pc:docChg chg="modSld">
      <pc:chgData name="Jake Kendrick" userId="S::21308325@student.uwa.edu.au::ab142299-a4dd-4def-8b03-8ee3e1d9a7dd" providerId="AD" clId="Web-{6BDB5DC7-B327-4349-9663-89FC86BB7159}" dt="2023-06-12T10:48:06.503" v="15" actId="20577"/>
      <pc:docMkLst>
        <pc:docMk/>
      </pc:docMkLst>
      <pc:sldChg chg="modSp">
        <pc:chgData name="Jake Kendrick" userId="S::21308325@student.uwa.edu.au::ab142299-a4dd-4def-8b03-8ee3e1d9a7dd" providerId="AD" clId="Web-{6BDB5DC7-B327-4349-9663-89FC86BB7159}" dt="2023-06-12T10:48:06.503" v="15" actId="20577"/>
        <pc:sldMkLst>
          <pc:docMk/>
          <pc:sldMk cId="109857222" sldId="256"/>
        </pc:sldMkLst>
        <pc:spChg chg="mod">
          <ac:chgData name="Jake Kendrick" userId="S::21308325@student.uwa.edu.au::ab142299-a4dd-4def-8b03-8ee3e1d9a7dd" providerId="AD" clId="Web-{6BDB5DC7-B327-4349-9663-89FC86BB7159}" dt="2023-06-12T10:48:06.503" v="15" actId="20577"/>
          <ac:spMkLst>
            <pc:docMk/>
            <pc:sldMk cId="109857222" sldId="256"/>
            <ac:spMk id="37" creationId="{31574BA6-DC1B-27E8-6D53-C5259F6FCE78}"/>
          </ac:spMkLst>
        </pc:spChg>
      </pc:sldChg>
    </pc:docChg>
  </pc:docChgLst>
  <pc:docChgLst>
    <pc:chgData name="Jake Kendrick" userId="S::21308325@student.uwa.edu.au::ab142299-a4dd-4def-8b03-8ee3e1d9a7dd" providerId="AD" clId="Web-{36C96D04-5FB1-4FF9-97B8-AD8AE1B97913}"/>
    <pc:docChg chg="modSld">
      <pc:chgData name="Jake Kendrick" userId="S::21308325@student.uwa.edu.au::ab142299-a4dd-4def-8b03-8ee3e1d9a7dd" providerId="AD" clId="Web-{36C96D04-5FB1-4FF9-97B8-AD8AE1B97913}" dt="2023-03-03T07:15:55.209" v="21"/>
      <pc:docMkLst>
        <pc:docMk/>
      </pc:docMkLst>
      <pc:sldChg chg="addSp delSp modSp">
        <pc:chgData name="Jake Kendrick" userId="S::21308325@student.uwa.edu.au::ab142299-a4dd-4def-8b03-8ee3e1d9a7dd" providerId="AD" clId="Web-{36C96D04-5FB1-4FF9-97B8-AD8AE1B97913}" dt="2023-03-03T07:15:55.209" v="21"/>
        <pc:sldMkLst>
          <pc:docMk/>
          <pc:sldMk cId="109857222" sldId="256"/>
        </pc:sldMkLst>
        <pc:picChg chg="add mod">
          <ac:chgData name="Jake Kendrick" userId="S::21308325@student.uwa.edu.au::ab142299-a4dd-4def-8b03-8ee3e1d9a7dd" providerId="AD" clId="Web-{36C96D04-5FB1-4FF9-97B8-AD8AE1B97913}" dt="2023-03-03T07:15:02.442" v="19" actId="1076"/>
          <ac:picMkLst>
            <pc:docMk/>
            <pc:sldMk cId="109857222" sldId="256"/>
            <ac:picMk id="4" creationId="{C4C21272-6BB4-922D-4E8A-DB9BDA6BFADE}"/>
          </ac:picMkLst>
        </pc:picChg>
        <pc:picChg chg="add mod">
          <ac:chgData name="Jake Kendrick" userId="S::21308325@student.uwa.edu.au::ab142299-a4dd-4def-8b03-8ee3e1d9a7dd" providerId="AD" clId="Web-{36C96D04-5FB1-4FF9-97B8-AD8AE1B97913}" dt="2023-03-03T07:14:53.879" v="18" actId="1076"/>
          <ac:picMkLst>
            <pc:docMk/>
            <pc:sldMk cId="109857222" sldId="256"/>
            <ac:picMk id="6" creationId="{8FDDA5BF-F1A6-FCB8-188B-1ACE13C5EFDF}"/>
          </ac:picMkLst>
        </pc:picChg>
        <pc:picChg chg="del mod">
          <ac:chgData name="Jake Kendrick" userId="S::21308325@student.uwa.edu.au::ab142299-a4dd-4def-8b03-8ee3e1d9a7dd" providerId="AD" clId="Web-{36C96D04-5FB1-4FF9-97B8-AD8AE1B97913}" dt="2023-03-03T07:15:55.209" v="21"/>
          <ac:picMkLst>
            <pc:docMk/>
            <pc:sldMk cId="109857222" sldId="256"/>
            <ac:picMk id="44" creationId="{E6FDD401-8D4D-70E2-E966-5C4A21D73D7C}"/>
          </ac:picMkLst>
        </pc:picChg>
        <pc:picChg chg="del mod">
          <ac:chgData name="Jake Kendrick" userId="S::21308325@student.uwa.edu.au::ab142299-a4dd-4def-8b03-8ee3e1d9a7dd" providerId="AD" clId="Web-{36C96D04-5FB1-4FF9-97B8-AD8AE1B97913}" dt="2023-03-03T07:15:54.459" v="20"/>
          <ac:picMkLst>
            <pc:docMk/>
            <pc:sldMk cId="109857222" sldId="256"/>
            <ac:picMk id="45" creationId="{20B50D02-9F4E-BBFD-0898-6B0E82922521}"/>
          </ac:picMkLst>
        </pc:picChg>
      </pc:sldChg>
    </pc:docChg>
  </pc:docChgLst>
  <pc:docChgLst>
    <pc:chgData name="Jake Kendrick" userId="S::21308325@student.uwa.edu.au::ab142299-a4dd-4def-8b03-8ee3e1d9a7dd" providerId="AD" clId="Web-{9150DE4D-96F0-483B-B20B-3A388AFBCF9F}"/>
    <pc:docChg chg="modSld">
      <pc:chgData name="Jake Kendrick" userId="S::21308325@student.uwa.edu.au::ab142299-a4dd-4def-8b03-8ee3e1d9a7dd" providerId="AD" clId="Web-{9150DE4D-96F0-483B-B20B-3A388AFBCF9F}" dt="2023-01-11T22:49:33.214" v="189" actId="1076"/>
      <pc:docMkLst>
        <pc:docMk/>
      </pc:docMkLst>
      <pc:sldChg chg="addSp delSp modSp">
        <pc:chgData name="Jake Kendrick" userId="S::21308325@student.uwa.edu.au::ab142299-a4dd-4def-8b03-8ee3e1d9a7dd" providerId="AD" clId="Web-{9150DE4D-96F0-483B-B20B-3A388AFBCF9F}" dt="2023-01-11T22:49:33.214" v="189" actId="1076"/>
        <pc:sldMkLst>
          <pc:docMk/>
          <pc:sldMk cId="109857222" sldId="256"/>
        </pc:sldMkLst>
        <pc:spChg chg="add mod">
          <ac:chgData name="Jake Kendrick" userId="S::21308325@student.uwa.edu.au::ab142299-a4dd-4def-8b03-8ee3e1d9a7dd" providerId="AD" clId="Web-{9150DE4D-96F0-483B-B20B-3A388AFBCF9F}" dt="2023-01-11T22:40:50.603" v="182" actId="1076"/>
          <ac:spMkLst>
            <pc:docMk/>
            <pc:sldMk cId="109857222" sldId="256"/>
            <ac:spMk id="5" creationId="{0578B295-60DA-1ACA-FA20-EABE43ECBD76}"/>
          </ac:spMkLst>
        </pc:spChg>
        <pc:spChg chg="mod ord">
          <ac:chgData name="Jake Kendrick" userId="S::21308325@student.uwa.edu.au::ab142299-a4dd-4def-8b03-8ee3e1d9a7dd" providerId="AD" clId="Web-{9150DE4D-96F0-483B-B20B-3A388AFBCF9F}" dt="2023-01-11T22:49:33.214" v="189" actId="1076"/>
          <ac:spMkLst>
            <pc:docMk/>
            <pc:sldMk cId="109857222" sldId="256"/>
            <ac:spMk id="8" creationId="{49AF7FBA-0E18-CB4F-B3BE-BE18C90D7AC9}"/>
          </ac:spMkLst>
        </pc:spChg>
        <pc:spChg chg="mod">
          <ac:chgData name="Jake Kendrick" userId="S::21308325@student.uwa.edu.au::ab142299-a4dd-4def-8b03-8ee3e1d9a7dd" providerId="AD" clId="Web-{9150DE4D-96F0-483B-B20B-3A388AFBCF9F}" dt="2023-01-11T08:38:52.719" v="117" actId="1076"/>
          <ac:spMkLst>
            <pc:docMk/>
            <pc:sldMk cId="109857222" sldId="256"/>
            <ac:spMk id="10" creationId="{77A02ED0-8423-0C42-930A-6F5D1DA6A053}"/>
          </ac:spMkLst>
        </pc:spChg>
        <pc:spChg chg="mod">
          <ac:chgData name="Jake Kendrick" userId="S::21308325@student.uwa.edu.au::ab142299-a4dd-4def-8b03-8ee3e1d9a7dd" providerId="AD" clId="Web-{9150DE4D-96F0-483B-B20B-3A388AFBCF9F}" dt="2023-01-11T08:36:22.569" v="91" actId="1076"/>
          <ac:spMkLst>
            <pc:docMk/>
            <pc:sldMk cId="109857222" sldId="256"/>
            <ac:spMk id="12" creationId="{CBAAA63C-1BA9-DA4A-A878-9EC83D20AC07}"/>
          </ac:spMkLst>
        </pc:spChg>
        <pc:spChg chg="mod">
          <ac:chgData name="Jake Kendrick" userId="S::21308325@student.uwa.edu.au::ab142299-a4dd-4def-8b03-8ee3e1d9a7dd" providerId="AD" clId="Web-{9150DE4D-96F0-483B-B20B-3A388AFBCF9F}" dt="2023-01-11T08:38:32.515" v="115" actId="1076"/>
          <ac:spMkLst>
            <pc:docMk/>
            <pc:sldMk cId="109857222" sldId="256"/>
            <ac:spMk id="13" creationId="{A9A32FB2-2064-654E-9855-BDC1D5C342CA}"/>
          </ac:spMkLst>
        </pc:spChg>
        <pc:spChg chg="mod ord">
          <ac:chgData name="Jake Kendrick" userId="S::21308325@student.uwa.edu.au::ab142299-a4dd-4def-8b03-8ee3e1d9a7dd" providerId="AD" clId="Web-{9150DE4D-96F0-483B-B20B-3A388AFBCF9F}" dt="2023-01-11T22:37:07.237" v="151" actId="1076"/>
          <ac:spMkLst>
            <pc:docMk/>
            <pc:sldMk cId="109857222" sldId="256"/>
            <ac:spMk id="16" creationId="{80964941-725D-582D-85CF-54E8FAAD5688}"/>
          </ac:spMkLst>
        </pc:spChg>
        <pc:spChg chg="add mod">
          <ac:chgData name="Jake Kendrick" userId="S::21308325@student.uwa.edu.au::ab142299-a4dd-4def-8b03-8ee3e1d9a7dd" providerId="AD" clId="Web-{9150DE4D-96F0-483B-B20B-3A388AFBCF9F}" dt="2023-01-11T08:36:22.615" v="95" actId="1076"/>
          <ac:spMkLst>
            <pc:docMk/>
            <pc:sldMk cId="109857222" sldId="256"/>
            <ac:spMk id="18" creationId="{4D65B9FF-6820-FDA8-0CD9-7668B2480389}"/>
          </ac:spMkLst>
        </pc:spChg>
        <pc:spChg chg="add mod">
          <ac:chgData name="Jake Kendrick" userId="S::21308325@student.uwa.edu.au::ab142299-a4dd-4def-8b03-8ee3e1d9a7dd" providerId="AD" clId="Web-{9150DE4D-96F0-483B-B20B-3A388AFBCF9F}" dt="2023-01-11T22:38:11.864" v="158" actId="14100"/>
          <ac:spMkLst>
            <pc:docMk/>
            <pc:sldMk cId="109857222" sldId="256"/>
            <ac:spMk id="19" creationId="{3812D9A9-07A0-88FE-16FA-489DD0F05B96}"/>
          </ac:spMkLst>
        </pc:spChg>
        <pc:spChg chg="add mod">
          <ac:chgData name="Jake Kendrick" userId="S::21308325@student.uwa.edu.au::ab142299-a4dd-4def-8b03-8ee3e1d9a7dd" providerId="AD" clId="Web-{9150DE4D-96F0-483B-B20B-3A388AFBCF9F}" dt="2023-01-11T08:37:00.258" v="106"/>
          <ac:spMkLst>
            <pc:docMk/>
            <pc:sldMk cId="109857222" sldId="256"/>
            <ac:spMk id="20" creationId="{A9BF038A-4132-71D8-636F-2AB899ABEE36}"/>
          </ac:spMkLst>
        </pc:spChg>
        <pc:spChg chg="add mod">
          <ac:chgData name="Jake Kendrick" userId="S::21308325@student.uwa.edu.au::ab142299-a4dd-4def-8b03-8ee3e1d9a7dd" providerId="AD" clId="Web-{9150DE4D-96F0-483B-B20B-3A388AFBCF9F}" dt="2023-01-11T22:39:40.664" v="175" actId="14100"/>
          <ac:spMkLst>
            <pc:docMk/>
            <pc:sldMk cId="109857222" sldId="256"/>
            <ac:spMk id="21" creationId="{C6CE92FD-6A3E-6E0F-574C-CD26CA5D3A57}"/>
          </ac:spMkLst>
        </pc:spChg>
        <pc:spChg chg="add del mod">
          <ac:chgData name="Jake Kendrick" userId="S::21308325@student.uwa.edu.au::ab142299-a4dd-4def-8b03-8ee3e1d9a7dd" providerId="AD" clId="Web-{9150DE4D-96F0-483B-B20B-3A388AFBCF9F}" dt="2023-01-11T08:37:08.540" v="109"/>
          <ac:spMkLst>
            <pc:docMk/>
            <pc:sldMk cId="109857222" sldId="256"/>
            <ac:spMk id="22" creationId="{FD69E045-DDBE-7F60-DECE-519EBA956B43}"/>
          </ac:spMkLst>
        </pc:spChg>
        <pc:spChg chg="add mod">
          <ac:chgData name="Jake Kendrick" userId="S::21308325@student.uwa.edu.au::ab142299-a4dd-4def-8b03-8ee3e1d9a7dd" providerId="AD" clId="Web-{9150DE4D-96F0-483B-B20B-3A388AFBCF9F}" dt="2023-01-11T22:39:09.757" v="168" actId="1076"/>
          <ac:spMkLst>
            <pc:docMk/>
            <pc:sldMk cId="109857222" sldId="256"/>
            <ac:spMk id="23" creationId="{95508AB1-968D-80D6-992F-FB9BCCC8E50C}"/>
          </ac:spMkLst>
        </pc:spChg>
        <pc:picChg chg="add mod">
          <ac:chgData name="Jake Kendrick" userId="S::21308325@student.uwa.edu.au::ab142299-a4dd-4def-8b03-8ee3e1d9a7dd" providerId="AD" clId="Web-{9150DE4D-96F0-483B-B20B-3A388AFBCF9F}" dt="2023-01-11T22:37:03.940" v="150" actId="1076"/>
          <ac:picMkLst>
            <pc:docMk/>
            <pc:sldMk cId="109857222" sldId="256"/>
            <ac:picMk id="3" creationId="{DC3B467F-2961-5A82-95F3-327D33E11716}"/>
          </ac:picMkLst>
        </pc:picChg>
        <pc:picChg chg="add del mod">
          <ac:chgData name="Jake Kendrick" userId="S::21308325@student.uwa.edu.au::ab142299-a4dd-4def-8b03-8ee3e1d9a7dd" providerId="AD" clId="Web-{9150DE4D-96F0-483B-B20B-3A388AFBCF9F}" dt="2023-01-11T08:25:48.855" v="26"/>
          <ac:picMkLst>
            <pc:docMk/>
            <pc:sldMk cId="109857222" sldId="256"/>
            <ac:picMk id="4" creationId="{3A606E86-D956-9A93-DA35-185E8BC85E1C}"/>
          </ac:picMkLst>
        </pc:picChg>
        <pc:picChg chg="add mod">
          <ac:chgData name="Jake Kendrick" userId="S::21308325@student.uwa.edu.au::ab142299-a4dd-4def-8b03-8ee3e1d9a7dd" providerId="AD" clId="Web-{9150DE4D-96F0-483B-B20B-3A388AFBCF9F}" dt="2023-01-11T22:48:57.759" v="185" actId="1076"/>
          <ac:picMkLst>
            <pc:docMk/>
            <pc:sldMk cId="109857222" sldId="256"/>
            <ac:picMk id="4" creationId="{A972ECAA-0A6A-0A57-6A95-F0FDAA2BD6B8}"/>
          </ac:picMkLst>
        </pc:picChg>
        <pc:picChg chg="add del mod">
          <ac:chgData name="Jake Kendrick" userId="S::21308325@student.uwa.edu.au::ab142299-a4dd-4def-8b03-8ee3e1d9a7dd" providerId="AD" clId="Web-{9150DE4D-96F0-483B-B20B-3A388AFBCF9F}" dt="2023-01-11T08:25:49.902" v="27"/>
          <ac:picMkLst>
            <pc:docMk/>
            <pc:sldMk cId="109857222" sldId="256"/>
            <ac:picMk id="5" creationId="{CD5E0E7D-A7A7-AB0C-1F06-50AA2BD856E5}"/>
          </ac:picMkLst>
        </pc:picChg>
        <pc:picChg chg="add mod ord modCrop">
          <ac:chgData name="Jake Kendrick" userId="S::21308325@student.uwa.edu.au::ab142299-a4dd-4def-8b03-8ee3e1d9a7dd" providerId="AD" clId="Web-{9150DE4D-96F0-483B-B20B-3A388AFBCF9F}" dt="2023-01-11T22:49:25.245" v="188" actId="14100"/>
          <ac:picMkLst>
            <pc:docMk/>
            <pc:sldMk cId="109857222" sldId="256"/>
            <ac:picMk id="6" creationId="{B4966B41-A841-E371-89F5-D9DB325AAB62}"/>
          </ac:picMkLst>
        </pc:picChg>
        <pc:picChg chg="del">
          <ac:chgData name="Jake Kendrick" userId="S::21308325@student.uwa.edu.au::ab142299-a4dd-4def-8b03-8ee3e1d9a7dd" providerId="AD" clId="Web-{9150DE4D-96F0-483B-B20B-3A388AFBCF9F}" dt="2023-01-11T08:16:58.597" v="0"/>
          <ac:picMkLst>
            <pc:docMk/>
            <pc:sldMk cId="109857222" sldId="256"/>
            <ac:picMk id="7" creationId="{B88E6ABA-78B8-3F49-417A-A1784A1552E1}"/>
          </ac:picMkLst>
        </pc:picChg>
        <pc:picChg chg="del">
          <ac:chgData name="Jake Kendrick" userId="S::21308325@student.uwa.edu.au::ab142299-a4dd-4def-8b03-8ee3e1d9a7dd" providerId="AD" clId="Web-{9150DE4D-96F0-483B-B20B-3A388AFBCF9F}" dt="2023-01-11T08:17:04.347" v="1"/>
          <ac:picMkLst>
            <pc:docMk/>
            <pc:sldMk cId="109857222" sldId="256"/>
            <ac:picMk id="9" creationId="{B78580BA-CA6C-E0AA-1F4E-8B6EE9A4EC2E}"/>
          </ac:picMkLst>
        </pc:picChg>
        <pc:picChg chg="del">
          <ac:chgData name="Jake Kendrick" userId="S::21308325@student.uwa.edu.au::ab142299-a4dd-4def-8b03-8ee3e1d9a7dd" providerId="AD" clId="Web-{9150DE4D-96F0-483B-B20B-3A388AFBCF9F}" dt="2023-01-11T08:17:58.007" v="9"/>
          <ac:picMkLst>
            <pc:docMk/>
            <pc:sldMk cId="109857222" sldId="256"/>
            <ac:picMk id="11" creationId="{6BE05963-DA49-5BEA-3DD4-BA88C3DA3C8D}"/>
          </ac:picMkLst>
        </pc:picChg>
        <pc:picChg chg="del">
          <ac:chgData name="Jake Kendrick" userId="S::21308325@student.uwa.edu.au::ab142299-a4dd-4def-8b03-8ee3e1d9a7dd" providerId="AD" clId="Web-{9150DE4D-96F0-483B-B20B-3A388AFBCF9F}" dt="2023-01-11T08:18:06.039" v="10"/>
          <ac:picMkLst>
            <pc:docMk/>
            <pc:sldMk cId="109857222" sldId="256"/>
            <ac:picMk id="14" creationId="{C1B7684E-4813-5A71-C5D5-92C5E7636AEF}"/>
          </ac:picMkLst>
        </pc:picChg>
        <pc:picChg chg="add mod modCrop">
          <ac:chgData name="Jake Kendrick" userId="S::21308325@student.uwa.edu.au::ab142299-a4dd-4def-8b03-8ee3e1d9a7dd" providerId="AD" clId="Web-{9150DE4D-96F0-483B-B20B-3A388AFBCF9F}" dt="2023-01-11T22:39:46.883" v="176" actId="1076"/>
          <ac:picMkLst>
            <pc:docMk/>
            <pc:sldMk cId="109857222" sldId="256"/>
            <ac:picMk id="17" creationId="{B34E3F46-1685-3C3E-1C5C-6733834D3548}"/>
          </ac:picMkLst>
        </pc:picChg>
        <pc:picChg chg="add del mod">
          <ac:chgData name="Jake Kendrick" userId="S::21308325@student.uwa.edu.au::ab142299-a4dd-4def-8b03-8ee3e1d9a7dd" providerId="AD" clId="Web-{9150DE4D-96F0-483B-B20B-3A388AFBCF9F}" dt="2023-01-11T08:49:49.893" v="129"/>
          <ac:picMkLst>
            <pc:docMk/>
            <pc:sldMk cId="109857222" sldId="256"/>
            <ac:picMk id="24" creationId="{9019C50A-FC5A-CCEF-5ECD-44C558342E06}"/>
          </ac:picMkLst>
        </pc:picChg>
        <pc:picChg chg="add del mod">
          <ac:chgData name="Jake Kendrick" userId="S::21308325@student.uwa.edu.au::ab142299-a4dd-4def-8b03-8ee3e1d9a7dd" providerId="AD" clId="Web-{9150DE4D-96F0-483B-B20B-3A388AFBCF9F}" dt="2023-01-11T08:50:25.458" v="138"/>
          <ac:picMkLst>
            <pc:docMk/>
            <pc:sldMk cId="109857222" sldId="256"/>
            <ac:picMk id="25" creationId="{F07478DE-D137-01AB-04E1-9D3EC91337FF}"/>
          </ac:picMkLst>
        </pc:picChg>
        <pc:picChg chg="add mod modCrop">
          <ac:chgData name="Jake Kendrick" userId="S::21308325@student.uwa.edu.au::ab142299-a4dd-4def-8b03-8ee3e1d9a7dd" providerId="AD" clId="Web-{9150DE4D-96F0-483B-B20B-3A388AFBCF9F}" dt="2023-01-11T22:48:44.509" v="184"/>
          <ac:picMkLst>
            <pc:docMk/>
            <pc:sldMk cId="109857222" sldId="256"/>
            <ac:picMk id="26" creationId="{625661E8-F1CD-2AC2-EA69-8FECF524C8E3}"/>
          </ac:picMkLst>
        </pc:picChg>
      </pc:sldChg>
    </pc:docChg>
  </pc:docChgLst>
  <pc:docChgLst>
    <pc:chgData name="Jake Kendrick" userId="S::21308325@student.uwa.edu.au::ab142299-a4dd-4def-8b03-8ee3e1d9a7dd" providerId="AD" clId="Web-{718FBA2C-ED38-385D-C525-33667249682D}"/>
    <pc:docChg chg="modSld">
      <pc:chgData name="Jake Kendrick" userId="S::21308325@student.uwa.edu.au::ab142299-a4dd-4def-8b03-8ee3e1d9a7dd" providerId="AD" clId="Web-{718FBA2C-ED38-385D-C525-33667249682D}" dt="2023-06-12T05:14:13.920" v="299"/>
      <pc:docMkLst>
        <pc:docMk/>
      </pc:docMkLst>
      <pc:sldChg chg="addSp delSp modSp">
        <pc:chgData name="Jake Kendrick" userId="S::21308325@student.uwa.edu.au::ab142299-a4dd-4def-8b03-8ee3e1d9a7dd" providerId="AD" clId="Web-{718FBA2C-ED38-385D-C525-33667249682D}" dt="2023-06-12T05:14:13.920" v="299"/>
        <pc:sldMkLst>
          <pc:docMk/>
          <pc:sldMk cId="109857222" sldId="256"/>
        </pc:sldMkLst>
        <pc:spChg chg="del">
          <ac:chgData name="Jake Kendrick" userId="S::21308325@student.uwa.edu.au::ab142299-a4dd-4def-8b03-8ee3e1d9a7dd" providerId="AD" clId="Web-{718FBA2C-ED38-385D-C525-33667249682D}" dt="2023-06-12T04:29:15.280" v="48"/>
          <ac:spMkLst>
            <pc:docMk/>
            <pc:sldMk cId="109857222" sldId="256"/>
            <ac:spMk id="2" creationId="{2EF2A381-DB62-ADB9-8061-FEE116D46C4B}"/>
          </ac:spMkLst>
        </pc:spChg>
        <pc:spChg chg="mod">
          <ac:chgData name="Jake Kendrick" userId="S::21308325@student.uwa.edu.au::ab142299-a4dd-4def-8b03-8ee3e1d9a7dd" providerId="AD" clId="Web-{718FBA2C-ED38-385D-C525-33667249682D}" dt="2023-06-12T04:29:52.500" v="59" actId="14100"/>
          <ac:spMkLst>
            <pc:docMk/>
            <pc:sldMk cId="109857222" sldId="256"/>
            <ac:spMk id="3" creationId="{ECC7EB11-F726-4C25-B968-5F3F1B5D581C}"/>
          </ac:spMkLst>
        </pc:spChg>
        <pc:spChg chg="mod">
          <ac:chgData name="Jake Kendrick" userId="S::21308325@student.uwa.edu.au::ab142299-a4dd-4def-8b03-8ee3e1d9a7dd" providerId="AD" clId="Web-{718FBA2C-ED38-385D-C525-33667249682D}" dt="2023-06-12T04:53:14.731" v="150" actId="1076"/>
          <ac:spMkLst>
            <pc:docMk/>
            <pc:sldMk cId="109857222" sldId="256"/>
            <ac:spMk id="5" creationId="{0578B295-60DA-1ACA-FA20-EABE43ECBD76}"/>
          </ac:spMkLst>
        </pc:spChg>
        <pc:spChg chg="mod">
          <ac:chgData name="Jake Kendrick" userId="S::21308325@student.uwa.edu.au::ab142299-a4dd-4def-8b03-8ee3e1d9a7dd" providerId="AD" clId="Web-{718FBA2C-ED38-385D-C525-33667249682D}" dt="2023-06-12T04:53:14.778" v="151" actId="1076"/>
          <ac:spMkLst>
            <pc:docMk/>
            <pc:sldMk cId="109857222" sldId="256"/>
            <ac:spMk id="7" creationId="{D5C3C840-2AF0-DF80-DC4C-81D5DA112E6E}"/>
          </ac:spMkLst>
        </pc:spChg>
        <pc:spChg chg="mod">
          <ac:chgData name="Jake Kendrick" userId="S::21308325@student.uwa.edu.au::ab142299-a4dd-4def-8b03-8ee3e1d9a7dd" providerId="AD" clId="Web-{718FBA2C-ED38-385D-C525-33667249682D}" dt="2023-06-12T04:53:14.700" v="149" actId="1076"/>
          <ac:spMkLst>
            <pc:docMk/>
            <pc:sldMk cId="109857222" sldId="256"/>
            <ac:spMk id="10" creationId="{77A02ED0-8423-0C42-930A-6F5D1DA6A053}"/>
          </ac:spMkLst>
        </pc:spChg>
        <pc:spChg chg="mod">
          <ac:chgData name="Jake Kendrick" userId="S::21308325@student.uwa.edu.au::ab142299-a4dd-4def-8b03-8ee3e1d9a7dd" providerId="AD" clId="Web-{718FBA2C-ED38-385D-C525-33667249682D}" dt="2023-06-12T04:59:10.055" v="189" actId="1076"/>
          <ac:spMkLst>
            <pc:docMk/>
            <pc:sldMk cId="109857222" sldId="256"/>
            <ac:spMk id="13" creationId="{A9A32FB2-2064-654E-9855-BDC1D5C342CA}"/>
          </ac:spMkLst>
        </pc:spChg>
        <pc:spChg chg="add mod">
          <ac:chgData name="Jake Kendrick" userId="S::21308325@student.uwa.edu.au::ab142299-a4dd-4def-8b03-8ee3e1d9a7dd" providerId="AD" clId="Web-{718FBA2C-ED38-385D-C525-33667249682D}" dt="2023-06-12T04:53:15.013" v="157" actId="1076"/>
          <ac:spMkLst>
            <pc:docMk/>
            <pc:sldMk cId="109857222" sldId="256"/>
            <ac:spMk id="14" creationId="{684747A3-725C-C054-C7E4-82C49ED43E2C}"/>
          </ac:spMkLst>
        </pc:spChg>
        <pc:spChg chg="add del">
          <ac:chgData name="Jake Kendrick" userId="S::21308325@student.uwa.edu.au::ab142299-a4dd-4def-8b03-8ee3e1d9a7dd" providerId="AD" clId="Web-{718FBA2C-ED38-385D-C525-33667249682D}" dt="2023-06-12T04:27:46.339" v="29"/>
          <ac:spMkLst>
            <pc:docMk/>
            <pc:sldMk cId="109857222" sldId="256"/>
            <ac:spMk id="17" creationId="{DFC3028B-DD68-1FF9-9B2F-83F4FFFB38E3}"/>
          </ac:spMkLst>
        </pc:spChg>
        <pc:spChg chg="add del">
          <ac:chgData name="Jake Kendrick" userId="S::21308325@student.uwa.edu.au::ab142299-a4dd-4def-8b03-8ee3e1d9a7dd" providerId="AD" clId="Web-{718FBA2C-ED38-385D-C525-33667249682D}" dt="2023-06-12T04:28:10.059" v="34"/>
          <ac:spMkLst>
            <pc:docMk/>
            <pc:sldMk cId="109857222" sldId="256"/>
            <ac:spMk id="18" creationId="{0559FCFA-2BE2-7938-38B6-F7B5D960C911}"/>
          </ac:spMkLst>
        </pc:spChg>
        <pc:spChg chg="add mod">
          <ac:chgData name="Jake Kendrick" userId="S::21308325@student.uwa.edu.au::ab142299-a4dd-4def-8b03-8ee3e1d9a7dd" providerId="AD" clId="Web-{718FBA2C-ED38-385D-C525-33667249682D}" dt="2023-06-12T04:53:15.059" v="158" actId="1076"/>
          <ac:spMkLst>
            <pc:docMk/>
            <pc:sldMk cId="109857222" sldId="256"/>
            <ac:spMk id="19" creationId="{213DBABF-567F-D77D-B8E1-6A769D5EA0AF}"/>
          </ac:spMkLst>
        </pc:spChg>
        <pc:spChg chg="del">
          <ac:chgData name="Jake Kendrick" userId="S::21308325@student.uwa.edu.au::ab142299-a4dd-4def-8b03-8ee3e1d9a7dd" providerId="AD" clId="Web-{718FBA2C-ED38-385D-C525-33667249682D}" dt="2023-06-12T04:29:15.280" v="47"/>
          <ac:spMkLst>
            <pc:docMk/>
            <pc:sldMk cId="109857222" sldId="256"/>
            <ac:spMk id="23" creationId="{95508AB1-968D-80D6-992F-FB9BCCC8E50C}"/>
          </ac:spMkLst>
        </pc:spChg>
        <pc:spChg chg="del mod">
          <ac:chgData name="Jake Kendrick" userId="S::21308325@student.uwa.edu.au::ab142299-a4dd-4def-8b03-8ee3e1d9a7dd" providerId="AD" clId="Web-{718FBA2C-ED38-385D-C525-33667249682D}" dt="2023-06-12T04:38:07.625" v="96"/>
          <ac:spMkLst>
            <pc:docMk/>
            <pc:sldMk cId="109857222" sldId="256"/>
            <ac:spMk id="24" creationId="{D03B52AC-0E6F-DF1C-D0F5-FA74898FA11D}"/>
          </ac:spMkLst>
        </pc:spChg>
        <pc:spChg chg="del mod">
          <ac:chgData name="Jake Kendrick" userId="S::21308325@student.uwa.edu.au::ab142299-a4dd-4def-8b03-8ee3e1d9a7dd" providerId="AD" clId="Web-{718FBA2C-ED38-385D-C525-33667249682D}" dt="2023-06-12T04:38:08.359" v="97"/>
          <ac:spMkLst>
            <pc:docMk/>
            <pc:sldMk cId="109857222" sldId="256"/>
            <ac:spMk id="25" creationId="{046B7A09-1A51-7855-228B-8E006AA12518}"/>
          </ac:spMkLst>
        </pc:spChg>
        <pc:spChg chg="del">
          <ac:chgData name="Jake Kendrick" userId="S::21308325@student.uwa.edu.au::ab142299-a4dd-4def-8b03-8ee3e1d9a7dd" providerId="AD" clId="Web-{718FBA2C-ED38-385D-C525-33667249682D}" dt="2023-06-12T04:28:24.716" v="38"/>
          <ac:spMkLst>
            <pc:docMk/>
            <pc:sldMk cId="109857222" sldId="256"/>
            <ac:spMk id="28" creationId="{3AC7618D-CAC4-1099-5DDE-36854DE868CD}"/>
          </ac:spMkLst>
        </pc:spChg>
        <pc:spChg chg="del">
          <ac:chgData name="Jake Kendrick" userId="S::21308325@student.uwa.edu.au::ab142299-a4dd-4def-8b03-8ee3e1d9a7dd" providerId="AD" clId="Web-{718FBA2C-ED38-385D-C525-33667249682D}" dt="2023-06-12T04:28:27.903" v="39"/>
          <ac:spMkLst>
            <pc:docMk/>
            <pc:sldMk cId="109857222" sldId="256"/>
            <ac:spMk id="32" creationId="{6EB4D891-2210-2913-0945-E42ACE242EA1}"/>
          </ac:spMkLst>
        </pc:spChg>
        <pc:spChg chg="add mod">
          <ac:chgData name="Jake Kendrick" userId="S::21308325@student.uwa.edu.au::ab142299-a4dd-4def-8b03-8ee3e1d9a7dd" providerId="AD" clId="Web-{718FBA2C-ED38-385D-C525-33667249682D}" dt="2023-06-12T04:53:18.872" v="160" actId="1076"/>
          <ac:spMkLst>
            <pc:docMk/>
            <pc:sldMk cId="109857222" sldId="256"/>
            <ac:spMk id="35" creationId="{EF356298-36BF-9C6A-CFB3-7ABA81BDE941}"/>
          </ac:spMkLst>
        </pc:spChg>
        <pc:spChg chg="mod">
          <ac:chgData name="Jake Kendrick" userId="S::21308325@student.uwa.edu.au::ab142299-a4dd-4def-8b03-8ee3e1d9a7dd" providerId="AD" clId="Web-{718FBA2C-ED38-385D-C525-33667249682D}" dt="2023-06-12T05:13:15.178" v="290" actId="14100"/>
          <ac:spMkLst>
            <pc:docMk/>
            <pc:sldMk cId="109857222" sldId="256"/>
            <ac:spMk id="36" creationId="{9038A5FC-BAEB-6F6F-E152-D90D91AFE4C4}"/>
          </ac:spMkLst>
        </pc:spChg>
        <pc:spChg chg="mod">
          <ac:chgData name="Jake Kendrick" userId="S::21308325@student.uwa.edu.au::ab142299-a4dd-4def-8b03-8ee3e1d9a7dd" providerId="AD" clId="Web-{718FBA2C-ED38-385D-C525-33667249682D}" dt="2023-06-12T05:02:49.734" v="216" actId="20577"/>
          <ac:spMkLst>
            <pc:docMk/>
            <pc:sldMk cId="109857222" sldId="256"/>
            <ac:spMk id="37" creationId="{31574BA6-DC1B-27E8-6D53-C5259F6FCE78}"/>
          </ac:spMkLst>
        </pc:spChg>
        <pc:spChg chg="add mod">
          <ac:chgData name="Jake Kendrick" userId="S::21308325@student.uwa.edu.au::ab142299-a4dd-4def-8b03-8ee3e1d9a7dd" providerId="AD" clId="Web-{718FBA2C-ED38-385D-C525-33667249682D}" dt="2023-06-12T04:53:35.982" v="164" actId="20577"/>
          <ac:spMkLst>
            <pc:docMk/>
            <pc:sldMk cId="109857222" sldId="256"/>
            <ac:spMk id="38" creationId="{164BBDCB-BEE3-3218-FF28-622DD53F2615}"/>
          </ac:spMkLst>
        </pc:spChg>
        <pc:spChg chg="mod">
          <ac:chgData name="Jake Kendrick" userId="S::21308325@student.uwa.edu.au::ab142299-a4dd-4def-8b03-8ee3e1d9a7dd" providerId="AD" clId="Web-{718FBA2C-ED38-385D-C525-33667249682D}" dt="2023-06-12T04:53:14.825" v="152" actId="1076"/>
          <ac:spMkLst>
            <pc:docMk/>
            <pc:sldMk cId="109857222" sldId="256"/>
            <ac:spMk id="39" creationId="{55A072C5-91CD-B984-C138-99285623E89B}"/>
          </ac:spMkLst>
        </pc:spChg>
        <pc:spChg chg="mod">
          <ac:chgData name="Jake Kendrick" userId="S::21308325@student.uwa.edu.au::ab142299-a4dd-4def-8b03-8ee3e1d9a7dd" providerId="AD" clId="Web-{718FBA2C-ED38-385D-C525-33667249682D}" dt="2023-06-12T04:53:14.872" v="153" actId="1076"/>
          <ac:spMkLst>
            <pc:docMk/>
            <pc:sldMk cId="109857222" sldId="256"/>
            <ac:spMk id="40" creationId="{33444CC2-0B7A-4C62-68A0-445C4CA3BE0B}"/>
          </ac:spMkLst>
        </pc:spChg>
        <pc:spChg chg="mod">
          <ac:chgData name="Jake Kendrick" userId="S::21308325@student.uwa.edu.au::ab142299-a4dd-4def-8b03-8ee3e1d9a7dd" providerId="AD" clId="Web-{718FBA2C-ED38-385D-C525-33667249682D}" dt="2023-06-12T04:53:14.919" v="154" actId="1076"/>
          <ac:spMkLst>
            <pc:docMk/>
            <pc:sldMk cId="109857222" sldId="256"/>
            <ac:spMk id="41" creationId="{0C5F94FA-5BDB-3A9B-D2F7-088A5358A9A4}"/>
          </ac:spMkLst>
        </pc:spChg>
        <pc:spChg chg="mod">
          <ac:chgData name="Jake Kendrick" userId="S::21308325@student.uwa.edu.au::ab142299-a4dd-4def-8b03-8ee3e1d9a7dd" providerId="AD" clId="Web-{718FBA2C-ED38-385D-C525-33667249682D}" dt="2023-06-12T04:53:14.950" v="155" actId="1076"/>
          <ac:spMkLst>
            <pc:docMk/>
            <pc:sldMk cId="109857222" sldId="256"/>
            <ac:spMk id="42" creationId="{3B80A3C7-7EB6-0B4C-23BA-E8FB9CFA8FBB}"/>
          </ac:spMkLst>
        </pc:spChg>
        <pc:spChg chg="add mod">
          <ac:chgData name="Jake Kendrick" userId="S::21308325@student.uwa.edu.au::ab142299-a4dd-4def-8b03-8ee3e1d9a7dd" providerId="AD" clId="Web-{718FBA2C-ED38-385D-C525-33667249682D}" dt="2023-06-12T04:58:18.116" v="181"/>
          <ac:spMkLst>
            <pc:docMk/>
            <pc:sldMk cId="109857222" sldId="256"/>
            <ac:spMk id="44" creationId="{CACC462F-5229-4ACD-D86F-DF133499E38F}"/>
          </ac:spMkLst>
        </pc:spChg>
        <pc:spChg chg="del">
          <ac:chgData name="Jake Kendrick" userId="S::21308325@student.uwa.edu.au::ab142299-a4dd-4def-8b03-8ee3e1d9a7dd" providerId="AD" clId="Web-{718FBA2C-ED38-385D-C525-33667249682D}" dt="2023-06-12T04:29:10.592" v="43"/>
          <ac:spMkLst>
            <pc:docMk/>
            <pc:sldMk cId="109857222" sldId="256"/>
            <ac:spMk id="48" creationId="{46C92995-C1F9-3A19-A0B2-3E947A6561DA}"/>
          </ac:spMkLst>
        </pc:spChg>
        <pc:spChg chg="add del mod topLvl">
          <ac:chgData name="Jake Kendrick" userId="S::21308325@student.uwa.edu.au::ab142299-a4dd-4def-8b03-8ee3e1d9a7dd" providerId="AD" clId="Web-{718FBA2C-ED38-385D-C525-33667249682D}" dt="2023-06-12T05:05:51.773" v="227"/>
          <ac:spMkLst>
            <pc:docMk/>
            <pc:sldMk cId="109857222" sldId="256"/>
            <ac:spMk id="50" creationId="{C72B1983-5F7D-DC12-94A7-F19C2A223FEA}"/>
          </ac:spMkLst>
        </pc:spChg>
        <pc:spChg chg="add mod">
          <ac:chgData name="Jake Kendrick" userId="S::21308325@student.uwa.edu.au::ab142299-a4dd-4def-8b03-8ee3e1d9a7dd" providerId="AD" clId="Web-{718FBA2C-ED38-385D-C525-33667249682D}" dt="2023-06-12T05:07:45.386" v="240" actId="1076"/>
          <ac:spMkLst>
            <pc:docMk/>
            <pc:sldMk cId="109857222" sldId="256"/>
            <ac:spMk id="54" creationId="{E2F46690-3403-E50E-37A8-DB3A33BE3B50}"/>
          </ac:spMkLst>
        </pc:spChg>
        <pc:spChg chg="add mod">
          <ac:chgData name="Jake Kendrick" userId="S::21308325@student.uwa.edu.au::ab142299-a4dd-4def-8b03-8ee3e1d9a7dd" providerId="AD" clId="Web-{718FBA2C-ED38-385D-C525-33667249682D}" dt="2023-06-12T05:14:08.185" v="297" actId="1076"/>
          <ac:spMkLst>
            <pc:docMk/>
            <pc:sldMk cId="109857222" sldId="256"/>
            <ac:spMk id="58" creationId="{12807188-A8EC-55CC-19F3-5C8F9FEE666B}"/>
          </ac:spMkLst>
        </pc:spChg>
        <pc:spChg chg="add del">
          <ac:chgData name="Jake Kendrick" userId="S::21308325@student.uwa.edu.au::ab142299-a4dd-4def-8b03-8ee3e1d9a7dd" providerId="AD" clId="Web-{718FBA2C-ED38-385D-C525-33667249682D}" dt="2023-06-12T05:10:26.001" v="261"/>
          <ac:spMkLst>
            <pc:docMk/>
            <pc:sldMk cId="109857222" sldId="256"/>
            <ac:spMk id="59" creationId="{57E2C249-7D6D-7457-9AF9-1AD8B84DDCC8}"/>
          </ac:spMkLst>
        </pc:spChg>
        <pc:spChg chg="add mod">
          <ac:chgData name="Jake Kendrick" userId="S::21308325@student.uwa.edu.au::ab142299-a4dd-4def-8b03-8ee3e1d9a7dd" providerId="AD" clId="Web-{718FBA2C-ED38-385D-C525-33667249682D}" dt="2023-06-12T05:10:56.799" v="270" actId="14100"/>
          <ac:spMkLst>
            <pc:docMk/>
            <pc:sldMk cId="109857222" sldId="256"/>
            <ac:spMk id="60" creationId="{571D5DE6-7BAC-F156-A40F-35164140D145}"/>
          </ac:spMkLst>
        </pc:spChg>
        <pc:grpChg chg="add del mod">
          <ac:chgData name="Jake Kendrick" userId="S::21308325@student.uwa.edu.au::ab142299-a4dd-4def-8b03-8ee3e1d9a7dd" providerId="AD" clId="Web-{718FBA2C-ED38-385D-C525-33667249682D}" dt="2023-06-12T05:14:13.920" v="299"/>
          <ac:grpSpMkLst>
            <pc:docMk/>
            <pc:sldMk cId="109857222" sldId="256"/>
            <ac:grpSpMk id="45" creationId="{A7FEE2A6-A422-00B1-6590-6511A55016DF}"/>
          </ac:grpSpMkLst>
        </pc:grpChg>
        <pc:grpChg chg="add del mod">
          <ac:chgData name="Jake Kendrick" userId="S::21308325@student.uwa.edu.au::ab142299-a4dd-4def-8b03-8ee3e1d9a7dd" providerId="AD" clId="Web-{718FBA2C-ED38-385D-C525-33667249682D}" dt="2023-06-12T05:05:51.773" v="227"/>
          <ac:grpSpMkLst>
            <pc:docMk/>
            <pc:sldMk cId="109857222" sldId="256"/>
            <ac:grpSpMk id="51" creationId="{7D57B35E-D8A2-EC4C-E683-793E7B7A6518}"/>
          </ac:grpSpMkLst>
        </pc:grpChg>
        <pc:picChg chg="del">
          <ac:chgData name="Jake Kendrick" userId="S::21308325@student.uwa.edu.au::ab142299-a4dd-4def-8b03-8ee3e1d9a7dd" providerId="AD" clId="Web-{718FBA2C-ED38-385D-C525-33667249682D}" dt="2023-06-12T04:29:15.280" v="44"/>
          <ac:picMkLst>
            <pc:docMk/>
            <pc:sldMk cId="109857222" sldId="256"/>
            <ac:picMk id="4" creationId="{C4C21272-6BB4-922D-4E8A-DB9BDA6BFADE}"/>
          </ac:picMkLst>
        </pc:picChg>
        <pc:picChg chg="del mod">
          <ac:chgData name="Jake Kendrick" userId="S::21308325@student.uwa.edu.au::ab142299-a4dd-4def-8b03-8ee3e1d9a7dd" providerId="AD" clId="Web-{718FBA2C-ED38-385D-C525-33667249682D}" dt="2023-06-12T04:59:25.555" v="193"/>
          <ac:picMkLst>
            <pc:docMk/>
            <pc:sldMk cId="109857222" sldId="256"/>
            <ac:picMk id="6" creationId="{8FDDA5BF-F1A6-FCB8-188B-1ACE13C5EFDF}"/>
          </ac:picMkLst>
        </pc:picChg>
        <pc:picChg chg="add del mod">
          <ac:chgData name="Jake Kendrick" userId="S::21308325@student.uwa.edu.au::ab142299-a4dd-4def-8b03-8ee3e1d9a7dd" providerId="AD" clId="Web-{718FBA2C-ED38-385D-C525-33667249682D}" dt="2023-06-12T04:24:04.317" v="8"/>
          <ac:picMkLst>
            <pc:docMk/>
            <pc:sldMk cId="109857222" sldId="256"/>
            <ac:picMk id="8" creationId="{72B79F9F-664B-476C-0019-7E3C0E2D5C6E}"/>
          </ac:picMkLst>
        </pc:picChg>
        <pc:picChg chg="add del mod">
          <ac:chgData name="Jake Kendrick" userId="S::21308325@student.uwa.edu.au::ab142299-a4dd-4def-8b03-8ee3e1d9a7dd" providerId="AD" clId="Web-{718FBA2C-ED38-385D-C525-33667249682D}" dt="2023-06-12T04:24:48.412" v="15"/>
          <ac:picMkLst>
            <pc:docMk/>
            <pc:sldMk cId="109857222" sldId="256"/>
            <ac:picMk id="9" creationId="{1E03C1D6-70A4-AB80-5891-2D8423A75B9F}"/>
          </ac:picMkLst>
        </pc:picChg>
        <pc:picChg chg="add del mod">
          <ac:chgData name="Jake Kendrick" userId="S::21308325@student.uwa.edu.au::ab142299-a4dd-4def-8b03-8ee3e1d9a7dd" providerId="AD" clId="Web-{718FBA2C-ED38-385D-C525-33667249682D}" dt="2023-06-12T04:26:53.041" v="23"/>
          <ac:picMkLst>
            <pc:docMk/>
            <pc:sldMk cId="109857222" sldId="256"/>
            <ac:picMk id="11" creationId="{0490F7DF-FE71-4DF0-108C-FAA1B430ED0B}"/>
          </ac:picMkLst>
        </pc:picChg>
        <pc:picChg chg="add mod ord">
          <ac:chgData name="Jake Kendrick" userId="S::21308325@student.uwa.edu.au::ab142299-a4dd-4def-8b03-8ee3e1d9a7dd" providerId="AD" clId="Web-{718FBA2C-ED38-385D-C525-33667249682D}" dt="2023-06-12T04:53:14.981" v="156" actId="1076"/>
          <ac:picMkLst>
            <pc:docMk/>
            <pc:sldMk cId="109857222" sldId="256"/>
            <ac:picMk id="16" creationId="{B3E9B01E-645C-60EC-AB54-5A3CF9EC3FD4}"/>
          </ac:picMkLst>
        </pc:picChg>
        <pc:picChg chg="add del mod">
          <ac:chgData name="Jake Kendrick" userId="S::21308325@student.uwa.edu.au::ab142299-a4dd-4def-8b03-8ee3e1d9a7dd" providerId="AD" clId="Web-{718FBA2C-ED38-385D-C525-33667249682D}" dt="2023-06-12T04:35:10.822" v="80"/>
          <ac:picMkLst>
            <pc:docMk/>
            <pc:sldMk cId="109857222" sldId="256"/>
            <ac:picMk id="20" creationId="{74581027-F089-7D8F-E07B-9EA02DC97D54}"/>
          </ac:picMkLst>
        </pc:picChg>
        <pc:picChg chg="add del mod">
          <ac:chgData name="Jake Kendrick" userId="S::21308325@student.uwa.edu.au::ab142299-a4dd-4def-8b03-8ee3e1d9a7dd" providerId="AD" clId="Web-{718FBA2C-ED38-385D-C525-33667249682D}" dt="2023-06-12T04:35:49.136" v="83"/>
          <ac:picMkLst>
            <pc:docMk/>
            <pc:sldMk cId="109857222" sldId="256"/>
            <ac:picMk id="21" creationId="{7EF76F4D-5C8E-F0B4-4E57-4EDBABB491C5}"/>
          </ac:picMkLst>
        </pc:picChg>
        <pc:picChg chg="del">
          <ac:chgData name="Jake Kendrick" userId="S::21308325@student.uwa.edu.au::ab142299-a4dd-4def-8b03-8ee3e1d9a7dd" providerId="AD" clId="Web-{718FBA2C-ED38-385D-C525-33667249682D}" dt="2023-06-12T04:30:53.361" v="74"/>
          <ac:picMkLst>
            <pc:docMk/>
            <pc:sldMk cId="109857222" sldId="256"/>
            <ac:picMk id="22" creationId="{9C3257FB-98C5-58ED-6EC1-6CBD33D00AA0}"/>
          </ac:picMkLst>
        </pc:picChg>
        <pc:picChg chg="del">
          <ac:chgData name="Jake Kendrick" userId="S::21308325@student.uwa.edu.au::ab142299-a4dd-4def-8b03-8ee3e1d9a7dd" providerId="AD" clId="Web-{718FBA2C-ED38-385D-C525-33667249682D}" dt="2023-06-12T04:30:54.111" v="75"/>
          <ac:picMkLst>
            <pc:docMk/>
            <pc:sldMk cId="109857222" sldId="256"/>
            <ac:picMk id="26" creationId="{625661E8-F1CD-2AC2-EA69-8FECF524C8E3}"/>
          </ac:picMkLst>
        </pc:picChg>
        <pc:picChg chg="del">
          <ac:chgData name="Jake Kendrick" userId="S::21308325@student.uwa.edu.au::ab142299-a4dd-4def-8b03-8ee3e1d9a7dd" providerId="AD" clId="Web-{718FBA2C-ED38-385D-C525-33667249682D}" dt="2023-06-12T04:28:23.075" v="37"/>
          <ac:picMkLst>
            <pc:docMk/>
            <pc:sldMk cId="109857222" sldId="256"/>
            <ac:picMk id="27" creationId="{9D03736E-DD8F-95BD-25BB-D4085B3A0A0E}"/>
          </ac:picMkLst>
        </pc:picChg>
        <pc:picChg chg="add mod ord">
          <ac:chgData name="Jake Kendrick" userId="S::21308325@student.uwa.edu.au::ab142299-a4dd-4def-8b03-8ee3e1d9a7dd" providerId="AD" clId="Web-{718FBA2C-ED38-385D-C525-33667249682D}" dt="2023-06-12T04:53:14.669" v="148" actId="1076"/>
          <ac:picMkLst>
            <pc:docMk/>
            <pc:sldMk cId="109857222" sldId="256"/>
            <ac:picMk id="29" creationId="{95E6D91C-398D-8DCF-3D4D-E341E42D1C4B}"/>
          </ac:picMkLst>
        </pc:picChg>
        <pc:picChg chg="add del mod">
          <ac:chgData name="Jake Kendrick" userId="S::21308325@student.uwa.edu.au::ab142299-a4dd-4def-8b03-8ee3e1d9a7dd" providerId="AD" clId="Web-{718FBA2C-ED38-385D-C525-33667249682D}" dt="2023-06-12T04:39:15.002" v="106"/>
          <ac:picMkLst>
            <pc:docMk/>
            <pc:sldMk cId="109857222" sldId="256"/>
            <ac:picMk id="30" creationId="{387D96F7-8C5D-3216-9F8F-5840C2B03665}"/>
          </ac:picMkLst>
        </pc:picChg>
        <pc:picChg chg="add mod modCrop">
          <ac:chgData name="Jake Kendrick" userId="S::21308325@student.uwa.edu.au::ab142299-a4dd-4def-8b03-8ee3e1d9a7dd" providerId="AD" clId="Web-{718FBA2C-ED38-385D-C525-33667249682D}" dt="2023-06-12T04:53:15.106" v="159" actId="1076"/>
          <ac:picMkLst>
            <pc:docMk/>
            <pc:sldMk cId="109857222" sldId="256"/>
            <ac:picMk id="31" creationId="{2C5DF484-5768-618B-EB79-746A831B3732}"/>
          </ac:picMkLst>
        </pc:picChg>
        <pc:picChg chg="del">
          <ac:chgData name="Jake Kendrick" userId="S::21308325@student.uwa.edu.au::ab142299-a4dd-4def-8b03-8ee3e1d9a7dd" providerId="AD" clId="Web-{718FBA2C-ED38-385D-C525-33667249682D}" dt="2023-06-12T04:29:15.280" v="46"/>
          <ac:picMkLst>
            <pc:docMk/>
            <pc:sldMk cId="109857222" sldId="256"/>
            <ac:picMk id="33" creationId="{C5C09760-FA55-B5E0-5665-829C0A0E4041}"/>
          </ac:picMkLst>
        </pc:picChg>
        <pc:picChg chg="del mod">
          <ac:chgData name="Jake Kendrick" userId="S::21308325@student.uwa.edu.au::ab142299-a4dd-4def-8b03-8ee3e1d9a7dd" providerId="AD" clId="Web-{718FBA2C-ED38-385D-C525-33667249682D}" dt="2023-06-12T04:59:15.164" v="191"/>
          <ac:picMkLst>
            <pc:docMk/>
            <pc:sldMk cId="109857222" sldId="256"/>
            <ac:picMk id="34" creationId="{27F33C34-E134-436F-980B-BE88724A9A53}"/>
          </ac:picMkLst>
        </pc:picChg>
        <pc:picChg chg="add mod">
          <ac:chgData name="Jake Kendrick" userId="S::21308325@student.uwa.edu.au::ab142299-a4dd-4def-8b03-8ee3e1d9a7dd" providerId="AD" clId="Web-{718FBA2C-ED38-385D-C525-33667249682D}" dt="2023-06-12T04:57:33.146" v="174" actId="1076"/>
          <ac:picMkLst>
            <pc:docMk/>
            <pc:sldMk cId="109857222" sldId="256"/>
            <ac:picMk id="43" creationId="{A6254AF7-30ED-3F6C-ADED-7CFC041BB25E}"/>
          </ac:picMkLst>
        </pc:picChg>
        <pc:picChg chg="del mod">
          <ac:chgData name="Jake Kendrick" userId="S::21308325@student.uwa.edu.au::ab142299-a4dd-4def-8b03-8ee3e1d9a7dd" providerId="AD" clId="Web-{718FBA2C-ED38-385D-C525-33667249682D}" dt="2023-06-12T04:59:26.165" v="194"/>
          <ac:picMkLst>
            <pc:docMk/>
            <pc:sldMk cId="109857222" sldId="256"/>
            <ac:picMk id="46" creationId="{A2C6F53B-A4B4-D819-4FB7-69E36E8FA5DC}"/>
          </ac:picMkLst>
        </pc:picChg>
        <pc:picChg chg="del">
          <ac:chgData name="Jake Kendrick" userId="S::21308325@student.uwa.edu.au::ab142299-a4dd-4def-8b03-8ee3e1d9a7dd" providerId="AD" clId="Web-{718FBA2C-ED38-385D-C525-33667249682D}" dt="2023-06-12T04:29:15.280" v="45"/>
          <ac:picMkLst>
            <pc:docMk/>
            <pc:sldMk cId="109857222" sldId="256"/>
            <ac:picMk id="47" creationId="{BB0866FE-E4BC-414C-5235-C69F629B2D52}"/>
          </ac:picMkLst>
        </pc:picChg>
        <pc:picChg chg="add del mod topLvl">
          <ac:chgData name="Jake Kendrick" userId="S::21308325@student.uwa.edu.au::ab142299-a4dd-4def-8b03-8ee3e1d9a7dd" providerId="AD" clId="Web-{718FBA2C-ED38-385D-C525-33667249682D}" dt="2023-06-12T05:05:54.102" v="228"/>
          <ac:picMkLst>
            <pc:docMk/>
            <pc:sldMk cId="109857222" sldId="256"/>
            <ac:picMk id="49" creationId="{35EA88FD-401D-4629-6B93-A8646FEEB58D}"/>
          </ac:picMkLst>
        </pc:picChg>
        <pc:picChg chg="add del mod modCrop">
          <ac:chgData name="Jake Kendrick" userId="S::21308325@student.uwa.edu.au::ab142299-a4dd-4def-8b03-8ee3e1d9a7dd" providerId="AD" clId="Web-{718FBA2C-ED38-385D-C525-33667249682D}" dt="2023-06-12T05:14:12.904" v="298"/>
          <ac:picMkLst>
            <pc:docMk/>
            <pc:sldMk cId="109857222" sldId="256"/>
            <ac:picMk id="52" creationId="{7731D164-30AB-D236-DB7C-7772541F6475}"/>
          </ac:picMkLst>
        </pc:picChg>
        <pc:picChg chg="add mod">
          <ac:chgData name="Jake Kendrick" userId="S::21308325@student.uwa.edu.au::ab142299-a4dd-4def-8b03-8ee3e1d9a7dd" providerId="AD" clId="Web-{718FBA2C-ED38-385D-C525-33667249682D}" dt="2023-06-12T05:09:24.093" v="248" actId="14100"/>
          <ac:picMkLst>
            <pc:docMk/>
            <pc:sldMk cId="109857222" sldId="256"/>
            <ac:picMk id="55" creationId="{FD19E755-28F7-14C7-2B2F-9691220023CD}"/>
          </ac:picMkLst>
        </pc:picChg>
        <pc:picChg chg="add del mod">
          <ac:chgData name="Jake Kendrick" userId="S::21308325@student.uwa.edu.au::ab142299-a4dd-4def-8b03-8ee3e1d9a7dd" providerId="AD" clId="Web-{718FBA2C-ED38-385D-C525-33667249682D}" dt="2023-06-12T05:11:50.691" v="271"/>
          <ac:picMkLst>
            <pc:docMk/>
            <pc:sldMk cId="109857222" sldId="256"/>
            <ac:picMk id="56" creationId="{DCC7BC13-CC9A-1402-F277-9EC71DF7E972}"/>
          </ac:picMkLst>
        </pc:picChg>
        <pc:picChg chg="add mod ord modCrop">
          <ac:chgData name="Jake Kendrick" userId="S::21308325@student.uwa.edu.au::ab142299-a4dd-4def-8b03-8ee3e1d9a7dd" providerId="AD" clId="Web-{718FBA2C-ED38-385D-C525-33667249682D}" dt="2023-06-12T05:14:08.154" v="296" actId="1076"/>
          <ac:picMkLst>
            <pc:docMk/>
            <pc:sldMk cId="109857222" sldId="256"/>
            <ac:picMk id="61" creationId="{64F72DF3-F2F2-95C7-31EE-BC1637A78667}"/>
          </ac:picMkLst>
        </pc:picChg>
      </pc:sldChg>
    </pc:docChg>
  </pc:docChgLst>
  <pc:docChgLst>
    <pc:chgData name="Jake Kendrick" userId="S::21308325@student.uwa.edu.au::ab142299-a4dd-4def-8b03-8ee3e1d9a7dd" providerId="AD" clId="Web-{C9C15643-D0C5-44B8-BAA7-AB85D2AF82BA}"/>
    <pc:docChg chg="modSld">
      <pc:chgData name="Jake Kendrick" userId="S::21308325@student.uwa.edu.au::ab142299-a4dd-4def-8b03-8ee3e1d9a7dd" providerId="AD" clId="Web-{C9C15643-D0C5-44B8-BAA7-AB85D2AF82BA}" dt="2022-12-29T23:58:52.205" v="84" actId="14100"/>
      <pc:docMkLst>
        <pc:docMk/>
      </pc:docMkLst>
      <pc:sldChg chg="addSp delSp modSp">
        <pc:chgData name="Jake Kendrick" userId="S::21308325@student.uwa.edu.au::ab142299-a4dd-4def-8b03-8ee3e1d9a7dd" providerId="AD" clId="Web-{C9C15643-D0C5-44B8-BAA7-AB85D2AF82BA}" dt="2022-12-29T23:58:52.205" v="84" actId="14100"/>
        <pc:sldMkLst>
          <pc:docMk/>
          <pc:sldMk cId="109857222" sldId="256"/>
        </pc:sldMkLst>
        <pc:spChg chg="add mod">
          <ac:chgData name="Jake Kendrick" userId="S::21308325@student.uwa.edu.au::ab142299-a4dd-4def-8b03-8ee3e1d9a7dd" providerId="AD" clId="Web-{C9C15643-D0C5-44B8-BAA7-AB85D2AF82BA}" dt="2022-12-29T23:55:22.518" v="70" actId="1076"/>
          <ac:spMkLst>
            <pc:docMk/>
            <pc:sldMk cId="109857222" sldId="256"/>
            <ac:spMk id="4" creationId="{10C2DED3-698D-7ED0-B399-35C69A59F96F}"/>
          </ac:spMkLst>
        </pc:spChg>
        <pc:spChg chg="add mod">
          <ac:chgData name="Jake Kendrick" userId="S::21308325@student.uwa.edu.au::ab142299-a4dd-4def-8b03-8ee3e1d9a7dd" providerId="AD" clId="Web-{C9C15643-D0C5-44B8-BAA7-AB85D2AF82BA}" dt="2022-12-29T23:58:52.205" v="84" actId="14100"/>
          <ac:spMkLst>
            <pc:docMk/>
            <pc:sldMk cId="109857222" sldId="256"/>
            <ac:spMk id="8" creationId="{49AF7FBA-0E18-CB4F-B3BE-BE18C90D7AC9}"/>
          </ac:spMkLst>
        </pc:spChg>
        <pc:spChg chg="del">
          <ac:chgData name="Jake Kendrick" userId="S::21308325@student.uwa.edu.au::ab142299-a4dd-4def-8b03-8ee3e1d9a7dd" providerId="AD" clId="Web-{C9C15643-D0C5-44B8-BAA7-AB85D2AF82BA}" dt="2022-12-29T23:43:44.745" v="3"/>
          <ac:spMkLst>
            <pc:docMk/>
            <pc:sldMk cId="109857222" sldId="256"/>
            <ac:spMk id="11" creationId="{51C3C997-41C1-7247-BB0B-5044F4E47364}"/>
          </ac:spMkLst>
        </pc:spChg>
        <pc:picChg chg="add mod modCrop">
          <ac:chgData name="Jake Kendrick" userId="S::21308325@student.uwa.edu.au::ab142299-a4dd-4def-8b03-8ee3e1d9a7dd" providerId="AD" clId="Web-{C9C15643-D0C5-44B8-BAA7-AB85D2AF82BA}" dt="2022-12-29T23:55:00.268" v="65" actId="1076"/>
          <ac:picMkLst>
            <pc:docMk/>
            <pc:sldMk cId="109857222" sldId="256"/>
            <ac:picMk id="2" creationId="{A01C2D52-27EF-673E-93AD-928A3BE60015}"/>
          </ac:picMkLst>
        </pc:picChg>
        <pc:picChg chg="add mod modCrop">
          <ac:chgData name="Jake Kendrick" userId="S::21308325@student.uwa.edu.au::ab142299-a4dd-4def-8b03-8ee3e1d9a7dd" providerId="AD" clId="Web-{C9C15643-D0C5-44B8-BAA7-AB85D2AF82BA}" dt="2022-12-29T23:55:17.706" v="68" actId="1076"/>
          <ac:picMkLst>
            <pc:docMk/>
            <pc:sldMk cId="109857222" sldId="256"/>
            <ac:picMk id="3" creationId="{661A1E88-944A-AB5F-978C-33994634841E}"/>
          </ac:picMkLst>
        </pc:picChg>
        <pc:picChg chg="del">
          <ac:chgData name="Jake Kendrick" userId="S::21308325@student.uwa.edu.au::ab142299-a4dd-4def-8b03-8ee3e1d9a7dd" providerId="AD" clId="Web-{C9C15643-D0C5-44B8-BAA7-AB85D2AF82BA}" dt="2022-12-29T23:43:38.713" v="0"/>
          <ac:picMkLst>
            <pc:docMk/>
            <pc:sldMk cId="109857222" sldId="256"/>
            <ac:picMk id="5" creationId="{D0D72CDC-DB73-4A46-BC72-65F82BD2E953}"/>
          </ac:picMkLst>
        </pc:picChg>
        <pc:picChg chg="add mod modCrop">
          <ac:chgData name="Jake Kendrick" userId="S::21308325@student.uwa.edu.au::ab142299-a4dd-4def-8b03-8ee3e1d9a7dd" providerId="AD" clId="Web-{C9C15643-D0C5-44B8-BAA7-AB85D2AF82BA}" dt="2022-12-29T23:57:03.224" v="74" actId="1076"/>
          <ac:picMkLst>
            <pc:docMk/>
            <pc:sldMk cId="109857222" sldId="256"/>
            <ac:picMk id="6" creationId="{C8430E77-9396-9DD5-0C58-64C6EC5B5743}"/>
          </ac:picMkLst>
        </pc:picChg>
        <pc:picChg chg="del">
          <ac:chgData name="Jake Kendrick" userId="S::21308325@student.uwa.edu.au::ab142299-a4dd-4def-8b03-8ee3e1d9a7dd" providerId="AD" clId="Web-{C9C15643-D0C5-44B8-BAA7-AB85D2AF82BA}" dt="2022-12-29T23:43:40.135" v="1"/>
          <ac:picMkLst>
            <pc:docMk/>
            <pc:sldMk cId="109857222" sldId="256"/>
            <ac:picMk id="7" creationId="{39AFEE4A-488A-8545-A74A-679028501F65}"/>
          </ac:picMkLst>
        </pc:picChg>
        <pc:picChg chg="del">
          <ac:chgData name="Jake Kendrick" userId="S::21308325@student.uwa.edu.au::ab142299-a4dd-4def-8b03-8ee3e1d9a7dd" providerId="AD" clId="Web-{C9C15643-D0C5-44B8-BAA7-AB85D2AF82BA}" dt="2022-12-29T23:43:42.120" v="2"/>
          <ac:picMkLst>
            <pc:docMk/>
            <pc:sldMk cId="109857222" sldId="256"/>
            <ac:picMk id="9" creationId="{7534F080-3019-5945-A870-517575C07067}"/>
          </ac:picMkLst>
        </pc:picChg>
      </pc:sldChg>
    </pc:docChg>
  </pc:docChgLst>
  <pc:docChgLst>
    <pc:chgData name="Jake Kendrick" userId="S::21308325@student.uwa.edu.au::ab142299-a4dd-4def-8b03-8ee3e1d9a7dd" providerId="AD" clId="Web-{36E15881-0BA3-4A58-AF06-5CA48921DAEB}"/>
    <pc:docChg chg="modSld">
      <pc:chgData name="Jake Kendrick" userId="S::21308325@student.uwa.edu.au::ab142299-a4dd-4def-8b03-8ee3e1d9a7dd" providerId="AD" clId="Web-{36E15881-0BA3-4A58-AF06-5CA48921DAEB}" dt="2023-01-12T01:10:43.062" v="23" actId="20577"/>
      <pc:docMkLst>
        <pc:docMk/>
      </pc:docMkLst>
      <pc:sldChg chg="modSp">
        <pc:chgData name="Jake Kendrick" userId="S::21308325@student.uwa.edu.au::ab142299-a4dd-4def-8b03-8ee3e1d9a7dd" providerId="AD" clId="Web-{36E15881-0BA3-4A58-AF06-5CA48921DAEB}" dt="2023-01-12T01:10:43.062" v="23" actId="20577"/>
        <pc:sldMkLst>
          <pc:docMk/>
          <pc:sldMk cId="109857222" sldId="256"/>
        </pc:sldMkLst>
        <pc:spChg chg="mod">
          <ac:chgData name="Jake Kendrick" userId="S::21308325@student.uwa.edu.au::ab142299-a4dd-4def-8b03-8ee3e1d9a7dd" providerId="AD" clId="Web-{36E15881-0BA3-4A58-AF06-5CA48921DAEB}" dt="2023-01-12T01:10:43.062" v="23" actId="20577"/>
          <ac:spMkLst>
            <pc:docMk/>
            <pc:sldMk cId="109857222" sldId="256"/>
            <ac:spMk id="13" creationId="{A9A32FB2-2064-654E-9855-BDC1D5C342CA}"/>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a:p>
        </p:txBody>
      </p:sp>
      <p:sp>
        <p:nvSpPr>
          <p:cNvPr id="4" name="Date Placeholder 3"/>
          <p:cNvSpPr>
            <a:spLocks noGrp="1"/>
          </p:cNvSpPr>
          <p:nvPr>
            <p:ph type="dt" sz="half" idx="10"/>
          </p:nvPr>
        </p:nvSpPr>
        <p:spPr/>
        <p:txBody>
          <a:bodyPr/>
          <a:lstStyle/>
          <a:p>
            <a:fld id="{846CE7D5-CF57-46EF-B807-FDD0502418D4}" type="datetimeFigureOut">
              <a:rPr lang="en-US" smtClean="0"/>
              <a:t>6/1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8100726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p:cNvSpPr>
            <a:spLocks noGrp="1"/>
          </p:cNvSpPr>
          <p:nvPr>
            <p:ph type="dt" sz="half" idx="10"/>
          </p:nvPr>
        </p:nvSpPr>
        <p:spPr/>
        <p:txBody>
          <a:bodyPr/>
          <a:lstStyle/>
          <a:p>
            <a:fld id="{846CE7D5-CF57-46EF-B807-FDD0502418D4}" type="datetimeFigureOut">
              <a:rPr lang="en-US" smtClean="0"/>
              <a:t>6/1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6898583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p:cNvSpPr>
            <a:spLocks noGrp="1"/>
          </p:cNvSpPr>
          <p:nvPr>
            <p:ph type="dt" sz="half" idx="10"/>
          </p:nvPr>
        </p:nvSpPr>
        <p:spPr/>
        <p:txBody>
          <a:bodyPr/>
          <a:lstStyle/>
          <a:p>
            <a:fld id="{846CE7D5-CF57-46EF-B807-FDD0502418D4}" type="datetimeFigureOut">
              <a:rPr lang="en-US" smtClean="0"/>
              <a:t>6/1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59449430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p:cNvSpPr>
            <a:spLocks noGrp="1"/>
          </p:cNvSpPr>
          <p:nvPr>
            <p:ph type="dt" sz="half" idx="10"/>
          </p:nvPr>
        </p:nvSpPr>
        <p:spPr/>
        <p:txBody>
          <a:bodyPr/>
          <a:lstStyle/>
          <a:p>
            <a:fld id="{846CE7D5-CF57-46EF-B807-FDD0502418D4}" type="datetimeFigureOut">
              <a:rPr lang="en-US" smtClean="0"/>
              <a:t>6/1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9169080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846CE7D5-CF57-46EF-B807-FDD0502418D4}" type="datetimeFigureOut">
              <a:rPr lang="en-US" smtClean="0"/>
              <a:t>6/1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6182465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p:cNvSpPr>
            <a:spLocks noGrp="1"/>
          </p:cNvSpPr>
          <p:nvPr>
            <p:ph type="dt" sz="half" idx="10"/>
          </p:nvPr>
        </p:nvSpPr>
        <p:spPr/>
        <p:txBody>
          <a:bodyPr/>
          <a:lstStyle/>
          <a:p>
            <a:fld id="{846CE7D5-CF57-46EF-B807-FDD0502418D4}" type="datetimeFigureOut">
              <a:rPr lang="en-US" smtClean="0"/>
              <a:t>6/12/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8608525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p:cNvSpPr>
            <a:spLocks noGrp="1"/>
          </p:cNvSpPr>
          <p:nvPr>
            <p:ph type="dt" sz="half" idx="10"/>
          </p:nvPr>
        </p:nvSpPr>
        <p:spPr/>
        <p:txBody>
          <a:bodyPr/>
          <a:lstStyle/>
          <a:p>
            <a:fld id="{846CE7D5-CF57-46EF-B807-FDD0502418D4}" type="datetimeFigureOut">
              <a:rPr lang="en-US" smtClean="0"/>
              <a:t>6/12/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1745356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Date Placeholder 2"/>
          <p:cNvSpPr>
            <a:spLocks noGrp="1"/>
          </p:cNvSpPr>
          <p:nvPr>
            <p:ph type="dt" sz="half" idx="10"/>
          </p:nvPr>
        </p:nvSpPr>
        <p:spPr/>
        <p:txBody>
          <a:bodyPr/>
          <a:lstStyle/>
          <a:p>
            <a:fld id="{846CE7D5-CF57-46EF-B807-FDD0502418D4}" type="datetimeFigureOut">
              <a:rPr lang="en-US" smtClean="0"/>
              <a:t>6/12/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5395275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46CE7D5-CF57-46EF-B807-FDD0502418D4}" type="datetimeFigureOut">
              <a:rPr lang="en-US" smtClean="0"/>
              <a:t>6/12/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9497663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US" smtClean="0"/>
              <a:t>6/12/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84505615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US" smtClean="0"/>
              <a:t>6/12/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4038514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46CE7D5-CF57-46EF-B807-FDD0502418D4}" type="datetimeFigureOut">
              <a:rPr lang="en-US" smtClean="0"/>
              <a:t>6/12/20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330EA680-D336-4FF7-8B7A-9848BB0A1C32}" type="slidenum">
              <a:rPr lang="en-US" smtClean="0"/>
              <a:t>‹#›</a:t>
            </a:fld>
            <a:endParaRPr lang="en-US"/>
          </a:p>
        </p:txBody>
      </p:sp>
    </p:spTree>
    <p:extLst>
      <p:ext uri="{BB962C8B-B14F-4D97-AF65-F5344CB8AC3E}">
        <p14:creationId xmlns:p14="http://schemas.microsoft.com/office/powerpoint/2010/main" val="573256408"/>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1" name="Picture 61" descr="A picture containing text&#10;&#10;Description automatically generated">
            <a:extLst>
              <a:ext uri="{FF2B5EF4-FFF2-40B4-BE49-F238E27FC236}">
                <a16:creationId xmlns:a16="http://schemas.microsoft.com/office/drawing/2014/main" id="{64F72DF3-F2F2-95C7-31EE-BC1637A78667}"/>
              </a:ext>
            </a:extLst>
          </p:cNvPr>
          <p:cNvPicPr>
            <a:picLocks noChangeAspect="1"/>
          </p:cNvPicPr>
          <p:nvPr/>
        </p:nvPicPr>
        <p:blipFill rotWithShape="1">
          <a:blip r:embed="rId2"/>
          <a:srcRect l="27405" t="-1734" r="462" b="578"/>
          <a:stretch/>
        </p:blipFill>
        <p:spPr>
          <a:xfrm>
            <a:off x="577969" y="4777638"/>
            <a:ext cx="2274932" cy="1595178"/>
          </a:xfrm>
          <a:prstGeom prst="rect">
            <a:avLst/>
          </a:prstGeom>
        </p:spPr>
      </p:pic>
      <p:pic>
        <p:nvPicPr>
          <p:cNvPr id="29" name="Picture 29" descr="A picture containing colorful&#10;&#10;Description automatically generated">
            <a:extLst>
              <a:ext uri="{FF2B5EF4-FFF2-40B4-BE49-F238E27FC236}">
                <a16:creationId xmlns:a16="http://schemas.microsoft.com/office/drawing/2014/main" id="{95E6D91C-398D-8DCF-3D4D-E341E42D1C4B}"/>
              </a:ext>
            </a:extLst>
          </p:cNvPr>
          <p:cNvPicPr>
            <a:picLocks noChangeAspect="1"/>
          </p:cNvPicPr>
          <p:nvPr/>
        </p:nvPicPr>
        <p:blipFill>
          <a:blip r:embed="rId3"/>
          <a:stretch>
            <a:fillRect/>
          </a:stretch>
        </p:blipFill>
        <p:spPr>
          <a:xfrm>
            <a:off x="3722916" y="639552"/>
            <a:ext cx="2242457" cy="2607097"/>
          </a:xfrm>
          <a:prstGeom prst="rect">
            <a:avLst/>
          </a:prstGeom>
        </p:spPr>
      </p:pic>
      <p:sp>
        <p:nvSpPr>
          <p:cNvPr id="10" name="TextBox 9">
            <a:extLst>
              <a:ext uri="{FF2B5EF4-FFF2-40B4-BE49-F238E27FC236}">
                <a16:creationId xmlns:a16="http://schemas.microsoft.com/office/drawing/2014/main" id="{77A02ED0-8423-0C42-930A-6F5D1DA6A053}"/>
              </a:ext>
            </a:extLst>
          </p:cNvPr>
          <p:cNvSpPr txBox="1"/>
          <p:nvPr/>
        </p:nvSpPr>
        <p:spPr>
          <a:xfrm>
            <a:off x="6403310" y="953890"/>
            <a:ext cx="387350" cy="282322"/>
          </a:xfrm>
          <a:prstGeom prst="rect">
            <a:avLst/>
          </a:prstGeom>
          <a:noFill/>
        </p:spPr>
        <p:txBody>
          <a:bodyPr wrap="square" rtlCol="0">
            <a:spAutoFit/>
          </a:bodyPr>
          <a:lstStyle/>
          <a:p>
            <a:r>
              <a:rPr lang="en-US" sz="1200" b="1">
                <a:solidFill>
                  <a:schemeClr val="bg1"/>
                </a:solidFill>
                <a:latin typeface="Times New Roman" panose="02020603050405020304" pitchFamily="18" charset="0"/>
                <a:cs typeface="Times New Roman" panose="02020603050405020304" pitchFamily="18" charset="0"/>
              </a:rPr>
              <a:t>15</a:t>
            </a:r>
          </a:p>
        </p:txBody>
      </p:sp>
      <p:sp>
        <p:nvSpPr>
          <p:cNvPr id="12" name="TextBox 11">
            <a:extLst>
              <a:ext uri="{FF2B5EF4-FFF2-40B4-BE49-F238E27FC236}">
                <a16:creationId xmlns:a16="http://schemas.microsoft.com/office/drawing/2014/main" id="{CBAAA63C-1BA9-DA4A-A878-9EC83D20AC07}"/>
              </a:ext>
            </a:extLst>
          </p:cNvPr>
          <p:cNvSpPr txBox="1"/>
          <p:nvPr/>
        </p:nvSpPr>
        <p:spPr>
          <a:xfrm>
            <a:off x="5469455" y="8475401"/>
            <a:ext cx="387350" cy="282322"/>
          </a:xfrm>
          <a:prstGeom prst="rect">
            <a:avLst/>
          </a:prstGeom>
          <a:noFill/>
        </p:spPr>
        <p:txBody>
          <a:bodyPr wrap="square" rtlCol="0">
            <a:spAutoFit/>
          </a:bodyPr>
          <a:lstStyle/>
          <a:p>
            <a:r>
              <a:rPr lang="en-US" sz="1200" b="1">
                <a:solidFill>
                  <a:schemeClr val="bg1"/>
                </a:solidFill>
                <a:latin typeface="Times New Roman" panose="02020603050405020304" pitchFamily="18" charset="0"/>
                <a:cs typeface="Times New Roman" panose="02020603050405020304" pitchFamily="18" charset="0"/>
              </a:rPr>
              <a:t>0</a:t>
            </a:r>
          </a:p>
        </p:txBody>
      </p:sp>
      <p:cxnSp>
        <p:nvCxnSpPr>
          <p:cNvPr id="15" name="Straight Connector 14">
            <a:extLst>
              <a:ext uri="{FF2B5EF4-FFF2-40B4-BE49-F238E27FC236}">
                <a16:creationId xmlns:a16="http://schemas.microsoft.com/office/drawing/2014/main" id="{31A8256A-2223-0045-8866-AF2EE0DBAA26}"/>
              </a:ext>
            </a:extLst>
          </p:cNvPr>
          <p:cNvCxnSpPr/>
          <p:nvPr/>
        </p:nvCxnSpPr>
        <p:spPr>
          <a:xfrm>
            <a:off x="3022896" y="253811"/>
            <a:ext cx="0" cy="4924679"/>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5" name="Oval 4">
            <a:extLst>
              <a:ext uri="{FF2B5EF4-FFF2-40B4-BE49-F238E27FC236}">
                <a16:creationId xmlns:a16="http://schemas.microsoft.com/office/drawing/2014/main" id="{0578B295-60DA-1ACA-FA20-EABE43ECBD76}"/>
              </a:ext>
            </a:extLst>
          </p:cNvPr>
          <p:cNvSpPr/>
          <p:nvPr/>
        </p:nvSpPr>
        <p:spPr>
          <a:xfrm>
            <a:off x="5189561" y="1811224"/>
            <a:ext cx="212284" cy="199353"/>
          </a:xfrm>
          <a:prstGeom prst="ellipse">
            <a:avLst/>
          </a:prstGeom>
          <a:noFill/>
          <a:ln w="2540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 name="Arrow: Right 7">
            <a:extLst>
              <a:ext uri="{FF2B5EF4-FFF2-40B4-BE49-F238E27FC236}">
                <a16:creationId xmlns:a16="http://schemas.microsoft.com/office/drawing/2014/main" id="{D5C3C840-2AF0-DF80-DC4C-81D5DA112E6E}"/>
              </a:ext>
            </a:extLst>
          </p:cNvPr>
          <p:cNvSpPr/>
          <p:nvPr/>
        </p:nvSpPr>
        <p:spPr>
          <a:xfrm rot="6027540">
            <a:off x="5246287" y="1592943"/>
            <a:ext cx="238460" cy="102265"/>
          </a:xfrm>
          <a:prstGeom prst="rightArrow">
            <a:avLst/>
          </a:prstGeom>
          <a:solidFill>
            <a:srgbClr val="FF0000"/>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6" name="Rectangle 35">
            <a:extLst>
              <a:ext uri="{FF2B5EF4-FFF2-40B4-BE49-F238E27FC236}">
                <a16:creationId xmlns:a16="http://schemas.microsoft.com/office/drawing/2014/main" id="{9038A5FC-BAEB-6F6F-E152-D90D91AFE4C4}"/>
              </a:ext>
            </a:extLst>
          </p:cNvPr>
          <p:cNvSpPr/>
          <p:nvPr/>
        </p:nvSpPr>
        <p:spPr>
          <a:xfrm>
            <a:off x="422865" y="4440295"/>
            <a:ext cx="6091307" cy="2063068"/>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7" name="TextBox 36">
            <a:extLst>
              <a:ext uri="{FF2B5EF4-FFF2-40B4-BE49-F238E27FC236}">
                <a16:creationId xmlns:a16="http://schemas.microsoft.com/office/drawing/2014/main" id="{31574BA6-DC1B-27E8-6D53-C5259F6FCE78}"/>
              </a:ext>
            </a:extLst>
          </p:cNvPr>
          <p:cNvSpPr txBox="1"/>
          <p:nvPr/>
        </p:nvSpPr>
        <p:spPr>
          <a:xfrm>
            <a:off x="471167" y="4437902"/>
            <a:ext cx="4299873"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1200" b="1" dirty="0">
                <a:latin typeface="Times New Roman"/>
                <a:cs typeface="Calibri"/>
              </a:rPr>
              <a:t>Axial Contours and Spherical Volume </a:t>
            </a:r>
            <a:r>
              <a:rPr lang="en-GB" sz="1200" b="1" dirty="0" err="1">
                <a:latin typeface="Times New Roman"/>
                <a:cs typeface="Calibri"/>
              </a:rPr>
              <a:t>Centered</a:t>
            </a:r>
            <a:r>
              <a:rPr lang="en-GB" sz="1200" b="1" dirty="0">
                <a:latin typeface="Times New Roman"/>
                <a:cs typeface="Calibri"/>
              </a:rPr>
              <a:t> on </a:t>
            </a:r>
            <a:r>
              <a:rPr lang="en-GB" sz="1200" b="1" dirty="0" err="1">
                <a:latin typeface="Times New Roman"/>
                <a:cs typeface="Calibri"/>
              </a:rPr>
              <a:t>SUV</a:t>
            </a:r>
            <a:r>
              <a:rPr lang="en-GB" sz="1200" b="1" baseline="-25000" dirty="0" err="1">
                <a:latin typeface="Times New Roman"/>
                <a:cs typeface="Calibri"/>
              </a:rPr>
              <a:t>max</a:t>
            </a:r>
          </a:p>
        </p:txBody>
      </p:sp>
      <p:sp>
        <p:nvSpPr>
          <p:cNvPr id="39" name="Rectangle 38">
            <a:extLst>
              <a:ext uri="{FF2B5EF4-FFF2-40B4-BE49-F238E27FC236}">
                <a16:creationId xmlns:a16="http://schemas.microsoft.com/office/drawing/2014/main" id="{55A072C5-91CD-B984-C138-99285623E89B}"/>
              </a:ext>
            </a:extLst>
          </p:cNvPr>
          <p:cNvSpPr/>
          <p:nvPr/>
        </p:nvSpPr>
        <p:spPr>
          <a:xfrm>
            <a:off x="543093" y="3501688"/>
            <a:ext cx="2314791" cy="523730"/>
          </a:xfrm>
          <a:prstGeom prst="rec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b="1">
                <a:latin typeface="Times New Roman"/>
                <a:cs typeface="Calibri"/>
              </a:rPr>
              <a:t>PSMA PET/CT at Biochemical Recurrence</a:t>
            </a:r>
            <a:endParaRPr lang="en-GB" sz="1200" b="1">
              <a:latin typeface="Times New Roman"/>
              <a:cs typeface="Times New Roman"/>
            </a:endParaRPr>
          </a:p>
        </p:txBody>
      </p:sp>
      <p:sp>
        <p:nvSpPr>
          <p:cNvPr id="40" name="Arrow: Right 39">
            <a:extLst>
              <a:ext uri="{FF2B5EF4-FFF2-40B4-BE49-F238E27FC236}">
                <a16:creationId xmlns:a16="http://schemas.microsoft.com/office/drawing/2014/main" id="{33444CC2-0B7A-4C62-68A0-445C4CA3BE0B}"/>
              </a:ext>
            </a:extLst>
          </p:cNvPr>
          <p:cNvSpPr/>
          <p:nvPr/>
        </p:nvSpPr>
        <p:spPr>
          <a:xfrm>
            <a:off x="2968022" y="3614492"/>
            <a:ext cx="662272" cy="114826"/>
          </a:xfrm>
          <a:prstGeom prst="rightArrow">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1" name="Rectangle 40">
            <a:extLst>
              <a:ext uri="{FF2B5EF4-FFF2-40B4-BE49-F238E27FC236}">
                <a16:creationId xmlns:a16="http://schemas.microsoft.com/office/drawing/2014/main" id="{0C5F94FA-5BDB-3A9B-D2F7-088A5358A9A4}"/>
              </a:ext>
            </a:extLst>
          </p:cNvPr>
          <p:cNvSpPr/>
          <p:nvPr/>
        </p:nvSpPr>
        <p:spPr>
          <a:xfrm>
            <a:off x="3719222" y="3501718"/>
            <a:ext cx="2244035" cy="523730"/>
          </a:xfrm>
          <a:prstGeom prst="rect">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lIns="91440" tIns="45720" rIns="91440" bIns="45720" rtlCol="0" anchor="ctr"/>
          <a:lstStyle/>
          <a:p>
            <a:pPr algn="ctr"/>
            <a:r>
              <a:rPr lang="en-GB" sz="1200" b="1">
                <a:latin typeface="Times New Roman"/>
                <a:cs typeface="Calibri"/>
              </a:rPr>
              <a:t>PSMA PET/CT at Follow-up</a:t>
            </a:r>
          </a:p>
        </p:txBody>
      </p:sp>
      <p:sp>
        <p:nvSpPr>
          <p:cNvPr id="42" name="TextBox 41">
            <a:extLst>
              <a:ext uri="{FF2B5EF4-FFF2-40B4-BE49-F238E27FC236}">
                <a16:creationId xmlns:a16="http://schemas.microsoft.com/office/drawing/2014/main" id="{3B80A3C7-7EB6-0B4C-23BA-E8FB9CFA8FBB}"/>
              </a:ext>
            </a:extLst>
          </p:cNvPr>
          <p:cNvSpPr txBox="1"/>
          <p:nvPr/>
        </p:nvSpPr>
        <p:spPr>
          <a:xfrm>
            <a:off x="2905364" y="3784841"/>
            <a:ext cx="2187501" cy="2462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1000" b="1">
                <a:latin typeface="Times New Roman"/>
                <a:cs typeface="Calibri"/>
              </a:rPr>
              <a:t>~ 6 months</a:t>
            </a:r>
          </a:p>
        </p:txBody>
      </p:sp>
      <p:sp>
        <p:nvSpPr>
          <p:cNvPr id="3" name="Rectangle 2">
            <a:extLst>
              <a:ext uri="{FF2B5EF4-FFF2-40B4-BE49-F238E27FC236}">
                <a16:creationId xmlns:a16="http://schemas.microsoft.com/office/drawing/2014/main" id="{ECC7EB11-F726-4C25-B968-5F3F1B5D581C}"/>
              </a:ext>
            </a:extLst>
          </p:cNvPr>
          <p:cNvSpPr/>
          <p:nvPr/>
        </p:nvSpPr>
        <p:spPr>
          <a:xfrm>
            <a:off x="423450" y="372352"/>
            <a:ext cx="6094550" cy="4069642"/>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16" name="Picture 16" descr="A picture containing close, colorful, painted, fabric&#10;&#10;Description automatically generated">
            <a:extLst>
              <a:ext uri="{FF2B5EF4-FFF2-40B4-BE49-F238E27FC236}">
                <a16:creationId xmlns:a16="http://schemas.microsoft.com/office/drawing/2014/main" id="{B3E9B01E-645C-60EC-AB54-5A3CF9EC3FD4}"/>
              </a:ext>
            </a:extLst>
          </p:cNvPr>
          <p:cNvPicPr>
            <a:picLocks noChangeAspect="1"/>
          </p:cNvPicPr>
          <p:nvPr/>
        </p:nvPicPr>
        <p:blipFill>
          <a:blip r:embed="rId4"/>
          <a:stretch>
            <a:fillRect/>
          </a:stretch>
        </p:blipFill>
        <p:spPr>
          <a:xfrm>
            <a:off x="576943" y="644373"/>
            <a:ext cx="2286000" cy="2532142"/>
          </a:xfrm>
          <a:prstGeom prst="rect">
            <a:avLst/>
          </a:prstGeom>
        </p:spPr>
      </p:pic>
      <p:sp>
        <p:nvSpPr>
          <p:cNvPr id="14" name="Oval 13">
            <a:extLst>
              <a:ext uri="{FF2B5EF4-FFF2-40B4-BE49-F238E27FC236}">
                <a16:creationId xmlns:a16="http://schemas.microsoft.com/office/drawing/2014/main" id="{684747A3-725C-C054-C7E4-82C49ED43E2C}"/>
              </a:ext>
            </a:extLst>
          </p:cNvPr>
          <p:cNvSpPr/>
          <p:nvPr/>
        </p:nvSpPr>
        <p:spPr>
          <a:xfrm>
            <a:off x="1989161" y="1822109"/>
            <a:ext cx="212284" cy="199353"/>
          </a:xfrm>
          <a:prstGeom prst="ellipse">
            <a:avLst/>
          </a:prstGeom>
          <a:noFill/>
          <a:ln w="2540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Arrow: Right 7">
            <a:extLst>
              <a:ext uri="{FF2B5EF4-FFF2-40B4-BE49-F238E27FC236}">
                <a16:creationId xmlns:a16="http://schemas.microsoft.com/office/drawing/2014/main" id="{213DBABF-567F-D77D-B8E1-6A769D5EA0AF}"/>
              </a:ext>
            </a:extLst>
          </p:cNvPr>
          <p:cNvSpPr/>
          <p:nvPr/>
        </p:nvSpPr>
        <p:spPr>
          <a:xfrm rot="6027540">
            <a:off x="2045887" y="1636485"/>
            <a:ext cx="238460" cy="102265"/>
          </a:xfrm>
          <a:prstGeom prst="rightArrow">
            <a:avLst/>
          </a:prstGeom>
          <a:solidFill>
            <a:srgbClr val="FF0000"/>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31" name="Picture 34">
            <a:extLst>
              <a:ext uri="{FF2B5EF4-FFF2-40B4-BE49-F238E27FC236}">
                <a16:creationId xmlns:a16="http://schemas.microsoft.com/office/drawing/2014/main" id="{2C5DF484-5768-618B-EB79-746A831B3732}"/>
              </a:ext>
            </a:extLst>
          </p:cNvPr>
          <p:cNvPicPr>
            <a:picLocks noChangeAspect="1"/>
          </p:cNvPicPr>
          <p:nvPr/>
        </p:nvPicPr>
        <p:blipFill rotWithShape="1">
          <a:blip r:embed="rId5"/>
          <a:srcRect r="7692" b="2381"/>
          <a:stretch/>
        </p:blipFill>
        <p:spPr>
          <a:xfrm>
            <a:off x="6073742" y="642255"/>
            <a:ext cx="99709" cy="3385460"/>
          </a:xfrm>
          <a:prstGeom prst="rect">
            <a:avLst/>
          </a:prstGeom>
        </p:spPr>
      </p:pic>
      <p:sp>
        <p:nvSpPr>
          <p:cNvPr id="35" name="TextBox 34">
            <a:extLst>
              <a:ext uri="{FF2B5EF4-FFF2-40B4-BE49-F238E27FC236}">
                <a16:creationId xmlns:a16="http://schemas.microsoft.com/office/drawing/2014/main" id="{EF356298-36BF-9C6A-CFB3-7ABA81BDE941}"/>
              </a:ext>
            </a:extLst>
          </p:cNvPr>
          <p:cNvSpPr txBox="1"/>
          <p:nvPr/>
        </p:nvSpPr>
        <p:spPr>
          <a:xfrm>
            <a:off x="5964249" y="4024326"/>
            <a:ext cx="2187501" cy="2462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1000" b="1">
                <a:latin typeface="Times New Roman"/>
                <a:cs typeface="Calibri"/>
              </a:rPr>
              <a:t>0 SUV</a:t>
            </a:r>
            <a:endParaRPr lang="en-US"/>
          </a:p>
        </p:txBody>
      </p:sp>
      <p:sp>
        <p:nvSpPr>
          <p:cNvPr id="38" name="TextBox 37">
            <a:extLst>
              <a:ext uri="{FF2B5EF4-FFF2-40B4-BE49-F238E27FC236}">
                <a16:creationId xmlns:a16="http://schemas.microsoft.com/office/drawing/2014/main" id="{164BBDCB-BEE3-3218-FF28-622DD53F2615}"/>
              </a:ext>
            </a:extLst>
          </p:cNvPr>
          <p:cNvSpPr txBox="1"/>
          <p:nvPr/>
        </p:nvSpPr>
        <p:spPr>
          <a:xfrm>
            <a:off x="5964249" y="442926"/>
            <a:ext cx="2187501" cy="2462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1000" b="1">
                <a:latin typeface="Times New Roman"/>
                <a:cs typeface="Calibri"/>
              </a:rPr>
              <a:t>8 SUV</a:t>
            </a:r>
            <a:endParaRPr lang="en-US"/>
          </a:p>
        </p:txBody>
      </p:sp>
      <p:sp>
        <p:nvSpPr>
          <p:cNvPr id="54" name="Oval 53">
            <a:extLst>
              <a:ext uri="{FF2B5EF4-FFF2-40B4-BE49-F238E27FC236}">
                <a16:creationId xmlns:a16="http://schemas.microsoft.com/office/drawing/2014/main" id="{E2F46690-3403-E50E-37A8-DB3A33BE3B50}"/>
              </a:ext>
            </a:extLst>
          </p:cNvPr>
          <p:cNvSpPr/>
          <p:nvPr/>
        </p:nvSpPr>
        <p:spPr>
          <a:xfrm>
            <a:off x="5199980" y="5410408"/>
            <a:ext cx="207468" cy="210441"/>
          </a:xfrm>
          <a:prstGeom prst="ellipse">
            <a:avLst/>
          </a:prstGeom>
          <a:noFill/>
          <a:ln w="25400">
            <a:solidFill>
              <a:srgbClr val="FFFF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55" name="Picture 55" descr="Map&#10;&#10;Description automatically generated">
            <a:extLst>
              <a:ext uri="{FF2B5EF4-FFF2-40B4-BE49-F238E27FC236}">
                <a16:creationId xmlns:a16="http://schemas.microsoft.com/office/drawing/2014/main" id="{FD19E755-28F7-14C7-2B2F-9691220023CD}"/>
              </a:ext>
            </a:extLst>
          </p:cNvPr>
          <p:cNvPicPr>
            <a:picLocks noChangeAspect="1"/>
          </p:cNvPicPr>
          <p:nvPr/>
        </p:nvPicPr>
        <p:blipFill rotWithShape="1">
          <a:blip r:embed="rId6"/>
          <a:srcRect l="17845" r="-308" b="-1117"/>
          <a:stretch/>
        </p:blipFill>
        <p:spPr>
          <a:xfrm>
            <a:off x="3721244" y="4808292"/>
            <a:ext cx="2277147" cy="1628608"/>
          </a:xfrm>
          <a:prstGeom prst="rect">
            <a:avLst/>
          </a:prstGeom>
        </p:spPr>
      </p:pic>
      <p:sp>
        <p:nvSpPr>
          <p:cNvPr id="58" name="Oval 57">
            <a:extLst>
              <a:ext uri="{FF2B5EF4-FFF2-40B4-BE49-F238E27FC236}">
                <a16:creationId xmlns:a16="http://schemas.microsoft.com/office/drawing/2014/main" id="{12807188-A8EC-55CC-19F3-5C8F9FEE666B}"/>
              </a:ext>
            </a:extLst>
          </p:cNvPr>
          <p:cNvSpPr/>
          <p:nvPr/>
        </p:nvSpPr>
        <p:spPr>
          <a:xfrm>
            <a:off x="1442640" y="5122117"/>
            <a:ext cx="405376" cy="408640"/>
          </a:xfrm>
          <a:prstGeom prst="ellipse">
            <a:avLst/>
          </a:prstGeom>
          <a:noFill/>
          <a:ln w="25400">
            <a:solidFill>
              <a:srgbClr val="FFFF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0" name="Oval 59">
            <a:extLst>
              <a:ext uri="{FF2B5EF4-FFF2-40B4-BE49-F238E27FC236}">
                <a16:creationId xmlns:a16="http://schemas.microsoft.com/office/drawing/2014/main" id="{571D5DE6-7BAC-F156-A40F-35164140D145}"/>
              </a:ext>
            </a:extLst>
          </p:cNvPr>
          <p:cNvSpPr/>
          <p:nvPr/>
        </p:nvSpPr>
        <p:spPr>
          <a:xfrm>
            <a:off x="4692166" y="5149810"/>
            <a:ext cx="342782" cy="332596"/>
          </a:xfrm>
          <a:prstGeom prst="ellipse">
            <a:avLst/>
          </a:prstGeom>
          <a:noFill/>
          <a:ln w="25400">
            <a:solidFill>
              <a:srgbClr val="FFFF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aphicFrame>
        <p:nvGraphicFramePr>
          <p:cNvPr id="9" name="Table 10">
            <a:extLst>
              <a:ext uri="{FF2B5EF4-FFF2-40B4-BE49-F238E27FC236}">
                <a16:creationId xmlns:a16="http://schemas.microsoft.com/office/drawing/2014/main" id="{BFBF22AD-8840-DCC0-C66D-C6455C72D88A}"/>
              </a:ext>
            </a:extLst>
          </p:cNvPr>
          <p:cNvGraphicFramePr>
            <a:graphicFrameLocks noGrp="1"/>
          </p:cNvGraphicFramePr>
          <p:nvPr>
            <p:extLst>
              <p:ext uri="{D42A27DB-BD31-4B8C-83A1-F6EECF244321}">
                <p14:modId xmlns:p14="http://schemas.microsoft.com/office/powerpoint/2010/main" val="2765825396"/>
              </p:ext>
            </p:extLst>
          </p:nvPr>
        </p:nvGraphicFramePr>
        <p:xfrm>
          <a:off x="542270" y="6688836"/>
          <a:ext cx="5952960" cy="1508760"/>
        </p:xfrm>
        <a:graphic>
          <a:graphicData uri="http://schemas.openxmlformats.org/drawingml/2006/table">
            <a:tbl>
              <a:tblPr firstRow="1" bandRow="1">
                <a:tableStyleId>{2D5ABB26-0587-4C30-8999-92F81FD0307C}</a:tableStyleId>
              </a:tblPr>
              <a:tblGrid>
                <a:gridCol w="1423603">
                  <a:extLst>
                    <a:ext uri="{9D8B030D-6E8A-4147-A177-3AD203B41FA5}">
                      <a16:colId xmlns:a16="http://schemas.microsoft.com/office/drawing/2014/main" val="1680890442"/>
                    </a:ext>
                  </a:extLst>
                </a:gridCol>
                <a:gridCol w="920931">
                  <a:extLst>
                    <a:ext uri="{9D8B030D-6E8A-4147-A177-3AD203B41FA5}">
                      <a16:colId xmlns:a16="http://schemas.microsoft.com/office/drawing/2014/main" val="763906378"/>
                    </a:ext>
                  </a:extLst>
                </a:gridCol>
                <a:gridCol w="1156682">
                  <a:extLst>
                    <a:ext uri="{9D8B030D-6E8A-4147-A177-3AD203B41FA5}">
                      <a16:colId xmlns:a16="http://schemas.microsoft.com/office/drawing/2014/main" val="2442288268"/>
                    </a:ext>
                  </a:extLst>
                </a:gridCol>
                <a:gridCol w="1049304">
                  <a:extLst>
                    <a:ext uri="{9D8B030D-6E8A-4147-A177-3AD203B41FA5}">
                      <a16:colId xmlns:a16="http://schemas.microsoft.com/office/drawing/2014/main" val="3281867703"/>
                    </a:ext>
                  </a:extLst>
                </a:gridCol>
                <a:gridCol w="1402440">
                  <a:extLst>
                    <a:ext uri="{9D8B030D-6E8A-4147-A177-3AD203B41FA5}">
                      <a16:colId xmlns:a16="http://schemas.microsoft.com/office/drawing/2014/main" val="1668174821"/>
                    </a:ext>
                  </a:extLst>
                </a:gridCol>
              </a:tblGrid>
              <a:tr h="370840">
                <a:tc>
                  <a:txBody>
                    <a:bodyPr/>
                    <a:lstStyle/>
                    <a:p>
                      <a:r>
                        <a:rPr lang="en-US" sz="1000" b="1" dirty="0">
                          <a:latin typeface="Times New Roman"/>
                        </a:rPr>
                        <a:t>Biomarker</a:t>
                      </a:r>
                    </a:p>
                  </a:txBody>
                  <a:tcPr/>
                </a:tc>
                <a:tc>
                  <a:txBody>
                    <a:bodyPr/>
                    <a:lstStyle/>
                    <a:p>
                      <a:pPr algn="ctr"/>
                      <a:r>
                        <a:rPr lang="en-US" sz="1000" b="1" dirty="0">
                          <a:latin typeface="Times New Roman"/>
                        </a:rPr>
                        <a:t>Baseline</a:t>
                      </a:r>
                    </a:p>
                  </a:txBody>
                  <a:tcPr/>
                </a:tc>
                <a:tc>
                  <a:txBody>
                    <a:bodyPr/>
                    <a:lstStyle/>
                    <a:p>
                      <a:pPr algn="ctr"/>
                      <a:r>
                        <a:rPr lang="en-US" sz="1000" b="1" dirty="0">
                          <a:latin typeface="Times New Roman"/>
                        </a:rPr>
                        <a:t>Follow-up</a:t>
                      </a:r>
                    </a:p>
                  </a:txBody>
                  <a:tcPr/>
                </a:tc>
                <a:tc>
                  <a:txBody>
                    <a:bodyPr/>
                    <a:lstStyle/>
                    <a:p>
                      <a:pPr algn="ctr"/>
                      <a:r>
                        <a:rPr lang="en-US" sz="1000" b="1" dirty="0">
                          <a:latin typeface="Times New Roman"/>
                        </a:rPr>
                        <a:t>% Change</a:t>
                      </a:r>
                    </a:p>
                  </a:txBody>
                  <a:tcPr/>
                </a:tc>
                <a:tc>
                  <a:txBody>
                    <a:bodyPr/>
                    <a:lstStyle/>
                    <a:p>
                      <a:pPr algn="ctr"/>
                      <a:r>
                        <a:rPr lang="en-US" sz="1000" b="1" dirty="0">
                          <a:latin typeface="Times New Roman"/>
                        </a:rPr>
                        <a:t>Classification (±30% threshold)</a:t>
                      </a:r>
                    </a:p>
                  </a:txBody>
                  <a:tcPr/>
                </a:tc>
                <a:extLst>
                  <a:ext uri="{0D108BD9-81ED-4DB2-BD59-A6C34878D82A}">
                    <a16:rowId xmlns:a16="http://schemas.microsoft.com/office/drawing/2014/main" val="236795591"/>
                  </a:ext>
                </a:extLst>
              </a:tr>
              <a:tr h="370840">
                <a:tc>
                  <a:txBody>
                    <a:bodyPr/>
                    <a:lstStyle/>
                    <a:p>
                      <a:r>
                        <a:rPr lang="en-US" sz="1000" err="1">
                          <a:latin typeface="Times New Roman"/>
                        </a:rPr>
                        <a:t>SUV</a:t>
                      </a:r>
                      <a:r>
                        <a:rPr lang="en-US" sz="1000" baseline="-25000" err="1">
                          <a:latin typeface="Times New Roman"/>
                        </a:rPr>
                        <a:t>mean</a:t>
                      </a:r>
                    </a:p>
                  </a:txBody>
                  <a:tcPr/>
                </a:tc>
                <a:tc>
                  <a:txBody>
                    <a:bodyPr/>
                    <a:lstStyle/>
                    <a:p>
                      <a:pPr algn="ctr"/>
                      <a:r>
                        <a:rPr lang="en-US" sz="1000" dirty="0">
                          <a:latin typeface="Times New Roman"/>
                        </a:rPr>
                        <a:t>2.5</a:t>
                      </a:r>
                    </a:p>
                  </a:txBody>
                  <a:tcPr/>
                </a:tc>
                <a:tc>
                  <a:txBody>
                    <a:bodyPr/>
                    <a:lstStyle/>
                    <a:p>
                      <a:pPr algn="ctr"/>
                      <a:r>
                        <a:rPr lang="en-US" sz="1000" dirty="0">
                          <a:latin typeface="Times New Roman"/>
                        </a:rPr>
                        <a:t>3.4</a:t>
                      </a:r>
                    </a:p>
                  </a:txBody>
                  <a:tcPr/>
                </a:tc>
                <a:tc>
                  <a:txBody>
                    <a:bodyPr/>
                    <a:lstStyle/>
                    <a:p>
                      <a:pPr algn="ctr"/>
                      <a:r>
                        <a:rPr lang="en-US" sz="1000" dirty="0">
                          <a:latin typeface="Times New Roman"/>
                        </a:rPr>
                        <a:t>+36%</a:t>
                      </a:r>
                    </a:p>
                  </a:txBody>
                  <a:tcPr/>
                </a:tc>
                <a:tc>
                  <a:txBody>
                    <a:bodyPr/>
                    <a:lstStyle/>
                    <a:p>
                      <a:pPr algn="ctr"/>
                      <a:endParaRPr lang="en-US" sz="1200" dirty="0">
                        <a:latin typeface="Times New Roman"/>
                      </a:endParaRPr>
                    </a:p>
                  </a:txBody>
                  <a:tcPr/>
                </a:tc>
                <a:extLst>
                  <a:ext uri="{0D108BD9-81ED-4DB2-BD59-A6C34878D82A}">
                    <a16:rowId xmlns:a16="http://schemas.microsoft.com/office/drawing/2014/main" val="494594170"/>
                  </a:ext>
                </a:extLst>
              </a:tr>
              <a:tr h="370840">
                <a:tc>
                  <a:txBody>
                    <a:bodyPr/>
                    <a:lstStyle/>
                    <a:p>
                      <a:r>
                        <a:rPr lang="en-US" sz="1000" dirty="0">
                          <a:latin typeface="Times New Roman"/>
                        </a:rPr>
                        <a:t>Volume (mL)</a:t>
                      </a:r>
                    </a:p>
                  </a:txBody>
                  <a:tcPr/>
                </a:tc>
                <a:tc>
                  <a:txBody>
                    <a:bodyPr/>
                    <a:lstStyle/>
                    <a:p>
                      <a:pPr algn="ctr"/>
                      <a:r>
                        <a:rPr lang="en-US" sz="1000" dirty="0">
                          <a:latin typeface="Times New Roman"/>
                        </a:rPr>
                        <a:t>0.43</a:t>
                      </a:r>
                    </a:p>
                  </a:txBody>
                  <a:tcPr/>
                </a:tc>
                <a:tc>
                  <a:txBody>
                    <a:bodyPr/>
                    <a:lstStyle/>
                    <a:p>
                      <a:pPr algn="ctr"/>
                      <a:r>
                        <a:rPr lang="en-US" sz="1000" dirty="0">
                          <a:latin typeface="Times New Roman"/>
                        </a:rPr>
                        <a:t>0.26</a:t>
                      </a:r>
                    </a:p>
                  </a:txBody>
                  <a:tcPr/>
                </a:tc>
                <a:tc>
                  <a:txBody>
                    <a:bodyPr/>
                    <a:lstStyle/>
                    <a:p>
                      <a:pPr algn="ctr"/>
                      <a:r>
                        <a:rPr lang="en-US" sz="1000" dirty="0">
                          <a:latin typeface="Times New Roman"/>
                        </a:rPr>
                        <a:t>-39.5%</a:t>
                      </a:r>
                    </a:p>
                  </a:txBody>
                  <a:tcPr/>
                </a:tc>
                <a:tc>
                  <a:txBody>
                    <a:bodyPr/>
                    <a:lstStyle/>
                    <a:p>
                      <a:pPr algn="ctr"/>
                      <a:endParaRPr lang="en-US" sz="1200" dirty="0">
                        <a:latin typeface="Times New Roman"/>
                      </a:endParaRPr>
                    </a:p>
                  </a:txBody>
                  <a:tcPr/>
                </a:tc>
                <a:extLst>
                  <a:ext uri="{0D108BD9-81ED-4DB2-BD59-A6C34878D82A}">
                    <a16:rowId xmlns:a16="http://schemas.microsoft.com/office/drawing/2014/main" val="113544179"/>
                  </a:ext>
                </a:extLst>
              </a:tr>
              <a:tr h="370840">
                <a:tc>
                  <a:txBody>
                    <a:bodyPr/>
                    <a:lstStyle/>
                    <a:p>
                      <a:r>
                        <a:rPr lang="en-US" sz="1000" err="1">
                          <a:latin typeface="Times New Roman"/>
                        </a:rPr>
                        <a:t>SUV</a:t>
                      </a:r>
                      <a:r>
                        <a:rPr lang="en-US" sz="1000" baseline="-25000" err="1">
                          <a:latin typeface="Times New Roman"/>
                        </a:rPr>
                        <a:t>peak</a:t>
                      </a:r>
                    </a:p>
                  </a:txBody>
                  <a:tcPr/>
                </a:tc>
                <a:tc>
                  <a:txBody>
                    <a:bodyPr/>
                    <a:lstStyle/>
                    <a:p>
                      <a:pPr algn="ctr"/>
                      <a:r>
                        <a:rPr lang="en-US" sz="1000" dirty="0">
                          <a:latin typeface="Times New Roman"/>
                        </a:rPr>
                        <a:t>2.0</a:t>
                      </a:r>
                    </a:p>
                  </a:txBody>
                  <a:tcPr/>
                </a:tc>
                <a:tc>
                  <a:txBody>
                    <a:bodyPr/>
                    <a:lstStyle/>
                    <a:p>
                      <a:pPr algn="ctr"/>
                      <a:r>
                        <a:rPr lang="en-US" sz="1000" dirty="0">
                          <a:latin typeface="Times New Roman"/>
                        </a:rPr>
                        <a:t>2.5</a:t>
                      </a:r>
                    </a:p>
                  </a:txBody>
                  <a:tcPr/>
                </a:tc>
                <a:tc>
                  <a:txBody>
                    <a:bodyPr/>
                    <a:lstStyle/>
                    <a:p>
                      <a:pPr algn="ctr"/>
                      <a:r>
                        <a:rPr lang="en-US" sz="1000" dirty="0">
                          <a:latin typeface="Times New Roman"/>
                        </a:rPr>
                        <a:t>+25%</a:t>
                      </a:r>
                    </a:p>
                  </a:txBody>
                  <a:tcPr/>
                </a:tc>
                <a:tc>
                  <a:txBody>
                    <a:bodyPr/>
                    <a:lstStyle/>
                    <a:p>
                      <a:pPr algn="ctr"/>
                      <a:endParaRPr lang="en-US" sz="1200" dirty="0">
                        <a:latin typeface="Times New Roman"/>
                      </a:endParaRPr>
                    </a:p>
                  </a:txBody>
                  <a:tcPr/>
                </a:tc>
                <a:extLst>
                  <a:ext uri="{0D108BD9-81ED-4DB2-BD59-A6C34878D82A}">
                    <a16:rowId xmlns:a16="http://schemas.microsoft.com/office/drawing/2014/main" val="2850038176"/>
                  </a:ext>
                </a:extLst>
              </a:tr>
            </a:tbl>
          </a:graphicData>
        </a:graphic>
      </p:graphicFrame>
      <p:sp>
        <p:nvSpPr>
          <p:cNvPr id="11" name="Rectangle 10">
            <a:extLst>
              <a:ext uri="{FF2B5EF4-FFF2-40B4-BE49-F238E27FC236}">
                <a16:creationId xmlns:a16="http://schemas.microsoft.com/office/drawing/2014/main" id="{BE6C1E72-9673-0254-0240-0D5606E34EAF}"/>
              </a:ext>
            </a:extLst>
          </p:cNvPr>
          <p:cNvSpPr/>
          <p:nvPr/>
        </p:nvSpPr>
        <p:spPr>
          <a:xfrm>
            <a:off x="422943" y="6507508"/>
            <a:ext cx="6091307" cy="2063068"/>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 name="Rectangle: Rounded Corners 1">
            <a:extLst>
              <a:ext uri="{FF2B5EF4-FFF2-40B4-BE49-F238E27FC236}">
                <a16:creationId xmlns:a16="http://schemas.microsoft.com/office/drawing/2014/main" id="{DB307362-7B48-0310-0A58-C2C0E905F869}"/>
              </a:ext>
            </a:extLst>
          </p:cNvPr>
          <p:cNvSpPr/>
          <p:nvPr/>
        </p:nvSpPr>
        <p:spPr>
          <a:xfrm>
            <a:off x="5254833" y="7089569"/>
            <a:ext cx="988619" cy="267191"/>
          </a:xfrm>
          <a:prstGeom prst="roundRect">
            <a:avLst/>
          </a:prstGeom>
          <a:solidFill>
            <a:srgbClr val="FF00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dirty="0">
                <a:solidFill>
                  <a:srgbClr val="000000"/>
                </a:solidFill>
                <a:latin typeface="Times New Roman"/>
                <a:cs typeface="Calibri"/>
              </a:rPr>
              <a:t>Progressing</a:t>
            </a:r>
            <a:endParaRPr lang="en-US" sz="1200">
              <a:solidFill>
                <a:srgbClr val="000000"/>
              </a:solidFill>
              <a:latin typeface="Times New Roman"/>
              <a:cs typeface="Times New Roman"/>
            </a:endParaRPr>
          </a:p>
        </p:txBody>
      </p:sp>
      <p:sp>
        <p:nvSpPr>
          <p:cNvPr id="4" name="Rectangle: Rounded Corners 3">
            <a:extLst>
              <a:ext uri="{FF2B5EF4-FFF2-40B4-BE49-F238E27FC236}">
                <a16:creationId xmlns:a16="http://schemas.microsoft.com/office/drawing/2014/main" id="{064E793E-D3F0-3B4D-8C7D-0A9BE94CBC10}"/>
              </a:ext>
            </a:extLst>
          </p:cNvPr>
          <p:cNvSpPr/>
          <p:nvPr/>
        </p:nvSpPr>
        <p:spPr>
          <a:xfrm>
            <a:off x="5255940" y="7454763"/>
            <a:ext cx="988619" cy="267191"/>
          </a:xfrm>
          <a:prstGeom prst="roundRect">
            <a:avLst/>
          </a:prstGeom>
          <a:solidFill>
            <a:srgbClr val="00B050"/>
          </a:solidFill>
        </p:spPr>
        <p:style>
          <a:lnRef idx="2">
            <a:schemeClr val="accent1">
              <a:shade val="15000"/>
            </a:schemeClr>
          </a:lnRef>
          <a:fillRef idx="1">
            <a:schemeClr val="accent1"/>
          </a:fillRef>
          <a:effectRef idx="0">
            <a:schemeClr val="accent1"/>
          </a:effectRef>
          <a:fontRef idx="minor">
            <a:schemeClr val="lt1"/>
          </a:fontRef>
        </p:style>
        <p:txBody>
          <a:bodyPr lIns="91440" tIns="45720" rIns="91440" bIns="45720" rtlCol="0" anchor="ctr"/>
          <a:lstStyle/>
          <a:p>
            <a:pPr algn="ctr"/>
            <a:r>
              <a:rPr lang="en-US" sz="1200" dirty="0">
                <a:solidFill>
                  <a:srgbClr val="000000"/>
                </a:solidFill>
                <a:latin typeface="Times New Roman"/>
                <a:cs typeface="Calibri"/>
              </a:rPr>
              <a:t>Responding</a:t>
            </a:r>
          </a:p>
        </p:txBody>
      </p:sp>
      <p:sp>
        <p:nvSpPr>
          <p:cNvPr id="6" name="Rectangle: Rounded Corners 5">
            <a:extLst>
              <a:ext uri="{FF2B5EF4-FFF2-40B4-BE49-F238E27FC236}">
                <a16:creationId xmlns:a16="http://schemas.microsoft.com/office/drawing/2014/main" id="{038E16DD-DDEB-B29B-5575-2AB0C79BD8B4}"/>
              </a:ext>
            </a:extLst>
          </p:cNvPr>
          <p:cNvSpPr/>
          <p:nvPr/>
        </p:nvSpPr>
        <p:spPr>
          <a:xfrm>
            <a:off x="5257047" y="7828863"/>
            <a:ext cx="988619" cy="267191"/>
          </a:xfrm>
          <a:prstGeom prst="roundRect">
            <a:avLst/>
          </a:prstGeom>
          <a:solidFill>
            <a:srgbClr val="FFFF00"/>
          </a:solidFill>
        </p:spPr>
        <p:style>
          <a:lnRef idx="2">
            <a:schemeClr val="accent1">
              <a:shade val="15000"/>
            </a:schemeClr>
          </a:lnRef>
          <a:fillRef idx="1">
            <a:schemeClr val="accent1"/>
          </a:fillRef>
          <a:effectRef idx="0">
            <a:schemeClr val="accent1"/>
          </a:effectRef>
          <a:fontRef idx="minor">
            <a:schemeClr val="lt1"/>
          </a:fontRef>
        </p:style>
        <p:txBody>
          <a:bodyPr lIns="91440" tIns="45720" rIns="91440" bIns="45720" rtlCol="0" anchor="ctr"/>
          <a:lstStyle/>
          <a:p>
            <a:pPr algn="ctr"/>
            <a:r>
              <a:rPr lang="en-US" sz="1200" dirty="0">
                <a:solidFill>
                  <a:srgbClr val="000000"/>
                </a:solidFill>
                <a:latin typeface="Times New Roman"/>
                <a:cs typeface="Calibri"/>
              </a:rPr>
              <a:t>Stable</a:t>
            </a:r>
          </a:p>
        </p:txBody>
      </p:sp>
    </p:spTree>
    <p:extLst>
      <p:ext uri="{BB962C8B-B14F-4D97-AF65-F5344CB8AC3E}">
        <p14:creationId xmlns:p14="http://schemas.microsoft.com/office/powerpoint/2010/main" val="10985722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46DDA527-3DF0-6192-7EEB-C48E303BE8D0}"/>
              </a:ext>
            </a:extLst>
          </p:cNvPr>
          <p:cNvSpPr txBox="1"/>
          <p:nvPr/>
        </p:nvSpPr>
        <p:spPr>
          <a:xfrm>
            <a:off x="225933" y="121339"/>
            <a:ext cx="6125408" cy="1384995"/>
          </a:xfrm>
          <a:prstGeom prst="rect">
            <a:avLst/>
          </a:prstGeom>
          <a:noFill/>
        </p:spPr>
        <p:txBody>
          <a:bodyPr wrap="square" lIns="91440" tIns="45720" rIns="91440" bIns="45720" rtlCol="0" anchor="t">
            <a:spAutoFit/>
          </a:bodyPr>
          <a:lstStyle/>
          <a:p>
            <a:pPr algn="just"/>
            <a:r>
              <a:rPr lang="en-US" sz="1200" b="1" dirty="0">
                <a:latin typeface="Times New Roman"/>
                <a:cs typeface="Times New Roman"/>
              </a:rPr>
              <a:t>Supplementary Figure 1.</a:t>
            </a:r>
            <a:r>
              <a:rPr lang="en-US" sz="1200" dirty="0">
                <a:latin typeface="Times New Roman"/>
                <a:cs typeface="Times New Roman"/>
              </a:rPr>
              <a:t> Case example of a lesion for a patient that was variably classified as progressing, responding, and stable depending on the biomarker chosen for response assessment. Red lines in the axial slice images represent manual contours for the lesion, and yellow circle shows the spherical volume defined for the </a:t>
            </a:r>
            <a:r>
              <a:rPr lang="en-US" sz="1200" dirty="0" err="1">
                <a:latin typeface="Times New Roman"/>
                <a:cs typeface="Times New Roman"/>
              </a:rPr>
              <a:t>SUV</a:t>
            </a:r>
            <a:r>
              <a:rPr lang="en-US" sz="1200" baseline="-25000" dirty="0" err="1">
                <a:latin typeface="Times New Roman"/>
                <a:cs typeface="Times New Roman"/>
              </a:rPr>
              <a:t>peak</a:t>
            </a:r>
            <a:r>
              <a:rPr lang="en-US" sz="1200" dirty="0">
                <a:latin typeface="Times New Roman"/>
                <a:cs typeface="Times New Roman"/>
              </a:rPr>
              <a:t> calculation. Spherical volume is 6.25mm in diameter, centered on the maximum uptake voxel in the lesion.</a:t>
            </a:r>
          </a:p>
          <a:p>
            <a:pPr algn="just"/>
            <a:endParaRPr lang="en-US" sz="1200">
              <a:latin typeface="Times New Roman"/>
              <a:cs typeface="Times New Roman"/>
            </a:endParaRPr>
          </a:p>
          <a:p>
            <a:pPr algn="just"/>
            <a:endParaRPr lang="en-US" sz="1200">
              <a:latin typeface="Times New Roman"/>
              <a:cs typeface="Times New Roman"/>
            </a:endParaRPr>
          </a:p>
        </p:txBody>
      </p:sp>
    </p:spTree>
    <p:extLst>
      <p:ext uri="{BB962C8B-B14F-4D97-AF65-F5344CB8AC3E}">
        <p14:creationId xmlns:p14="http://schemas.microsoft.com/office/powerpoint/2010/main" val="351154846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Application>Microsoft Office PowerPoint</Application>
  <PresentationFormat>A4 Paper (210x297 mm)</PresentationFormat>
  <Slides>2</Slides>
  <Notes>0</Notes>
  <HiddenSlides>0</HiddenSlide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
  <cp:revision>128</cp:revision>
  <dcterms:created xsi:type="dcterms:W3CDTF">2022-05-16T02:35:23Z</dcterms:created>
  <dcterms:modified xsi:type="dcterms:W3CDTF">2023-06-12T23:24:50Z</dcterms:modified>
</cp:coreProperties>
</file>